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tif" ContentType="image/tiff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changesInfos/changesInfo1.xml" ContentType="application/vnd.ms-powerpoint.changesinfo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5" Type="http://schemas.openxmlformats.org/officeDocument/2006/relationships/custom-properties" Target="docProps/custom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</p:sldIdLst>
  <p:sldSz cx="12192000" cy="9144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FEAA6D48-6958-419A-8516-B343146D1F99}" v="34" dt="2026-04-09T23:52:47.643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85" autoAdjust="0"/>
    <p:restoredTop sz="94660"/>
  </p:normalViewPr>
  <p:slideViewPr>
    <p:cSldViewPr snapToGrid="0">
      <p:cViewPr>
        <p:scale>
          <a:sx n="81" d="100"/>
          <a:sy n="81" d="100"/>
        </p:scale>
        <p:origin x="-1456" y="-328"/>
      </p:cViewPr>
      <p:guideLst>
        <p:guide orient="horz" pos="288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slide" Target="slides/slide10.xml"/><Relationship Id="rId12" Type="http://schemas.openxmlformats.org/officeDocument/2006/relationships/slide" Target="slides/slide11.xml"/><Relationship Id="rId13" Type="http://schemas.openxmlformats.org/officeDocument/2006/relationships/printerSettings" Target="printerSettings/printerSettings1.bin"/><Relationship Id="rId14" Type="http://schemas.openxmlformats.org/officeDocument/2006/relationships/presProps" Target="presProps.xml"/><Relationship Id="rId15" Type="http://schemas.openxmlformats.org/officeDocument/2006/relationships/viewProps" Target="viewProps.xml"/><Relationship Id="rId16" Type="http://schemas.openxmlformats.org/officeDocument/2006/relationships/theme" Target="theme/theme1.xml"/><Relationship Id="rId17" Type="http://schemas.openxmlformats.org/officeDocument/2006/relationships/tableStyles" Target="tableStyles.xml"/><Relationship Id="rId18" Type="http://schemas.microsoft.com/office/2016/11/relationships/changesInfo" Target="changesInfos/changesInfo1.xml"/><Relationship Id="rId19" Type="http://schemas.microsoft.com/office/2015/10/relationships/revisionInfo" Target="revisionInfo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Relationship Id="rId9" Type="http://schemas.openxmlformats.org/officeDocument/2006/relationships/slide" Target="slides/slide8.xml"/><Relationship Id="rId10" Type="http://schemas.openxmlformats.org/officeDocument/2006/relationships/slide" Target="slides/slide9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Dawn Holmes" userId="b7a8a953-5552-462e-ab5c-f3e22cb2b5df" providerId="ADAL" clId="{91CB56AA-EA07-4E7B-8CF8-687302C44E3C}"/>
    <pc:docChg chg="undo custSel addSld modSld">
      <pc:chgData name="Dawn Holmes" userId="b7a8a953-5552-462e-ab5c-f3e22cb2b5df" providerId="ADAL" clId="{91CB56AA-EA07-4E7B-8CF8-687302C44E3C}" dt="2026-04-09T23:53:32.098" v="1121" actId="207"/>
      <pc:docMkLst>
        <pc:docMk/>
      </pc:docMkLst>
      <pc:sldChg chg="addSp modSp mod">
        <pc:chgData name="Dawn Holmes" userId="b7a8a953-5552-462e-ab5c-f3e22cb2b5df" providerId="ADAL" clId="{91CB56AA-EA07-4E7B-8CF8-687302C44E3C}" dt="2026-04-09T21:12:44.742" v="154" actId="207"/>
        <pc:sldMkLst>
          <pc:docMk/>
          <pc:sldMk cId="2513654285" sldId="256"/>
        </pc:sldMkLst>
        <pc:spChg chg="add mod">
          <ac:chgData name="Dawn Holmes" userId="b7a8a953-5552-462e-ab5c-f3e22cb2b5df" providerId="ADAL" clId="{91CB56AA-EA07-4E7B-8CF8-687302C44E3C}" dt="2026-04-09T21:10:33.994" v="82" actId="20577"/>
          <ac:spMkLst>
            <pc:docMk/>
            <pc:sldMk cId="2513654285" sldId="256"/>
            <ac:spMk id="12" creationId="{6ADF0CA8-9013-2EF2-2C18-16C3648808A1}"/>
          </ac:spMkLst>
        </pc:spChg>
        <pc:spChg chg="add mod">
          <ac:chgData name="Dawn Holmes" userId="b7a8a953-5552-462e-ab5c-f3e22cb2b5df" providerId="ADAL" clId="{91CB56AA-EA07-4E7B-8CF8-687302C44E3C}" dt="2026-04-09T21:11:16.724" v="99" actId="1036"/>
          <ac:spMkLst>
            <pc:docMk/>
            <pc:sldMk cId="2513654285" sldId="256"/>
            <ac:spMk id="13" creationId="{B3D3BD94-34F2-9DA5-B2CB-E7078F6867E2}"/>
          </ac:spMkLst>
        </pc:spChg>
        <pc:spChg chg="add mod">
          <ac:chgData name="Dawn Holmes" userId="b7a8a953-5552-462e-ab5c-f3e22cb2b5df" providerId="ADAL" clId="{91CB56AA-EA07-4E7B-8CF8-687302C44E3C}" dt="2026-04-09T21:11:33.652" v="126" actId="1038"/>
          <ac:spMkLst>
            <pc:docMk/>
            <pc:sldMk cId="2513654285" sldId="256"/>
            <ac:spMk id="14" creationId="{A5674784-CEC0-21A2-22E3-F45A4326E103}"/>
          </ac:spMkLst>
        </pc:spChg>
        <pc:spChg chg="add mod">
          <ac:chgData name="Dawn Holmes" userId="b7a8a953-5552-462e-ab5c-f3e22cb2b5df" providerId="ADAL" clId="{91CB56AA-EA07-4E7B-8CF8-687302C44E3C}" dt="2026-04-09T21:11:52.932" v="151" actId="1038"/>
          <ac:spMkLst>
            <pc:docMk/>
            <pc:sldMk cId="2513654285" sldId="256"/>
            <ac:spMk id="15" creationId="{B7780117-2B36-3FC5-AEDD-920CCFE35E54}"/>
          </ac:spMkLst>
        </pc:spChg>
        <pc:graphicFrameChg chg="add mod modGraphic">
          <ac:chgData name="Dawn Holmes" userId="b7a8a953-5552-462e-ab5c-f3e22cb2b5df" providerId="ADAL" clId="{91CB56AA-EA07-4E7B-8CF8-687302C44E3C}" dt="2026-04-09T21:12:44.742" v="154" actId="207"/>
          <ac:graphicFrameMkLst>
            <pc:docMk/>
            <pc:sldMk cId="2513654285" sldId="256"/>
            <ac:graphicFrameMk id="10" creationId="{F3BCE9EE-168F-56C3-59AD-80C13035019F}"/>
          </ac:graphicFrameMkLst>
        </pc:graphicFrameChg>
        <pc:picChg chg="add mod">
          <ac:chgData name="Dawn Holmes" userId="b7a8a953-5552-462e-ab5c-f3e22cb2b5df" providerId="ADAL" clId="{91CB56AA-EA07-4E7B-8CF8-687302C44E3C}" dt="2026-04-09T21:07:06.110" v="42" actId="1037"/>
          <ac:picMkLst>
            <pc:docMk/>
            <pc:sldMk cId="2513654285" sldId="256"/>
            <ac:picMk id="5" creationId="{ECB4E2B8-4AEB-D426-9B0A-C45BB7C466A0}"/>
          </ac:picMkLst>
        </pc:picChg>
        <pc:picChg chg="add mod">
          <ac:chgData name="Dawn Holmes" userId="b7a8a953-5552-462e-ab5c-f3e22cb2b5df" providerId="ADAL" clId="{91CB56AA-EA07-4E7B-8CF8-687302C44E3C}" dt="2026-04-09T21:10:55.924" v="83" actId="14100"/>
          <ac:picMkLst>
            <pc:docMk/>
            <pc:sldMk cId="2513654285" sldId="256"/>
            <ac:picMk id="7" creationId="{F04A5139-32DB-2E2D-6292-B3DC433F2271}"/>
          </ac:picMkLst>
        </pc:picChg>
        <pc:picChg chg="add mod">
          <ac:chgData name="Dawn Holmes" userId="b7a8a953-5552-462e-ab5c-f3e22cb2b5df" providerId="ADAL" clId="{91CB56AA-EA07-4E7B-8CF8-687302C44E3C}" dt="2026-04-09T21:07:13.831" v="64" actId="1037"/>
          <ac:picMkLst>
            <pc:docMk/>
            <pc:sldMk cId="2513654285" sldId="256"/>
            <ac:picMk id="9" creationId="{6F570342-06D0-4EAD-4C3E-EED234FBFBA1}"/>
          </ac:picMkLst>
        </pc:picChg>
      </pc:sldChg>
      <pc:sldChg chg="addSp delSp modSp new mod">
        <pc:chgData name="Dawn Holmes" userId="b7a8a953-5552-462e-ab5c-f3e22cb2b5df" providerId="ADAL" clId="{91CB56AA-EA07-4E7B-8CF8-687302C44E3C}" dt="2026-04-09T21:19:38.860" v="275" actId="20577"/>
        <pc:sldMkLst>
          <pc:docMk/>
          <pc:sldMk cId="2067564685" sldId="257"/>
        </pc:sldMkLst>
        <pc:spChg chg="del">
          <ac:chgData name="Dawn Holmes" userId="b7a8a953-5552-462e-ab5c-f3e22cb2b5df" providerId="ADAL" clId="{91CB56AA-EA07-4E7B-8CF8-687302C44E3C}" dt="2026-04-09T21:12:53.294" v="156" actId="478"/>
          <ac:spMkLst>
            <pc:docMk/>
            <pc:sldMk cId="2067564685" sldId="257"/>
            <ac:spMk id="2" creationId="{A12550A1-ED92-F15A-F00F-2DA636C8FC0A}"/>
          </ac:spMkLst>
        </pc:spChg>
        <pc:spChg chg="del">
          <ac:chgData name="Dawn Holmes" userId="b7a8a953-5552-462e-ab5c-f3e22cb2b5df" providerId="ADAL" clId="{91CB56AA-EA07-4E7B-8CF8-687302C44E3C}" dt="2026-04-09T21:12:53.294" v="156" actId="478"/>
          <ac:spMkLst>
            <pc:docMk/>
            <pc:sldMk cId="2067564685" sldId="257"/>
            <ac:spMk id="3" creationId="{80C78655-61B8-0189-E68D-FD60058373B4}"/>
          </ac:spMkLst>
        </pc:spChg>
        <pc:spChg chg="add mod">
          <ac:chgData name="Dawn Holmes" userId="b7a8a953-5552-462e-ab5c-f3e22cb2b5df" providerId="ADAL" clId="{91CB56AA-EA07-4E7B-8CF8-687302C44E3C}" dt="2026-04-09T21:16:43.314" v="212" actId="20577"/>
          <ac:spMkLst>
            <pc:docMk/>
            <pc:sldMk cId="2067564685" sldId="257"/>
            <ac:spMk id="10" creationId="{3CA04546-3FF8-09BF-347A-DA907233014B}"/>
          </ac:spMkLst>
        </pc:spChg>
        <pc:spChg chg="add mod">
          <ac:chgData name="Dawn Holmes" userId="b7a8a953-5552-462e-ab5c-f3e22cb2b5df" providerId="ADAL" clId="{91CB56AA-EA07-4E7B-8CF8-687302C44E3C}" dt="2026-04-09T21:16:52.495" v="227" actId="20577"/>
          <ac:spMkLst>
            <pc:docMk/>
            <pc:sldMk cId="2067564685" sldId="257"/>
            <ac:spMk id="11" creationId="{6E44E5F3-1A5B-CAF1-4A2D-E5BD69F5B1A5}"/>
          </ac:spMkLst>
        </pc:spChg>
        <pc:spChg chg="add mod">
          <ac:chgData name="Dawn Holmes" userId="b7a8a953-5552-462e-ab5c-f3e22cb2b5df" providerId="ADAL" clId="{91CB56AA-EA07-4E7B-8CF8-687302C44E3C}" dt="2026-04-09T21:16:58.937" v="233" actId="20577"/>
          <ac:spMkLst>
            <pc:docMk/>
            <pc:sldMk cId="2067564685" sldId="257"/>
            <ac:spMk id="12" creationId="{E6A56B67-658C-1014-352D-F5D8469DFD09}"/>
          </ac:spMkLst>
        </pc:spChg>
        <pc:spChg chg="add mod">
          <ac:chgData name="Dawn Holmes" userId="b7a8a953-5552-462e-ab5c-f3e22cb2b5df" providerId="ADAL" clId="{91CB56AA-EA07-4E7B-8CF8-687302C44E3C}" dt="2026-04-09T21:18:30.318" v="252" actId="20577"/>
          <ac:spMkLst>
            <pc:docMk/>
            <pc:sldMk cId="2067564685" sldId="257"/>
            <ac:spMk id="14" creationId="{D779FC0D-9C68-F217-70DD-0338C8038EFB}"/>
          </ac:spMkLst>
        </pc:spChg>
        <pc:graphicFrameChg chg="add mod modGraphic">
          <ac:chgData name="Dawn Holmes" userId="b7a8a953-5552-462e-ab5c-f3e22cb2b5df" providerId="ADAL" clId="{91CB56AA-EA07-4E7B-8CF8-687302C44E3C}" dt="2026-04-09T21:19:38.860" v="275" actId="20577"/>
          <ac:graphicFrameMkLst>
            <pc:docMk/>
            <pc:sldMk cId="2067564685" sldId="257"/>
            <ac:graphicFrameMk id="13" creationId="{E191306C-9EAB-0A52-FF20-6245E0E49E4B}"/>
          </ac:graphicFrameMkLst>
        </pc:graphicFrameChg>
        <pc:picChg chg="add mod">
          <ac:chgData name="Dawn Holmes" userId="b7a8a953-5552-462e-ab5c-f3e22cb2b5df" providerId="ADAL" clId="{91CB56AA-EA07-4E7B-8CF8-687302C44E3C}" dt="2026-04-09T21:18:39.108" v="266" actId="14100"/>
          <ac:picMkLst>
            <pc:docMk/>
            <pc:sldMk cId="2067564685" sldId="257"/>
            <ac:picMk id="5" creationId="{7C092497-0C45-7A43-B38B-9F8FCEDDBDF6}"/>
          </ac:picMkLst>
        </pc:picChg>
        <pc:picChg chg="add mod">
          <ac:chgData name="Dawn Holmes" userId="b7a8a953-5552-462e-ab5c-f3e22cb2b5df" providerId="ADAL" clId="{91CB56AA-EA07-4E7B-8CF8-687302C44E3C}" dt="2026-04-09T21:18:44.972" v="268" actId="14100"/>
          <ac:picMkLst>
            <pc:docMk/>
            <pc:sldMk cId="2067564685" sldId="257"/>
            <ac:picMk id="7" creationId="{5B7AF379-2D5A-72F3-B1F6-49E61EEBA4AC}"/>
          </ac:picMkLst>
        </pc:picChg>
        <pc:picChg chg="add mod">
          <ac:chgData name="Dawn Holmes" userId="b7a8a953-5552-462e-ab5c-f3e22cb2b5df" providerId="ADAL" clId="{91CB56AA-EA07-4E7B-8CF8-687302C44E3C}" dt="2026-04-09T21:18:41.091" v="267" actId="14100"/>
          <ac:picMkLst>
            <pc:docMk/>
            <pc:sldMk cId="2067564685" sldId="257"/>
            <ac:picMk id="9" creationId="{12381628-7DBF-EB7A-9E5E-3F6F6CFEB89D}"/>
          </ac:picMkLst>
        </pc:picChg>
      </pc:sldChg>
      <pc:sldChg chg="addSp delSp modSp new mod">
        <pc:chgData name="Dawn Holmes" userId="b7a8a953-5552-462e-ab5c-f3e22cb2b5df" providerId="ADAL" clId="{91CB56AA-EA07-4E7B-8CF8-687302C44E3C}" dt="2026-04-09T21:25:42.844" v="408" actId="20577"/>
        <pc:sldMkLst>
          <pc:docMk/>
          <pc:sldMk cId="1973337206" sldId="258"/>
        </pc:sldMkLst>
        <pc:spChg chg="del">
          <ac:chgData name="Dawn Holmes" userId="b7a8a953-5552-462e-ab5c-f3e22cb2b5df" providerId="ADAL" clId="{91CB56AA-EA07-4E7B-8CF8-687302C44E3C}" dt="2026-04-09T21:20:00.078" v="278" actId="478"/>
          <ac:spMkLst>
            <pc:docMk/>
            <pc:sldMk cId="1973337206" sldId="258"/>
            <ac:spMk id="2" creationId="{29BA21F7-B2EE-5644-1E29-D888AB78DC82}"/>
          </ac:spMkLst>
        </pc:spChg>
        <pc:spChg chg="del">
          <ac:chgData name="Dawn Holmes" userId="b7a8a953-5552-462e-ab5c-f3e22cb2b5df" providerId="ADAL" clId="{91CB56AA-EA07-4E7B-8CF8-687302C44E3C}" dt="2026-04-09T21:19:58.166" v="277" actId="478"/>
          <ac:spMkLst>
            <pc:docMk/>
            <pc:sldMk cId="1973337206" sldId="258"/>
            <ac:spMk id="3" creationId="{2EAD3C00-3A32-CAC1-B0D8-D40F8E643E62}"/>
          </ac:spMkLst>
        </pc:spChg>
        <pc:spChg chg="add mod">
          <ac:chgData name="Dawn Holmes" userId="b7a8a953-5552-462e-ab5c-f3e22cb2b5df" providerId="ADAL" clId="{91CB56AA-EA07-4E7B-8CF8-687302C44E3C}" dt="2026-04-09T21:23:46.605" v="366" actId="1076"/>
          <ac:spMkLst>
            <pc:docMk/>
            <pc:sldMk cId="1973337206" sldId="258"/>
            <ac:spMk id="10" creationId="{36640EC8-E356-9C01-AB51-2A5981988FBF}"/>
          </ac:spMkLst>
        </pc:spChg>
        <pc:spChg chg="add mod">
          <ac:chgData name="Dawn Holmes" userId="b7a8a953-5552-462e-ab5c-f3e22cb2b5df" providerId="ADAL" clId="{91CB56AA-EA07-4E7B-8CF8-687302C44E3C}" dt="2026-04-09T21:23:54.124" v="368" actId="1076"/>
          <ac:spMkLst>
            <pc:docMk/>
            <pc:sldMk cId="1973337206" sldId="258"/>
            <ac:spMk id="11" creationId="{F381970B-7B5B-B3B7-9F65-821AD4D62B0A}"/>
          </ac:spMkLst>
        </pc:spChg>
        <pc:spChg chg="add mod">
          <ac:chgData name="Dawn Holmes" userId="b7a8a953-5552-462e-ab5c-f3e22cb2b5df" providerId="ADAL" clId="{91CB56AA-EA07-4E7B-8CF8-687302C44E3C}" dt="2026-04-09T21:24:01.499" v="371" actId="1076"/>
          <ac:spMkLst>
            <pc:docMk/>
            <pc:sldMk cId="1973337206" sldId="258"/>
            <ac:spMk id="12" creationId="{96EABEA8-9778-D622-DDE3-637CD627CB28}"/>
          </ac:spMkLst>
        </pc:spChg>
        <pc:spChg chg="add mod">
          <ac:chgData name="Dawn Holmes" userId="b7a8a953-5552-462e-ab5c-f3e22cb2b5df" providerId="ADAL" clId="{91CB56AA-EA07-4E7B-8CF8-687302C44E3C}" dt="2026-04-09T21:25:42.844" v="408" actId="20577"/>
          <ac:spMkLst>
            <pc:docMk/>
            <pc:sldMk cId="1973337206" sldId="258"/>
            <ac:spMk id="14" creationId="{FA59FCF4-B0A6-7021-3A80-0EB1E7DBFB27}"/>
          </ac:spMkLst>
        </pc:spChg>
        <pc:graphicFrameChg chg="add mod modGraphic">
          <ac:chgData name="Dawn Holmes" userId="b7a8a953-5552-462e-ab5c-f3e22cb2b5df" providerId="ADAL" clId="{91CB56AA-EA07-4E7B-8CF8-687302C44E3C}" dt="2026-04-09T21:25:35.030" v="406" actId="207"/>
          <ac:graphicFrameMkLst>
            <pc:docMk/>
            <pc:sldMk cId="1973337206" sldId="258"/>
            <ac:graphicFrameMk id="13" creationId="{C8B2E143-D1CF-6AC8-16B1-7B5189CAA5E0}"/>
          </ac:graphicFrameMkLst>
        </pc:graphicFrameChg>
        <pc:picChg chg="add mod">
          <ac:chgData name="Dawn Holmes" userId="b7a8a953-5552-462e-ab5c-f3e22cb2b5df" providerId="ADAL" clId="{91CB56AA-EA07-4E7B-8CF8-687302C44E3C}" dt="2026-04-09T21:23:32.916" v="363" actId="1076"/>
          <ac:picMkLst>
            <pc:docMk/>
            <pc:sldMk cId="1973337206" sldId="258"/>
            <ac:picMk id="5" creationId="{42011B00-E234-A6E2-2B1F-0DF924013DC2}"/>
          </ac:picMkLst>
        </pc:picChg>
        <pc:picChg chg="add mod">
          <ac:chgData name="Dawn Holmes" userId="b7a8a953-5552-462e-ab5c-f3e22cb2b5df" providerId="ADAL" clId="{91CB56AA-EA07-4E7B-8CF8-687302C44E3C}" dt="2026-04-09T21:23:04.011" v="353" actId="1038"/>
          <ac:picMkLst>
            <pc:docMk/>
            <pc:sldMk cId="1973337206" sldId="258"/>
            <ac:picMk id="7" creationId="{750D0169-FA32-63B1-8EF8-7DC85D912EB4}"/>
          </ac:picMkLst>
        </pc:picChg>
        <pc:picChg chg="add mod">
          <ac:chgData name="Dawn Holmes" userId="b7a8a953-5552-462e-ab5c-f3e22cb2b5df" providerId="ADAL" clId="{91CB56AA-EA07-4E7B-8CF8-687302C44E3C}" dt="2026-04-09T21:23:10.047" v="359" actId="1035"/>
          <ac:picMkLst>
            <pc:docMk/>
            <pc:sldMk cId="1973337206" sldId="258"/>
            <ac:picMk id="9" creationId="{C04C3769-E8DA-A6E3-7C42-0C74F680AD75}"/>
          </ac:picMkLst>
        </pc:picChg>
      </pc:sldChg>
      <pc:sldChg chg="addSp delSp modSp new mod">
        <pc:chgData name="Dawn Holmes" userId="b7a8a953-5552-462e-ab5c-f3e22cb2b5df" providerId="ADAL" clId="{91CB56AA-EA07-4E7B-8CF8-687302C44E3C}" dt="2026-04-09T22:10:08.638" v="570" actId="207"/>
        <pc:sldMkLst>
          <pc:docMk/>
          <pc:sldMk cId="52670275" sldId="259"/>
        </pc:sldMkLst>
        <pc:spChg chg="del">
          <ac:chgData name="Dawn Holmes" userId="b7a8a953-5552-462e-ab5c-f3e22cb2b5df" providerId="ADAL" clId="{91CB56AA-EA07-4E7B-8CF8-687302C44E3C}" dt="2026-04-09T21:25:51.811" v="410" actId="478"/>
          <ac:spMkLst>
            <pc:docMk/>
            <pc:sldMk cId="52670275" sldId="259"/>
            <ac:spMk id="2" creationId="{5FD64D40-55F4-89EB-0240-2FB175D0629A}"/>
          </ac:spMkLst>
        </pc:spChg>
        <pc:spChg chg="del">
          <ac:chgData name="Dawn Holmes" userId="b7a8a953-5552-462e-ab5c-f3e22cb2b5df" providerId="ADAL" clId="{91CB56AA-EA07-4E7B-8CF8-687302C44E3C}" dt="2026-04-09T21:25:51.811" v="410" actId="478"/>
          <ac:spMkLst>
            <pc:docMk/>
            <pc:sldMk cId="52670275" sldId="259"/>
            <ac:spMk id="3" creationId="{E7B2845F-1C63-4AE8-FF48-531CFE8A709F}"/>
          </ac:spMkLst>
        </pc:spChg>
        <pc:spChg chg="add mod">
          <ac:chgData name="Dawn Holmes" userId="b7a8a953-5552-462e-ab5c-f3e22cb2b5df" providerId="ADAL" clId="{91CB56AA-EA07-4E7B-8CF8-687302C44E3C}" dt="2026-04-09T21:29:05.680" v="477" actId="20577"/>
          <ac:spMkLst>
            <pc:docMk/>
            <pc:sldMk cId="52670275" sldId="259"/>
            <ac:spMk id="10" creationId="{C0BEBE48-6147-8536-FFB7-57D86236863A}"/>
          </ac:spMkLst>
        </pc:spChg>
        <pc:spChg chg="add mod">
          <ac:chgData name="Dawn Holmes" userId="b7a8a953-5552-462e-ab5c-f3e22cb2b5df" providerId="ADAL" clId="{91CB56AA-EA07-4E7B-8CF8-687302C44E3C}" dt="2026-04-09T21:29:12.362" v="480" actId="20577"/>
          <ac:spMkLst>
            <pc:docMk/>
            <pc:sldMk cId="52670275" sldId="259"/>
            <ac:spMk id="11" creationId="{594D8548-412D-2896-83E7-160C348380F1}"/>
          </ac:spMkLst>
        </pc:spChg>
        <pc:spChg chg="add mod">
          <ac:chgData name="Dawn Holmes" userId="b7a8a953-5552-462e-ab5c-f3e22cb2b5df" providerId="ADAL" clId="{91CB56AA-EA07-4E7B-8CF8-687302C44E3C}" dt="2026-04-09T21:29:20.033" v="483" actId="20577"/>
          <ac:spMkLst>
            <pc:docMk/>
            <pc:sldMk cId="52670275" sldId="259"/>
            <ac:spMk id="12" creationId="{918C2F7D-B886-0A45-71EA-3B7A5B838325}"/>
          </ac:spMkLst>
        </pc:spChg>
        <pc:spChg chg="add mod">
          <ac:chgData name="Dawn Holmes" userId="b7a8a953-5552-462e-ab5c-f3e22cb2b5df" providerId="ADAL" clId="{91CB56AA-EA07-4E7B-8CF8-687302C44E3C}" dt="2026-04-09T21:31:16.748" v="499" actId="20577"/>
          <ac:spMkLst>
            <pc:docMk/>
            <pc:sldMk cId="52670275" sldId="259"/>
            <ac:spMk id="14" creationId="{3AA2706D-B761-9B11-4264-3381C576E8F0}"/>
          </ac:spMkLst>
        </pc:spChg>
        <pc:graphicFrameChg chg="add mod modGraphic">
          <ac:chgData name="Dawn Holmes" userId="b7a8a953-5552-462e-ab5c-f3e22cb2b5df" providerId="ADAL" clId="{91CB56AA-EA07-4E7B-8CF8-687302C44E3C}" dt="2026-04-09T22:10:08.638" v="570" actId="207"/>
          <ac:graphicFrameMkLst>
            <pc:docMk/>
            <pc:sldMk cId="52670275" sldId="259"/>
            <ac:graphicFrameMk id="13" creationId="{78552BA4-154F-D9C0-6528-015043782F8F}"/>
          </ac:graphicFrameMkLst>
        </pc:graphicFrameChg>
        <pc:picChg chg="add mod">
          <ac:chgData name="Dawn Holmes" userId="b7a8a953-5552-462e-ab5c-f3e22cb2b5df" providerId="ADAL" clId="{91CB56AA-EA07-4E7B-8CF8-687302C44E3C}" dt="2026-04-09T21:28:45.452" v="473" actId="1038"/>
          <ac:picMkLst>
            <pc:docMk/>
            <pc:sldMk cId="52670275" sldId="259"/>
            <ac:picMk id="5" creationId="{A1AD71DB-37C9-A330-55AC-C81CF5FDFA63}"/>
          </ac:picMkLst>
        </pc:picChg>
        <pc:picChg chg="add mod">
          <ac:chgData name="Dawn Holmes" userId="b7a8a953-5552-462e-ab5c-f3e22cb2b5df" providerId="ADAL" clId="{91CB56AA-EA07-4E7B-8CF8-687302C44E3C}" dt="2026-04-09T21:28:39.340" v="449" actId="1038"/>
          <ac:picMkLst>
            <pc:docMk/>
            <pc:sldMk cId="52670275" sldId="259"/>
            <ac:picMk id="7" creationId="{95A4D609-ACD3-6C0F-6E45-0FDE74ABC261}"/>
          </ac:picMkLst>
        </pc:picChg>
        <pc:picChg chg="add mod">
          <ac:chgData name="Dawn Holmes" userId="b7a8a953-5552-462e-ab5c-f3e22cb2b5df" providerId="ADAL" clId="{91CB56AA-EA07-4E7B-8CF8-687302C44E3C}" dt="2026-04-09T21:28:42.427" v="460" actId="1038"/>
          <ac:picMkLst>
            <pc:docMk/>
            <pc:sldMk cId="52670275" sldId="259"/>
            <ac:picMk id="9" creationId="{170E508A-AB0A-E1A0-0CB2-8BC62ECA9176}"/>
          </ac:picMkLst>
        </pc:picChg>
      </pc:sldChg>
      <pc:sldChg chg="addSp delSp modSp new mod">
        <pc:chgData name="Dawn Holmes" userId="b7a8a953-5552-462e-ab5c-f3e22cb2b5df" providerId="ADAL" clId="{91CB56AA-EA07-4E7B-8CF8-687302C44E3C}" dt="2026-04-09T22:56:08.511" v="1061" actId="207"/>
        <pc:sldMkLst>
          <pc:docMk/>
          <pc:sldMk cId="3740585624" sldId="260"/>
        </pc:sldMkLst>
        <pc:spChg chg="del">
          <ac:chgData name="Dawn Holmes" userId="b7a8a953-5552-462e-ab5c-f3e22cb2b5df" providerId="ADAL" clId="{91CB56AA-EA07-4E7B-8CF8-687302C44E3C}" dt="2026-04-09T21:31:26.595" v="501" actId="478"/>
          <ac:spMkLst>
            <pc:docMk/>
            <pc:sldMk cId="3740585624" sldId="260"/>
            <ac:spMk id="2" creationId="{F97F7072-815B-9292-3A89-3D03A978186C}"/>
          </ac:spMkLst>
        </pc:spChg>
        <pc:spChg chg="del">
          <ac:chgData name="Dawn Holmes" userId="b7a8a953-5552-462e-ab5c-f3e22cb2b5df" providerId="ADAL" clId="{91CB56AA-EA07-4E7B-8CF8-687302C44E3C}" dt="2026-04-09T21:31:26.595" v="501" actId="478"/>
          <ac:spMkLst>
            <pc:docMk/>
            <pc:sldMk cId="3740585624" sldId="260"/>
            <ac:spMk id="3" creationId="{385C9B53-C090-4E10-0FFF-11B6CFBED29F}"/>
          </ac:spMkLst>
        </pc:spChg>
        <pc:spChg chg="add mod">
          <ac:chgData name="Dawn Holmes" userId="b7a8a953-5552-462e-ab5c-f3e22cb2b5df" providerId="ADAL" clId="{91CB56AA-EA07-4E7B-8CF8-687302C44E3C}" dt="2026-04-09T22:07:40.182" v="557" actId="1038"/>
          <ac:spMkLst>
            <pc:docMk/>
            <pc:sldMk cId="3740585624" sldId="260"/>
            <ac:spMk id="10" creationId="{CD7EAB12-CDFD-78E7-3AAB-0709547861B5}"/>
          </ac:spMkLst>
        </pc:spChg>
        <pc:spChg chg="add mod">
          <ac:chgData name="Dawn Holmes" userId="b7a8a953-5552-462e-ab5c-f3e22cb2b5df" providerId="ADAL" clId="{91CB56AA-EA07-4E7B-8CF8-687302C44E3C}" dt="2026-04-09T22:07:50.806" v="566" actId="1036"/>
          <ac:spMkLst>
            <pc:docMk/>
            <pc:sldMk cId="3740585624" sldId="260"/>
            <ac:spMk id="11" creationId="{2DE77165-68F1-DFE1-07E7-C70A914666A0}"/>
          </ac:spMkLst>
        </pc:spChg>
        <pc:spChg chg="add mod">
          <ac:chgData name="Dawn Holmes" userId="b7a8a953-5552-462e-ab5c-f3e22cb2b5df" providerId="ADAL" clId="{91CB56AA-EA07-4E7B-8CF8-687302C44E3C}" dt="2026-04-09T22:07:47.280" v="564" actId="1036"/>
          <ac:spMkLst>
            <pc:docMk/>
            <pc:sldMk cId="3740585624" sldId="260"/>
            <ac:spMk id="12" creationId="{5ACA912B-456C-A0C2-00FB-6C7D1D8E5E6F}"/>
          </ac:spMkLst>
        </pc:spChg>
        <pc:spChg chg="add mod">
          <ac:chgData name="Dawn Holmes" userId="b7a8a953-5552-462e-ab5c-f3e22cb2b5df" providerId="ADAL" clId="{91CB56AA-EA07-4E7B-8CF8-687302C44E3C}" dt="2026-04-09T22:10:37.714" v="575" actId="20577"/>
          <ac:spMkLst>
            <pc:docMk/>
            <pc:sldMk cId="3740585624" sldId="260"/>
            <ac:spMk id="14" creationId="{D70B46E7-6D14-C2FA-4519-CAEDAC8F47E9}"/>
          </ac:spMkLst>
        </pc:spChg>
        <pc:graphicFrameChg chg="add mod modGraphic">
          <ac:chgData name="Dawn Holmes" userId="b7a8a953-5552-462e-ab5c-f3e22cb2b5df" providerId="ADAL" clId="{91CB56AA-EA07-4E7B-8CF8-687302C44E3C}" dt="2026-04-09T22:56:08.511" v="1061" actId="207"/>
          <ac:graphicFrameMkLst>
            <pc:docMk/>
            <pc:sldMk cId="3740585624" sldId="260"/>
            <ac:graphicFrameMk id="13" creationId="{ADAD441A-04DE-9A55-FDC4-2341C6F29873}"/>
          </ac:graphicFrameMkLst>
        </pc:graphicFrameChg>
        <pc:picChg chg="add mod">
          <ac:chgData name="Dawn Holmes" userId="b7a8a953-5552-462e-ab5c-f3e22cb2b5df" providerId="ADAL" clId="{91CB56AA-EA07-4E7B-8CF8-687302C44E3C}" dt="2026-04-09T22:06:38.640" v="530" actId="1035"/>
          <ac:picMkLst>
            <pc:docMk/>
            <pc:sldMk cId="3740585624" sldId="260"/>
            <ac:picMk id="5" creationId="{9119F249-A5F2-715D-60E4-DEB8EFD93FF2}"/>
          </ac:picMkLst>
        </pc:picChg>
        <pc:picChg chg="add mod">
          <ac:chgData name="Dawn Holmes" userId="b7a8a953-5552-462e-ab5c-f3e22cb2b5df" providerId="ADAL" clId="{91CB56AA-EA07-4E7B-8CF8-687302C44E3C}" dt="2026-04-09T22:06:40.837" v="537" actId="1035"/>
          <ac:picMkLst>
            <pc:docMk/>
            <pc:sldMk cId="3740585624" sldId="260"/>
            <ac:picMk id="7" creationId="{DCC09847-7ED0-9D74-A7C3-ECAEE50C76E5}"/>
          </ac:picMkLst>
        </pc:picChg>
        <pc:picChg chg="add mod">
          <ac:chgData name="Dawn Holmes" userId="b7a8a953-5552-462e-ab5c-f3e22cb2b5df" providerId="ADAL" clId="{91CB56AA-EA07-4E7B-8CF8-687302C44E3C}" dt="2026-04-09T22:06:43.184" v="544" actId="1035"/>
          <ac:picMkLst>
            <pc:docMk/>
            <pc:sldMk cId="3740585624" sldId="260"/>
            <ac:picMk id="9" creationId="{91377A5A-C6BE-7699-9980-8DC13EEA965F}"/>
          </ac:picMkLst>
        </pc:picChg>
      </pc:sldChg>
      <pc:sldChg chg="addSp delSp modSp new mod">
        <pc:chgData name="Dawn Holmes" userId="b7a8a953-5552-462e-ab5c-f3e22cb2b5df" providerId="ADAL" clId="{91CB56AA-EA07-4E7B-8CF8-687302C44E3C}" dt="2026-04-09T22:55:53.209" v="1058" actId="20577"/>
        <pc:sldMkLst>
          <pc:docMk/>
          <pc:sldMk cId="2455857031" sldId="261"/>
        </pc:sldMkLst>
        <pc:spChg chg="del">
          <ac:chgData name="Dawn Holmes" userId="b7a8a953-5552-462e-ab5c-f3e22cb2b5df" providerId="ADAL" clId="{91CB56AA-EA07-4E7B-8CF8-687302C44E3C}" dt="2026-04-09T22:10:49.576" v="578" actId="478"/>
          <ac:spMkLst>
            <pc:docMk/>
            <pc:sldMk cId="2455857031" sldId="261"/>
            <ac:spMk id="2" creationId="{9E54C79F-B4C8-6C44-1A77-F199B164AE0B}"/>
          </ac:spMkLst>
        </pc:spChg>
        <pc:spChg chg="del">
          <ac:chgData name="Dawn Holmes" userId="b7a8a953-5552-462e-ab5c-f3e22cb2b5df" providerId="ADAL" clId="{91CB56AA-EA07-4E7B-8CF8-687302C44E3C}" dt="2026-04-09T22:10:46.276" v="577" actId="478"/>
          <ac:spMkLst>
            <pc:docMk/>
            <pc:sldMk cId="2455857031" sldId="261"/>
            <ac:spMk id="3" creationId="{8AE18E7C-655B-99FE-EC23-A5CCFEA459B3}"/>
          </ac:spMkLst>
        </pc:spChg>
        <pc:spChg chg="add mod">
          <ac:chgData name="Dawn Holmes" userId="b7a8a953-5552-462e-ab5c-f3e22cb2b5df" providerId="ADAL" clId="{91CB56AA-EA07-4E7B-8CF8-687302C44E3C}" dt="2026-04-09T22:15:43.528" v="638" actId="1037"/>
          <ac:spMkLst>
            <pc:docMk/>
            <pc:sldMk cId="2455857031" sldId="261"/>
            <ac:spMk id="10" creationId="{95712133-9EF3-D15E-8C12-E816D0A7A07E}"/>
          </ac:spMkLst>
        </pc:spChg>
        <pc:spChg chg="add mod">
          <ac:chgData name="Dawn Holmes" userId="b7a8a953-5552-462e-ab5c-f3e22cb2b5df" providerId="ADAL" clId="{91CB56AA-EA07-4E7B-8CF8-687302C44E3C}" dt="2026-04-09T22:15:49.347" v="641" actId="1076"/>
          <ac:spMkLst>
            <pc:docMk/>
            <pc:sldMk cId="2455857031" sldId="261"/>
            <ac:spMk id="11" creationId="{B3064E58-67F4-379B-2873-CCE5E42A27D6}"/>
          </ac:spMkLst>
        </pc:spChg>
        <pc:spChg chg="add mod">
          <ac:chgData name="Dawn Holmes" userId="b7a8a953-5552-462e-ab5c-f3e22cb2b5df" providerId="ADAL" clId="{91CB56AA-EA07-4E7B-8CF8-687302C44E3C}" dt="2026-04-09T22:15:55.563" v="644" actId="1076"/>
          <ac:spMkLst>
            <pc:docMk/>
            <pc:sldMk cId="2455857031" sldId="261"/>
            <ac:spMk id="12" creationId="{292FC76D-8F7A-7B5A-48D3-D3DD1049693A}"/>
          </ac:spMkLst>
        </pc:spChg>
        <pc:spChg chg="add mod">
          <ac:chgData name="Dawn Holmes" userId="b7a8a953-5552-462e-ab5c-f3e22cb2b5df" providerId="ADAL" clId="{91CB56AA-EA07-4E7B-8CF8-687302C44E3C}" dt="2026-04-09T22:17:40.065" v="652" actId="20577"/>
          <ac:spMkLst>
            <pc:docMk/>
            <pc:sldMk cId="2455857031" sldId="261"/>
            <ac:spMk id="14" creationId="{F927133D-2569-F4C3-B1B5-573974483286}"/>
          </ac:spMkLst>
        </pc:spChg>
        <pc:graphicFrameChg chg="add mod modGraphic">
          <ac:chgData name="Dawn Holmes" userId="b7a8a953-5552-462e-ab5c-f3e22cb2b5df" providerId="ADAL" clId="{91CB56AA-EA07-4E7B-8CF8-687302C44E3C}" dt="2026-04-09T22:55:53.209" v="1058" actId="20577"/>
          <ac:graphicFrameMkLst>
            <pc:docMk/>
            <pc:sldMk cId="2455857031" sldId="261"/>
            <ac:graphicFrameMk id="13" creationId="{B5CF787D-0147-488E-2E8C-80ED1D0FE178}"/>
          </ac:graphicFrameMkLst>
        </pc:graphicFrameChg>
        <pc:picChg chg="add mod">
          <ac:chgData name="Dawn Holmes" userId="b7a8a953-5552-462e-ab5c-f3e22cb2b5df" providerId="ADAL" clId="{91CB56AA-EA07-4E7B-8CF8-687302C44E3C}" dt="2026-04-09T22:14:43" v="604" actId="1038"/>
          <ac:picMkLst>
            <pc:docMk/>
            <pc:sldMk cId="2455857031" sldId="261"/>
            <ac:picMk id="5" creationId="{72AFF809-ACC1-CE0B-0AA5-0F9BB84FFAD7}"/>
          </ac:picMkLst>
        </pc:picChg>
        <pc:picChg chg="add mod">
          <ac:chgData name="Dawn Holmes" userId="b7a8a953-5552-462e-ab5c-f3e22cb2b5df" providerId="ADAL" clId="{91CB56AA-EA07-4E7B-8CF8-687302C44E3C}" dt="2026-04-09T22:15:02.883" v="618" actId="14100"/>
          <ac:picMkLst>
            <pc:docMk/>
            <pc:sldMk cId="2455857031" sldId="261"/>
            <ac:picMk id="7" creationId="{0AD82611-0C17-D2F9-6E14-7144DFC66CE9}"/>
          </ac:picMkLst>
        </pc:picChg>
        <pc:picChg chg="add mod">
          <ac:chgData name="Dawn Holmes" userId="b7a8a953-5552-462e-ab5c-f3e22cb2b5df" providerId="ADAL" clId="{91CB56AA-EA07-4E7B-8CF8-687302C44E3C}" dt="2026-04-09T22:15:06.371" v="619" actId="14100"/>
          <ac:picMkLst>
            <pc:docMk/>
            <pc:sldMk cId="2455857031" sldId="261"/>
            <ac:picMk id="9" creationId="{690D259F-8C81-DD38-1C04-402FE56D8361}"/>
          </ac:picMkLst>
        </pc:picChg>
      </pc:sldChg>
      <pc:sldChg chg="addSp delSp modSp new mod">
        <pc:chgData name="Dawn Holmes" userId="b7a8a953-5552-462e-ab5c-f3e22cb2b5df" providerId="ADAL" clId="{91CB56AA-EA07-4E7B-8CF8-687302C44E3C}" dt="2026-04-09T22:55:26.957" v="1053" actId="20577"/>
        <pc:sldMkLst>
          <pc:docMk/>
          <pc:sldMk cId="211723739" sldId="262"/>
        </pc:sldMkLst>
        <pc:spChg chg="del">
          <ac:chgData name="Dawn Holmes" userId="b7a8a953-5552-462e-ab5c-f3e22cb2b5df" providerId="ADAL" clId="{91CB56AA-EA07-4E7B-8CF8-687302C44E3C}" dt="2026-04-09T22:17:54.322" v="654" actId="478"/>
          <ac:spMkLst>
            <pc:docMk/>
            <pc:sldMk cId="211723739" sldId="262"/>
            <ac:spMk id="2" creationId="{F33FF058-DB0D-0A88-68B2-B2630AD267CD}"/>
          </ac:spMkLst>
        </pc:spChg>
        <pc:spChg chg="del">
          <ac:chgData name="Dawn Holmes" userId="b7a8a953-5552-462e-ab5c-f3e22cb2b5df" providerId="ADAL" clId="{91CB56AA-EA07-4E7B-8CF8-687302C44E3C}" dt="2026-04-09T22:17:54.322" v="654" actId="478"/>
          <ac:spMkLst>
            <pc:docMk/>
            <pc:sldMk cId="211723739" sldId="262"/>
            <ac:spMk id="3" creationId="{C78109DB-885F-CEF8-2276-74D4AE2184B5}"/>
          </ac:spMkLst>
        </pc:spChg>
        <pc:spChg chg="add mod">
          <ac:chgData name="Dawn Holmes" userId="b7a8a953-5552-462e-ab5c-f3e22cb2b5df" providerId="ADAL" clId="{91CB56AA-EA07-4E7B-8CF8-687302C44E3C}" dt="2026-04-09T22:44:26.041" v="902" actId="20577"/>
          <ac:spMkLst>
            <pc:docMk/>
            <pc:sldMk cId="211723739" sldId="262"/>
            <ac:spMk id="10" creationId="{1AA51873-ADD6-B6A2-5A8E-7C9A2E9B5615}"/>
          </ac:spMkLst>
        </pc:spChg>
        <pc:spChg chg="add mod">
          <ac:chgData name="Dawn Holmes" userId="b7a8a953-5552-462e-ab5c-f3e22cb2b5df" providerId="ADAL" clId="{91CB56AA-EA07-4E7B-8CF8-687302C44E3C}" dt="2026-04-09T22:44:29.533" v="904" actId="20577"/>
          <ac:spMkLst>
            <pc:docMk/>
            <pc:sldMk cId="211723739" sldId="262"/>
            <ac:spMk id="11" creationId="{D58D2251-F19C-84C6-C539-7644CEF03CA0}"/>
          </ac:spMkLst>
        </pc:spChg>
        <pc:spChg chg="add mod">
          <ac:chgData name="Dawn Holmes" userId="b7a8a953-5552-462e-ab5c-f3e22cb2b5df" providerId="ADAL" clId="{91CB56AA-EA07-4E7B-8CF8-687302C44E3C}" dt="2026-04-09T22:44:32.828" v="906" actId="20577"/>
          <ac:spMkLst>
            <pc:docMk/>
            <pc:sldMk cId="211723739" sldId="262"/>
            <ac:spMk id="12" creationId="{865E1A26-3EAC-D24D-2BA2-AF110BEA549C}"/>
          </ac:spMkLst>
        </pc:spChg>
        <pc:spChg chg="add mod">
          <ac:chgData name="Dawn Holmes" userId="b7a8a953-5552-462e-ab5c-f3e22cb2b5df" providerId="ADAL" clId="{91CB56AA-EA07-4E7B-8CF8-687302C44E3C}" dt="2026-04-09T22:24:34.421" v="790" actId="20577"/>
          <ac:spMkLst>
            <pc:docMk/>
            <pc:sldMk cId="211723739" sldId="262"/>
            <ac:spMk id="14" creationId="{884A6FE2-EB9A-874C-8FF4-5675A483DABE}"/>
          </ac:spMkLst>
        </pc:spChg>
        <pc:graphicFrameChg chg="add mod modGraphic">
          <ac:chgData name="Dawn Holmes" userId="b7a8a953-5552-462e-ab5c-f3e22cb2b5df" providerId="ADAL" clId="{91CB56AA-EA07-4E7B-8CF8-687302C44E3C}" dt="2026-04-09T22:55:26.957" v="1053" actId="20577"/>
          <ac:graphicFrameMkLst>
            <pc:docMk/>
            <pc:sldMk cId="211723739" sldId="262"/>
            <ac:graphicFrameMk id="13" creationId="{867042AF-C894-C44F-6AA2-CF128946B201}"/>
          </ac:graphicFrameMkLst>
        </pc:graphicFrameChg>
        <pc:picChg chg="add mod">
          <ac:chgData name="Dawn Holmes" userId="b7a8a953-5552-462e-ab5c-f3e22cb2b5df" providerId="ADAL" clId="{91CB56AA-EA07-4E7B-8CF8-687302C44E3C}" dt="2026-04-09T22:24:05.732" v="784" actId="1076"/>
          <ac:picMkLst>
            <pc:docMk/>
            <pc:sldMk cId="211723739" sldId="262"/>
            <ac:picMk id="5" creationId="{E4E6BC70-BCB5-9F20-51C3-9B8D1457FA81}"/>
          </ac:picMkLst>
        </pc:picChg>
        <pc:picChg chg="add mod">
          <ac:chgData name="Dawn Holmes" userId="b7a8a953-5552-462e-ab5c-f3e22cb2b5df" providerId="ADAL" clId="{91CB56AA-EA07-4E7B-8CF8-687302C44E3C}" dt="2026-04-09T22:24:01.125" v="782" actId="1076"/>
          <ac:picMkLst>
            <pc:docMk/>
            <pc:sldMk cId="211723739" sldId="262"/>
            <ac:picMk id="7" creationId="{28065578-4F6C-D7B2-8F3A-7DE368D04E4D}"/>
          </ac:picMkLst>
        </pc:picChg>
        <pc:picChg chg="add mod">
          <ac:chgData name="Dawn Holmes" userId="b7a8a953-5552-462e-ab5c-f3e22cb2b5df" providerId="ADAL" clId="{91CB56AA-EA07-4E7B-8CF8-687302C44E3C}" dt="2026-04-09T22:24:02.948" v="783" actId="1076"/>
          <ac:picMkLst>
            <pc:docMk/>
            <pc:sldMk cId="211723739" sldId="262"/>
            <ac:picMk id="9" creationId="{3B62D786-AE78-37E6-117D-3334714EF74E}"/>
          </ac:picMkLst>
        </pc:picChg>
      </pc:sldChg>
      <pc:sldChg chg="addSp delSp modSp new mod">
        <pc:chgData name="Dawn Holmes" userId="b7a8a953-5552-462e-ab5c-f3e22cb2b5df" providerId="ADAL" clId="{91CB56AA-EA07-4E7B-8CF8-687302C44E3C}" dt="2026-04-09T22:55:29.579" v="1054" actId="20577"/>
        <pc:sldMkLst>
          <pc:docMk/>
          <pc:sldMk cId="1404835807" sldId="263"/>
        </pc:sldMkLst>
        <pc:spChg chg="del">
          <ac:chgData name="Dawn Holmes" userId="b7a8a953-5552-462e-ab5c-f3e22cb2b5df" providerId="ADAL" clId="{91CB56AA-EA07-4E7B-8CF8-687302C44E3C}" dt="2026-04-09T22:24:45.790" v="793" actId="478"/>
          <ac:spMkLst>
            <pc:docMk/>
            <pc:sldMk cId="1404835807" sldId="263"/>
            <ac:spMk id="2" creationId="{E7F7354D-7F24-1F1A-6ED4-538ED62A3893}"/>
          </ac:spMkLst>
        </pc:spChg>
        <pc:spChg chg="del">
          <ac:chgData name="Dawn Holmes" userId="b7a8a953-5552-462e-ab5c-f3e22cb2b5df" providerId="ADAL" clId="{91CB56AA-EA07-4E7B-8CF8-687302C44E3C}" dt="2026-04-09T22:24:41.755" v="792" actId="478"/>
          <ac:spMkLst>
            <pc:docMk/>
            <pc:sldMk cId="1404835807" sldId="263"/>
            <ac:spMk id="3" creationId="{EC46582B-9FAE-67C3-B4AE-7638C2CA4E64}"/>
          </ac:spMkLst>
        </pc:spChg>
        <pc:spChg chg="add mod">
          <ac:chgData name="Dawn Holmes" userId="b7a8a953-5552-462e-ab5c-f3e22cb2b5df" providerId="ADAL" clId="{91CB56AA-EA07-4E7B-8CF8-687302C44E3C}" dt="2026-04-09T22:29:24.713" v="838" actId="20577"/>
          <ac:spMkLst>
            <pc:docMk/>
            <pc:sldMk cId="1404835807" sldId="263"/>
            <ac:spMk id="11" creationId="{8CDB5440-7695-FE3F-EA9A-58F1D0A40C3F}"/>
          </ac:spMkLst>
        </pc:spChg>
        <pc:spChg chg="add mod">
          <ac:chgData name="Dawn Holmes" userId="b7a8a953-5552-462e-ab5c-f3e22cb2b5df" providerId="ADAL" clId="{91CB56AA-EA07-4E7B-8CF8-687302C44E3C}" dt="2026-04-09T22:44:37.568" v="908" actId="20577"/>
          <ac:spMkLst>
            <pc:docMk/>
            <pc:sldMk cId="1404835807" sldId="263"/>
            <ac:spMk id="12" creationId="{F083A6A0-6BB1-BB96-54BC-4FBD58C22FA5}"/>
          </ac:spMkLst>
        </pc:spChg>
        <pc:spChg chg="add mod">
          <ac:chgData name="Dawn Holmes" userId="b7a8a953-5552-462e-ab5c-f3e22cb2b5df" providerId="ADAL" clId="{91CB56AA-EA07-4E7B-8CF8-687302C44E3C}" dt="2026-04-09T22:44:41.306" v="910" actId="20577"/>
          <ac:spMkLst>
            <pc:docMk/>
            <pc:sldMk cId="1404835807" sldId="263"/>
            <ac:spMk id="13" creationId="{4BFE22DA-7FA9-A526-704C-899909B4963C}"/>
          </ac:spMkLst>
        </pc:spChg>
        <pc:spChg chg="add mod">
          <ac:chgData name="Dawn Holmes" userId="b7a8a953-5552-462e-ab5c-f3e22cb2b5df" providerId="ADAL" clId="{91CB56AA-EA07-4E7B-8CF8-687302C44E3C}" dt="2026-04-09T22:44:53.583" v="933" actId="1037"/>
          <ac:spMkLst>
            <pc:docMk/>
            <pc:sldMk cId="1404835807" sldId="263"/>
            <ac:spMk id="14" creationId="{DD13474E-7B47-26E9-074C-C4C3FDE7EF50}"/>
          </ac:spMkLst>
        </pc:spChg>
        <pc:graphicFrameChg chg="add mod modGraphic">
          <ac:chgData name="Dawn Holmes" userId="b7a8a953-5552-462e-ab5c-f3e22cb2b5df" providerId="ADAL" clId="{91CB56AA-EA07-4E7B-8CF8-687302C44E3C}" dt="2026-04-09T22:55:29.579" v="1054" actId="20577"/>
          <ac:graphicFrameMkLst>
            <pc:docMk/>
            <pc:sldMk cId="1404835807" sldId="263"/>
            <ac:graphicFrameMk id="10" creationId="{FF111ED3-3B6C-3789-07C5-7806ED5D5B24}"/>
          </ac:graphicFrameMkLst>
        </pc:graphicFrameChg>
        <pc:picChg chg="add mod">
          <ac:chgData name="Dawn Holmes" userId="b7a8a953-5552-462e-ab5c-f3e22cb2b5df" providerId="ADAL" clId="{91CB56AA-EA07-4E7B-8CF8-687302C44E3C}" dt="2026-04-09T22:27:35.835" v="819" actId="1076"/>
          <ac:picMkLst>
            <pc:docMk/>
            <pc:sldMk cId="1404835807" sldId="263"/>
            <ac:picMk id="5" creationId="{7C6C843D-CB75-6C20-81A1-F93995124104}"/>
          </ac:picMkLst>
        </pc:picChg>
        <pc:picChg chg="add mod">
          <ac:chgData name="Dawn Holmes" userId="b7a8a953-5552-462e-ab5c-f3e22cb2b5df" providerId="ADAL" clId="{91CB56AA-EA07-4E7B-8CF8-687302C44E3C}" dt="2026-04-09T22:27:33.084" v="818" actId="1076"/>
          <ac:picMkLst>
            <pc:docMk/>
            <pc:sldMk cId="1404835807" sldId="263"/>
            <ac:picMk id="7" creationId="{F3C6535C-5FEE-EF52-8CCC-715FB4AA66BA}"/>
          </ac:picMkLst>
        </pc:picChg>
        <pc:picChg chg="add mod">
          <ac:chgData name="Dawn Holmes" userId="b7a8a953-5552-462e-ab5c-f3e22cb2b5df" providerId="ADAL" clId="{91CB56AA-EA07-4E7B-8CF8-687302C44E3C}" dt="2026-04-09T22:27:30.419" v="817" actId="1076"/>
          <ac:picMkLst>
            <pc:docMk/>
            <pc:sldMk cId="1404835807" sldId="263"/>
            <ac:picMk id="9" creationId="{6729E6F3-EEE0-E72D-4F1E-F36A6F091FCE}"/>
          </ac:picMkLst>
        </pc:picChg>
      </pc:sldChg>
      <pc:sldChg chg="addSp delSp modSp new mod">
        <pc:chgData name="Dawn Holmes" userId="b7a8a953-5552-462e-ab5c-f3e22cb2b5df" providerId="ADAL" clId="{91CB56AA-EA07-4E7B-8CF8-687302C44E3C}" dt="2026-04-09T22:55:32.504" v="1055" actId="20577"/>
        <pc:sldMkLst>
          <pc:docMk/>
          <pc:sldMk cId="1786771047" sldId="264"/>
        </pc:sldMkLst>
        <pc:spChg chg="del">
          <ac:chgData name="Dawn Holmes" userId="b7a8a953-5552-462e-ab5c-f3e22cb2b5df" providerId="ADAL" clId="{91CB56AA-EA07-4E7B-8CF8-687302C44E3C}" dt="2026-04-09T22:36:25.967" v="841" actId="478"/>
          <ac:spMkLst>
            <pc:docMk/>
            <pc:sldMk cId="1786771047" sldId="264"/>
            <ac:spMk id="2" creationId="{0A627FA5-2ED0-93A7-4951-8008E1E43815}"/>
          </ac:spMkLst>
        </pc:spChg>
        <pc:spChg chg="del">
          <ac:chgData name="Dawn Holmes" userId="b7a8a953-5552-462e-ab5c-f3e22cb2b5df" providerId="ADAL" clId="{91CB56AA-EA07-4E7B-8CF8-687302C44E3C}" dt="2026-04-09T22:36:22.875" v="840" actId="478"/>
          <ac:spMkLst>
            <pc:docMk/>
            <pc:sldMk cId="1786771047" sldId="264"/>
            <ac:spMk id="3" creationId="{5A3C1239-5BB4-6E69-DD0E-E7999FBA8E8A}"/>
          </ac:spMkLst>
        </pc:spChg>
        <pc:spChg chg="add mod">
          <ac:chgData name="Dawn Holmes" userId="b7a8a953-5552-462e-ab5c-f3e22cb2b5df" providerId="ADAL" clId="{91CB56AA-EA07-4E7B-8CF8-687302C44E3C}" dt="2026-04-09T22:45:15.504" v="937" actId="20577"/>
          <ac:spMkLst>
            <pc:docMk/>
            <pc:sldMk cId="1786771047" sldId="264"/>
            <ac:spMk id="10" creationId="{CC1C21EE-343C-6C6B-5A90-7B895958FD7E}"/>
          </ac:spMkLst>
        </pc:spChg>
        <pc:spChg chg="add mod">
          <ac:chgData name="Dawn Holmes" userId="b7a8a953-5552-462e-ab5c-f3e22cb2b5df" providerId="ADAL" clId="{91CB56AA-EA07-4E7B-8CF8-687302C44E3C}" dt="2026-04-09T22:45:22.749" v="940" actId="20577"/>
          <ac:spMkLst>
            <pc:docMk/>
            <pc:sldMk cId="1786771047" sldId="264"/>
            <ac:spMk id="11" creationId="{A4FC4E31-1770-28DA-EAA7-49529DC90E5C}"/>
          </ac:spMkLst>
        </pc:spChg>
        <pc:spChg chg="add mod">
          <ac:chgData name="Dawn Holmes" userId="b7a8a953-5552-462e-ab5c-f3e22cb2b5df" providerId="ADAL" clId="{91CB56AA-EA07-4E7B-8CF8-687302C44E3C}" dt="2026-04-09T22:45:29.415" v="943" actId="20577"/>
          <ac:spMkLst>
            <pc:docMk/>
            <pc:sldMk cId="1786771047" sldId="264"/>
            <ac:spMk id="12" creationId="{7DC82AEE-59FE-D903-086C-0C5292E15E3D}"/>
          </ac:spMkLst>
        </pc:spChg>
        <pc:spChg chg="add mod">
          <ac:chgData name="Dawn Holmes" userId="b7a8a953-5552-462e-ab5c-f3e22cb2b5df" providerId="ADAL" clId="{91CB56AA-EA07-4E7B-8CF8-687302C44E3C}" dt="2026-04-09T22:46:51.739" v="951" actId="20577"/>
          <ac:spMkLst>
            <pc:docMk/>
            <pc:sldMk cId="1786771047" sldId="264"/>
            <ac:spMk id="14" creationId="{F5CFBD4C-57FD-3E03-9603-3A97E9319D67}"/>
          </ac:spMkLst>
        </pc:spChg>
        <pc:graphicFrameChg chg="add mod modGraphic">
          <ac:chgData name="Dawn Holmes" userId="b7a8a953-5552-462e-ab5c-f3e22cb2b5df" providerId="ADAL" clId="{91CB56AA-EA07-4E7B-8CF8-687302C44E3C}" dt="2026-04-09T22:55:32.504" v="1055" actId="20577"/>
          <ac:graphicFrameMkLst>
            <pc:docMk/>
            <pc:sldMk cId="1786771047" sldId="264"/>
            <ac:graphicFrameMk id="13" creationId="{0C4B3114-8C7F-8C3E-6C8D-1F8FD1013483}"/>
          </ac:graphicFrameMkLst>
        </pc:graphicFrameChg>
        <pc:picChg chg="add mod">
          <ac:chgData name="Dawn Holmes" userId="b7a8a953-5552-462e-ab5c-f3e22cb2b5df" providerId="ADAL" clId="{91CB56AA-EA07-4E7B-8CF8-687302C44E3C}" dt="2026-04-09T22:39:00.384" v="871" actId="1037"/>
          <ac:picMkLst>
            <pc:docMk/>
            <pc:sldMk cId="1786771047" sldId="264"/>
            <ac:picMk id="5" creationId="{C27E5F16-0D9A-E3FD-0135-A3803756CFC3}"/>
          </ac:picMkLst>
        </pc:picChg>
        <pc:picChg chg="add mod">
          <ac:chgData name="Dawn Holmes" userId="b7a8a953-5552-462e-ab5c-f3e22cb2b5df" providerId="ADAL" clId="{91CB56AA-EA07-4E7B-8CF8-687302C44E3C}" dt="2026-04-09T22:39:04.327" v="883" actId="1037"/>
          <ac:picMkLst>
            <pc:docMk/>
            <pc:sldMk cId="1786771047" sldId="264"/>
            <ac:picMk id="7" creationId="{BFC317DC-D5B8-E073-E334-A27CF39FC206}"/>
          </ac:picMkLst>
        </pc:picChg>
        <pc:picChg chg="add mod">
          <ac:chgData name="Dawn Holmes" userId="b7a8a953-5552-462e-ab5c-f3e22cb2b5df" providerId="ADAL" clId="{91CB56AA-EA07-4E7B-8CF8-687302C44E3C}" dt="2026-04-09T22:39:01.814" v="875" actId="1037"/>
          <ac:picMkLst>
            <pc:docMk/>
            <pc:sldMk cId="1786771047" sldId="264"/>
            <ac:picMk id="9" creationId="{AC8F091E-D231-DC86-9B8F-99F5AB47FD20}"/>
          </ac:picMkLst>
        </pc:picChg>
      </pc:sldChg>
      <pc:sldChg chg="addSp delSp modSp new mod">
        <pc:chgData name="Dawn Holmes" userId="b7a8a953-5552-462e-ab5c-f3e22cb2b5df" providerId="ADAL" clId="{91CB56AA-EA07-4E7B-8CF8-687302C44E3C}" dt="2026-04-09T22:56:22.682" v="1064" actId="1038"/>
        <pc:sldMkLst>
          <pc:docMk/>
          <pc:sldMk cId="3179911285" sldId="265"/>
        </pc:sldMkLst>
        <pc:spChg chg="del">
          <ac:chgData name="Dawn Holmes" userId="b7a8a953-5552-462e-ab5c-f3e22cb2b5df" providerId="ADAL" clId="{91CB56AA-EA07-4E7B-8CF8-687302C44E3C}" dt="2026-04-09T22:47:06.885" v="953" actId="478"/>
          <ac:spMkLst>
            <pc:docMk/>
            <pc:sldMk cId="3179911285" sldId="265"/>
            <ac:spMk id="2" creationId="{0CA9A6DC-780D-33C7-90D4-0F8307241E85}"/>
          </ac:spMkLst>
        </pc:spChg>
        <pc:spChg chg="del">
          <ac:chgData name="Dawn Holmes" userId="b7a8a953-5552-462e-ab5c-f3e22cb2b5df" providerId="ADAL" clId="{91CB56AA-EA07-4E7B-8CF8-687302C44E3C}" dt="2026-04-09T22:47:06.885" v="953" actId="478"/>
          <ac:spMkLst>
            <pc:docMk/>
            <pc:sldMk cId="3179911285" sldId="265"/>
            <ac:spMk id="3" creationId="{21A343B0-B1B4-4654-0365-2383D884FB22}"/>
          </ac:spMkLst>
        </pc:spChg>
        <pc:spChg chg="add mod">
          <ac:chgData name="Dawn Holmes" userId="b7a8a953-5552-462e-ab5c-f3e22cb2b5df" providerId="ADAL" clId="{91CB56AA-EA07-4E7B-8CF8-687302C44E3C}" dt="2026-04-09T22:56:22.682" v="1064" actId="1038"/>
          <ac:spMkLst>
            <pc:docMk/>
            <pc:sldMk cId="3179911285" sldId="265"/>
            <ac:spMk id="12" creationId="{E5A8D821-DBAE-0558-80E7-1C09846B34E8}"/>
          </ac:spMkLst>
        </pc:spChg>
        <pc:spChg chg="add mod">
          <ac:chgData name="Dawn Holmes" userId="b7a8a953-5552-462e-ab5c-f3e22cb2b5df" providerId="ADAL" clId="{91CB56AA-EA07-4E7B-8CF8-687302C44E3C}" dt="2026-04-09T22:52:00.548" v="1010" actId="1038"/>
          <ac:spMkLst>
            <pc:docMk/>
            <pc:sldMk cId="3179911285" sldId="265"/>
            <ac:spMk id="13" creationId="{993151FF-F6C8-101F-FA2F-D867BCC18D25}"/>
          </ac:spMkLst>
        </pc:spChg>
        <pc:spChg chg="add mod">
          <ac:chgData name="Dawn Holmes" userId="b7a8a953-5552-462e-ab5c-f3e22cb2b5df" providerId="ADAL" clId="{91CB56AA-EA07-4E7B-8CF8-687302C44E3C}" dt="2026-04-09T22:52:13.611" v="1019" actId="20577"/>
          <ac:spMkLst>
            <pc:docMk/>
            <pc:sldMk cId="3179911285" sldId="265"/>
            <ac:spMk id="14" creationId="{2582937D-AD75-2A70-8E8B-68A38A040DA6}"/>
          </ac:spMkLst>
        </pc:spChg>
        <pc:spChg chg="add mod">
          <ac:chgData name="Dawn Holmes" userId="b7a8a953-5552-462e-ab5c-f3e22cb2b5df" providerId="ADAL" clId="{91CB56AA-EA07-4E7B-8CF8-687302C44E3C}" dt="2026-04-09T22:54:23.155" v="1044" actId="1076"/>
          <ac:spMkLst>
            <pc:docMk/>
            <pc:sldMk cId="3179911285" sldId="265"/>
            <ac:spMk id="16" creationId="{4019C237-D111-60AC-0D6C-D4D91199E567}"/>
          </ac:spMkLst>
        </pc:spChg>
        <pc:graphicFrameChg chg="add mod modGraphic">
          <ac:chgData name="Dawn Holmes" userId="b7a8a953-5552-462e-ab5c-f3e22cb2b5df" providerId="ADAL" clId="{91CB56AA-EA07-4E7B-8CF8-687302C44E3C}" dt="2026-04-09T22:54:03.694" v="1038" actId="207"/>
          <ac:graphicFrameMkLst>
            <pc:docMk/>
            <pc:sldMk cId="3179911285" sldId="265"/>
            <ac:graphicFrameMk id="15" creationId="{7A8BDD78-2C06-ACC7-17B9-80223966B5A6}"/>
          </ac:graphicFrameMkLst>
        </pc:graphicFrameChg>
        <pc:picChg chg="add del mod">
          <ac:chgData name="Dawn Holmes" userId="b7a8a953-5552-462e-ab5c-f3e22cb2b5df" providerId="ADAL" clId="{91CB56AA-EA07-4E7B-8CF8-687302C44E3C}" dt="2026-04-09T22:49:05.297" v="957" actId="478"/>
          <ac:picMkLst>
            <pc:docMk/>
            <pc:sldMk cId="3179911285" sldId="265"/>
            <ac:picMk id="5" creationId="{AA8B2209-3BAA-A21B-AF1E-95B8FC7F7403}"/>
          </ac:picMkLst>
        </pc:picChg>
        <pc:picChg chg="add mod">
          <ac:chgData name="Dawn Holmes" userId="b7a8a953-5552-462e-ab5c-f3e22cb2b5df" providerId="ADAL" clId="{91CB56AA-EA07-4E7B-8CF8-687302C44E3C}" dt="2026-04-09T22:51:24.651" v="993" actId="1076"/>
          <ac:picMkLst>
            <pc:docMk/>
            <pc:sldMk cId="3179911285" sldId="265"/>
            <ac:picMk id="7" creationId="{1E61A132-2BB5-6CF2-2B11-2F3E10D9D9AA}"/>
          </ac:picMkLst>
        </pc:picChg>
        <pc:picChg chg="add mod">
          <ac:chgData name="Dawn Holmes" userId="b7a8a953-5552-462e-ab5c-f3e22cb2b5df" providerId="ADAL" clId="{91CB56AA-EA07-4E7B-8CF8-687302C44E3C}" dt="2026-04-09T22:51:10.060" v="991" actId="1076"/>
          <ac:picMkLst>
            <pc:docMk/>
            <pc:sldMk cId="3179911285" sldId="265"/>
            <ac:picMk id="9" creationId="{D6BFDCF9-D443-F206-D5F4-E380E5935185}"/>
          </ac:picMkLst>
        </pc:picChg>
        <pc:picChg chg="add mod">
          <ac:chgData name="Dawn Holmes" userId="b7a8a953-5552-462e-ab5c-f3e22cb2b5df" providerId="ADAL" clId="{91CB56AA-EA07-4E7B-8CF8-687302C44E3C}" dt="2026-04-09T22:51:03.588" v="988" actId="1076"/>
          <ac:picMkLst>
            <pc:docMk/>
            <pc:sldMk cId="3179911285" sldId="265"/>
            <ac:picMk id="11" creationId="{9E65E466-4412-AFBE-4559-600DDB66E59D}"/>
          </ac:picMkLst>
        </pc:picChg>
      </pc:sldChg>
      <pc:sldChg chg="addSp delSp modSp new mod">
        <pc:chgData name="Dawn Holmes" userId="b7a8a953-5552-462e-ab5c-f3e22cb2b5df" providerId="ADAL" clId="{91CB56AA-EA07-4E7B-8CF8-687302C44E3C}" dt="2026-04-09T23:53:32.098" v="1121" actId="207"/>
        <pc:sldMkLst>
          <pc:docMk/>
          <pc:sldMk cId="3638451264" sldId="266"/>
        </pc:sldMkLst>
        <pc:spChg chg="del">
          <ac:chgData name="Dawn Holmes" userId="b7a8a953-5552-462e-ab5c-f3e22cb2b5df" providerId="ADAL" clId="{91CB56AA-EA07-4E7B-8CF8-687302C44E3C}" dt="2026-04-09T23:46:28.079" v="1066" actId="478"/>
          <ac:spMkLst>
            <pc:docMk/>
            <pc:sldMk cId="3638451264" sldId="266"/>
            <ac:spMk id="2" creationId="{200AF1AD-9629-53F2-9B6F-C39269EA56E9}"/>
          </ac:spMkLst>
        </pc:spChg>
        <pc:spChg chg="del">
          <ac:chgData name="Dawn Holmes" userId="b7a8a953-5552-462e-ab5c-f3e22cb2b5df" providerId="ADAL" clId="{91CB56AA-EA07-4E7B-8CF8-687302C44E3C}" dt="2026-04-09T23:46:28.079" v="1066" actId="478"/>
          <ac:spMkLst>
            <pc:docMk/>
            <pc:sldMk cId="3638451264" sldId="266"/>
            <ac:spMk id="3" creationId="{A0E07019-30AC-58CE-D88A-91E518D29C05}"/>
          </ac:spMkLst>
        </pc:spChg>
        <pc:spChg chg="add mod">
          <ac:chgData name="Dawn Holmes" userId="b7a8a953-5552-462e-ab5c-f3e22cb2b5df" providerId="ADAL" clId="{91CB56AA-EA07-4E7B-8CF8-687302C44E3C}" dt="2026-04-09T23:50:52.263" v="1106" actId="1037"/>
          <ac:spMkLst>
            <pc:docMk/>
            <pc:sldMk cId="3638451264" sldId="266"/>
            <ac:spMk id="10" creationId="{32C6937F-4F74-C8C6-0DE1-961F84F0F55C}"/>
          </ac:spMkLst>
        </pc:spChg>
        <pc:spChg chg="add mod">
          <ac:chgData name="Dawn Holmes" userId="b7a8a953-5552-462e-ab5c-f3e22cb2b5df" providerId="ADAL" clId="{91CB56AA-EA07-4E7B-8CF8-687302C44E3C}" dt="2026-04-09T23:51:00.889" v="1109" actId="20577"/>
          <ac:spMkLst>
            <pc:docMk/>
            <pc:sldMk cId="3638451264" sldId="266"/>
            <ac:spMk id="11" creationId="{1074D1B0-D005-BC56-5814-CD268B6CCE46}"/>
          </ac:spMkLst>
        </pc:spChg>
        <pc:spChg chg="add mod">
          <ac:chgData name="Dawn Holmes" userId="b7a8a953-5552-462e-ab5c-f3e22cb2b5df" providerId="ADAL" clId="{91CB56AA-EA07-4E7B-8CF8-687302C44E3C}" dt="2026-04-09T23:51:13.535" v="1112" actId="20577"/>
          <ac:spMkLst>
            <pc:docMk/>
            <pc:sldMk cId="3638451264" sldId="266"/>
            <ac:spMk id="12" creationId="{B4AFBE28-1897-5B0F-9E04-314BE2C18ACE}"/>
          </ac:spMkLst>
        </pc:spChg>
        <pc:spChg chg="add mod">
          <ac:chgData name="Dawn Holmes" userId="b7a8a953-5552-462e-ab5c-f3e22cb2b5df" providerId="ADAL" clId="{91CB56AA-EA07-4E7B-8CF8-687302C44E3C}" dt="2026-04-09T23:52:58.649" v="1119" actId="20577"/>
          <ac:spMkLst>
            <pc:docMk/>
            <pc:sldMk cId="3638451264" sldId="266"/>
            <ac:spMk id="14" creationId="{2760D75F-39A8-5222-D82B-F4098BD3C6C1}"/>
          </ac:spMkLst>
        </pc:spChg>
        <pc:graphicFrameChg chg="add mod modGraphic">
          <ac:chgData name="Dawn Holmes" userId="b7a8a953-5552-462e-ab5c-f3e22cb2b5df" providerId="ADAL" clId="{91CB56AA-EA07-4E7B-8CF8-687302C44E3C}" dt="2026-04-09T23:53:32.098" v="1121" actId="207"/>
          <ac:graphicFrameMkLst>
            <pc:docMk/>
            <pc:sldMk cId="3638451264" sldId="266"/>
            <ac:graphicFrameMk id="13" creationId="{C54FFDED-E46C-9BE8-4E02-6857983AAFC7}"/>
          </ac:graphicFrameMkLst>
        </pc:graphicFrameChg>
        <pc:picChg chg="add mod">
          <ac:chgData name="Dawn Holmes" userId="b7a8a953-5552-462e-ab5c-f3e22cb2b5df" providerId="ADAL" clId="{91CB56AA-EA07-4E7B-8CF8-687302C44E3C}" dt="2026-04-09T23:50:29.135" v="1099" actId="1076"/>
          <ac:picMkLst>
            <pc:docMk/>
            <pc:sldMk cId="3638451264" sldId="266"/>
            <ac:picMk id="5" creationId="{33089F7E-7367-751B-7BEE-4F6D4D975D6C}"/>
          </ac:picMkLst>
        </pc:picChg>
        <pc:picChg chg="add mod">
          <ac:chgData name="Dawn Holmes" userId="b7a8a953-5552-462e-ab5c-f3e22cb2b5df" providerId="ADAL" clId="{91CB56AA-EA07-4E7B-8CF8-687302C44E3C}" dt="2026-04-09T23:49:50.854" v="1084" actId="14100"/>
          <ac:picMkLst>
            <pc:docMk/>
            <pc:sldMk cId="3638451264" sldId="266"/>
            <ac:picMk id="7" creationId="{15B0DBD2-95DC-0C2B-BA88-5E854C6A199B}"/>
          </ac:picMkLst>
        </pc:picChg>
        <pc:picChg chg="add mod">
          <ac:chgData name="Dawn Holmes" userId="b7a8a953-5552-462e-ab5c-f3e22cb2b5df" providerId="ADAL" clId="{91CB56AA-EA07-4E7B-8CF8-687302C44E3C}" dt="2026-04-09T23:50:07.199" v="1097" actId="1076"/>
          <ac:picMkLst>
            <pc:docMk/>
            <pc:sldMk cId="3638451264" sldId="266"/>
            <ac:picMk id="9" creationId="{62CA81C4-CB68-49B9-A7A2-481C35C1E1E0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496484"/>
            <a:ext cx="10363200" cy="3183467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4802717"/>
            <a:ext cx="9144000" cy="2207683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EC2099-25F1-4615-A559-FE83B488974A}" type="datetimeFigureOut">
              <a:rPr lang="en-US" smtClean="0"/>
              <a:t>4/11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040B3D-7C10-4EEB-A496-C75F274494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23271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EC2099-25F1-4615-A559-FE83B488974A}" type="datetimeFigureOut">
              <a:rPr lang="en-US" smtClean="0"/>
              <a:t>4/11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040B3D-7C10-4EEB-A496-C75F274494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87228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486834"/>
            <a:ext cx="2628900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486834"/>
            <a:ext cx="7734300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EC2099-25F1-4615-A559-FE83B488974A}" type="datetimeFigureOut">
              <a:rPr lang="en-US" smtClean="0"/>
              <a:t>4/11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040B3D-7C10-4EEB-A496-C75F274494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1675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EC2099-25F1-4615-A559-FE83B488974A}" type="datetimeFigureOut">
              <a:rPr lang="en-US" smtClean="0"/>
              <a:t>4/11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040B3D-7C10-4EEB-A496-C75F274494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45900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2279653"/>
            <a:ext cx="10515600" cy="3803649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6119286"/>
            <a:ext cx="10515600" cy="200024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>
                    <a:tint val="82000"/>
                  </a:schemeClr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82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EC2099-25F1-4615-A559-FE83B488974A}" type="datetimeFigureOut">
              <a:rPr lang="en-US" smtClean="0"/>
              <a:t>4/11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040B3D-7C10-4EEB-A496-C75F274494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60907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2434167"/>
            <a:ext cx="518160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2434167"/>
            <a:ext cx="518160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EC2099-25F1-4615-A559-FE83B488974A}" type="datetimeFigureOut">
              <a:rPr lang="en-US" smtClean="0"/>
              <a:t>4/11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040B3D-7C10-4EEB-A496-C75F274494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55448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86836"/>
            <a:ext cx="10515600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2241551"/>
            <a:ext cx="5157787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3340100"/>
            <a:ext cx="5157787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2241551"/>
            <a:ext cx="5183188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3340100"/>
            <a:ext cx="5183188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EC2099-25F1-4615-A559-FE83B488974A}" type="datetimeFigureOut">
              <a:rPr lang="en-US" smtClean="0"/>
              <a:t>4/11/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040B3D-7C10-4EEB-A496-C75F274494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30691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EC2099-25F1-4615-A559-FE83B488974A}" type="datetimeFigureOut">
              <a:rPr lang="en-US" smtClean="0"/>
              <a:t>4/11/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040B3D-7C10-4EEB-A496-C75F274494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72349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EC2099-25F1-4615-A559-FE83B488974A}" type="datetimeFigureOut">
              <a:rPr lang="en-US" smtClean="0"/>
              <a:t>4/11/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040B3D-7C10-4EEB-A496-C75F274494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91682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609600"/>
            <a:ext cx="3932237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1316569"/>
            <a:ext cx="6172200" cy="6498167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743200"/>
            <a:ext cx="3932237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EC2099-25F1-4615-A559-FE83B488974A}" type="datetimeFigureOut">
              <a:rPr lang="en-US" smtClean="0"/>
              <a:t>4/11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040B3D-7C10-4EEB-A496-C75F274494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00403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609600"/>
            <a:ext cx="3932237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1316569"/>
            <a:ext cx="6172200" cy="6498167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743200"/>
            <a:ext cx="3932237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EC2099-25F1-4615-A559-FE83B488974A}" type="datetimeFigureOut">
              <a:rPr lang="en-US" smtClean="0"/>
              <a:t>4/11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040B3D-7C10-4EEB-A496-C75F274494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38529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486836"/>
            <a:ext cx="10515600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2434167"/>
            <a:ext cx="10515600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8475136"/>
            <a:ext cx="2743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6EC2099-25F1-4615-A559-FE83B488974A}" type="datetimeFigureOut">
              <a:rPr lang="en-US" smtClean="0"/>
              <a:t>4/11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8475136"/>
            <a:ext cx="41148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8475136"/>
            <a:ext cx="2743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F040B3D-7C10-4EEB-A496-C75F274494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69250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4" Type="http://schemas.openxmlformats.org/officeDocument/2006/relationships/image" Target="../media/image3.tif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tif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tif"/><Relationship Id="rId4" Type="http://schemas.openxmlformats.org/officeDocument/2006/relationships/image" Target="../media/image30.ti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8.tif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tif"/><Relationship Id="rId4" Type="http://schemas.openxmlformats.org/officeDocument/2006/relationships/image" Target="../media/image33.ti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1.ti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"/><Relationship Id="rId4" Type="http://schemas.openxmlformats.org/officeDocument/2006/relationships/image" Target="../media/image6.ti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4.ti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"/><Relationship Id="rId4" Type="http://schemas.openxmlformats.org/officeDocument/2006/relationships/image" Target="../media/image9.ti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7.ti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tif"/><Relationship Id="rId4" Type="http://schemas.openxmlformats.org/officeDocument/2006/relationships/image" Target="../media/image12.ti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0.ti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tif"/><Relationship Id="rId4" Type="http://schemas.openxmlformats.org/officeDocument/2006/relationships/image" Target="../media/image15.ti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3.ti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tif"/><Relationship Id="rId4" Type="http://schemas.openxmlformats.org/officeDocument/2006/relationships/image" Target="../media/image18.ti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6.ti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tif"/><Relationship Id="rId4" Type="http://schemas.openxmlformats.org/officeDocument/2006/relationships/image" Target="../media/image21.ti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9.ti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tif"/><Relationship Id="rId4" Type="http://schemas.openxmlformats.org/officeDocument/2006/relationships/image" Target="../media/image24.ti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2.tif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tif"/><Relationship Id="rId4" Type="http://schemas.openxmlformats.org/officeDocument/2006/relationships/image" Target="../media/image27.ti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5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xmlns="" id="{ECB4E2B8-4AEB-D426-9B0A-C45BB7C466A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0501" y="325865"/>
            <a:ext cx="3744191" cy="3199177"/>
          </a:xfrm>
          <a:prstGeom prst="rect">
            <a:avLst/>
          </a:prstGeom>
          <a:ln>
            <a:solidFill>
              <a:schemeClr val="tx1">
                <a:lumMod val="95000"/>
                <a:lumOff val="5000"/>
              </a:schemeClr>
            </a:solidFill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xmlns="" id="{F04A5139-32DB-2E2D-6292-B3DC433F227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01026" y="325863"/>
            <a:ext cx="3744191" cy="3199177"/>
          </a:xfrm>
          <a:prstGeom prst="rect">
            <a:avLst/>
          </a:prstGeom>
          <a:ln>
            <a:solidFill>
              <a:schemeClr val="tx1">
                <a:lumMod val="95000"/>
                <a:lumOff val="5000"/>
              </a:schemeClr>
            </a:solidFill>
          </a:ln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xmlns="" id="{6F570342-06D0-4EAD-4C3E-EED234FBFBA1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07454" y="325864"/>
            <a:ext cx="3744191" cy="3199177"/>
          </a:xfrm>
          <a:prstGeom prst="rect">
            <a:avLst/>
          </a:prstGeom>
          <a:ln>
            <a:solidFill>
              <a:schemeClr val="tx1">
                <a:lumMod val="95000"/>
                <a:lumOff val="5000"/>
              </a:schemeClr>
            </a:solidFill>
          </a:ln>
        </p:spPr>
      </p:pic>
      <p:graphicFrame>
        <p:nvGraphicFramePr>
          <p:cNvPr id="10" name="Table 9">
            <a:extLst>
              <a:ext uri="{FF2B5EF4-FFF2-40B4-BE49-F238E27FC236}">
                <a16:creationId xmlns:a16="http://schemas.microsoft.com/office/drawing/2014/main" xmlns="" id="{F3BCE9EE-168F-56C3-59AD-80C13035019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68538848"/>
              </p:ext>
            </p:extLst>
          </p:nvPr>
        </p:nvGraphicFramePr>
        <p:xfrm>
          <a:off x="1513396" y="3870746"/>
          <a:ext cx="9132306" cy="366268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965967">
                  <a:extLst>
                    <a:ext uri="{9D8B030D-6E8A-4147-A177-3AD203B41FA5}">
                      <a16:colId xmlns:a16="http://schemas.microsoft.com/office/drawing/2014/main" xmlns="" val="2939663930"/>
                    </a:ext>
                  </a:extLst>
                </a:gridCol>
                <a:gridCol w="6166339">
                  <a:extLst>
                    <a:ext uri="{9D8B030D-6E8A-4147-A177-3AD203B41FA5}">
                      <a16:colId xmlns:a16="http://schemas.microsoft.com/office/drawing/2014/main" xmlns="" val="3209885687"/>
                    </a:ext>
                  </a:extLst>
                </a:gridCol>
              </a:tblGrid>
              <a:tr h="261425">
                <a:tc>
                  <a:txBody>
                    <a:bodyPr/>
                    <a:lstStyle/>
                    <a:p>
                      <a:r>
                        <a:rPr lang="en-US" sz="12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alysis of OscA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sults</a:t>
                      </a:r>
                      <a:endParaRPr lang="en-US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006691554"/>
                  </a:ext>
                </a:extLst>
              </a:tr>
              <a:tr h="171938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del confidence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A=97.2%, LT=96.9% confidently predicted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214046072"/>
                  </a:ext>
                </a:extLst>
              </a:tr>
              <a:tr h="246575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M-score results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MSD=0.62 Å, TM-score=0.99, MaxSub-score=0.98, GDT-TS-score=0.99, GDT-HA-score=0.97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419888419"/>
                  </a:ext>
                </a:extLst>
              </a:tr>
              <a:tr h="227428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imeraX Matchmaker RMSD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2 Å (across all 289 pairs), 0.29 Å (across 285 pruned pairs), 1.38% of protein deviates &gt;2Å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4159834249"/>
                  </a:ext>
                </a:extLst>
              </a:tr>
              <a:tr h="231726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% helix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A=4.8%, LT=4.8%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490254430"/>
                  </a:ext>
                </a:extLst>
              </a:tr>
              <a:tr h="236025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% sheet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A=56.4%, LT=57.1%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976539031"/>
                  </a:ext>
                </a:extLst>
              </a:tr>
              <a:tr h="216877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sidues structurally changed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1% (6 residues)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620130767"/>
                  </a:ext>
                </a:extLst>
              </a:tr>
              <a:tr h="244622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Nemar test for helices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Nemar’s X</a:t>
                      </a:r>
                      <a:r>
                        <a:rPr lang="en-US" sz="1200" baseline="300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=NaN, df = 1, p-value =NaN (no difference)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519064644"/>
                  </a:ext>
                </a:extLst>
              </a:tr>
              <a:tr h="24892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Nemar test for strands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Nemar's X</a:t>
                      </a:r>
                      <a:r>
                        <a:rPr lang="en-US" sz="1200" baseline="300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=0.67, df = 1, p-value = 0.4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548791018"/>
                  </a:ext>
                </a:extLst>
              </a:tr>
              <a:tr h="229772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verage helix length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A=4.67 Å, LT=3.5 Å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74937089"/>
                  </a:ext>
                </a:extLst>
              </a:tr>
              <a:tr h="257517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ired t-test for differences in helix length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 =3.46, df = 2, p-value =0.05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758321292"/>
                  </a:ext>
                </a:extLst>
              </a:tr>
              <a:tr h="191477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verage </a:t>
                      </a:r>
                      <a:r>
                        <a:rPr lang="el-GR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β</a:t>
                      </a: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strand length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A=4.29 Å, LT=4.13 Å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18793239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ired t-test for differences in strand length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 = 0.37, </a:t>
                      </a:r>
                      <a:r>
                        <a:rPr lang="en-US" sz="12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f</a:t>
                      </a:r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= 37, p-value = 0.7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949914184"/>
                  </a:ext>
                </a:extLst>
              </a:tr>
            </a:tbl>
          </a:graphicData>
        </a:graphic>
      </p:graphicFrame>
      <p:sp>
        <p:nvSpPr>
          <p:cNvPr id="12" name="TextBox 11">
            <a:extLst>
              <a:ext uri="{FF2B5EF4-FFF2-40B4-BE49-F238E27FC236}">
                <a16:creationId xmlns:a16="http://schemas.microsoft.com/office/drawing/2014/main" xmlns="" id="{6ADF0CA8-9013-2EF2-2C18-16C3648808A1}"/>
              </a:ext>
            </a:extLst>
          </p:cNvPr>
          <p:cNvSpPr txBox="1"/>
          <p:nvPr/>
        </p:nvSpPr>
        <p:spPr>
          <a:xfrm>
            <a:off x="373945" y="7752130"/>
            <a:ext cx="10920844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buNone/>
            </a:pPr>
            <a:r>
              <a:rPr lang="en-US" sz="1200" b="1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3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 (A) Tertiary structure predictions made for </a:t>
            </a:r>
            <a:r>
              <a:rPr lang="en-US" sz="12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OscA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proteins using </a:t>
            </a:r>
            <a:r>
              <a:rPr lang="en-US" sz="12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alphafold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 The structures were visualized and </a:t>
            </a:r>
            <a:r>
              <a:rPr lang="en-US" sz="12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heme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positions were labeled in </a:t>
            </a:r>
            <a:r>
              <a:rPr lang="en-US" sz="12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ChimeraX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b="0" i="0" u="none" strike="noStrike" dirty="0" smtClean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or 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tructural comparisons, the predicted structures were superimposed using Matchmaker and colored by the calculated per residue Cα-</a:t>
            </a:r>
            <a:r>
              <a:rPr lang="en-US" sz="1200" b="0" i="0" u="none" strike="noStrike" dirty="0" smtClean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RMSD measurement. 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Residues are colored on a continuous gradient: Blue indicates the highest similarity (RMSD </a:t>
            </a:r>
            <a:r>
              <a:rPr lang="en-US" sz="1200" b="0" i="0" u="sng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&lt; 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A), white indicates intermediate difference (RMSD ~ 1 A), and red indicates the largest structural difference (RSD </a:t>
            </a:r>
            <a:r>
              <a:rPr lang="en-US" sz="1200" b="0" i="0" u="sng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&gt;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2 A). Secondary structures predicted by </a:t>
            </a:r>
            <a:r>
              <a:rPr lang="en-US" sz="12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alphafold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were also analyzed in DSSP and statistics comparing DSSP results were done with the R-stats package. 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xmlns="" id="{B3D3BD94-34F2-9DA5-B2CB-E7078F6867E2}"/>
              </a:ext>
            </a:extLst>
          </p:cNvPr>
          <p:cNvSpPr txBox="1"/>
          <p:nvPr/>
        </p:nvSpPr>
        <p:spPr>
          <a:xfrm>
            <a:off x="2695577" y="3166630"/>
            <a:ext cx="12327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>
                <a:latin typeface="Times New Roman"/>
                <a:cs typeface="Times New Roman"/>
              </a:rPr>
              <a:t>OscA</a:t>
            </a:r>
            <a:r>
              <a:rPr lang="en-US" b="1" dirty="0">
                <a:latin typeface="Times New Roman"/>
                <a:cs typeface="Times New Roman"/>
              </a:rPr>
              <a:t> PCA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xmlns="" id="{A5674784-CEC0-21A2-22E3-F45A4326E103}"/>
              </a:ext>
            </a:extLst>
          </p:cNvPr>
          <p:cNvSpPr txBox="1"/>
          <p:nvPr/>
        </p:nvSpPr>
        <p:spPr>
          <a:xfrm>
            <a:off x="6906842" y="3179400"/>
            <a:ext cx="10507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>
                <a:latin typeface="Times New Roman"/>
                <a:cs typeface="Times New Roman"/>
              </a:rPr>
              <a:t>OscA</a:t>
            </a:r>
            <a:r>
              <a:rPr lang="en-US" b="1" dirty="0">
                <a:latin typeface="Times New Roman"/>
                <a:cs typeface="Times New Roman"/>
              </a:rPr>
              <a:t> LT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xmlns="" id="{B7780117-2B36-3FC5-AEDD-920CCFE35E54}"/>
              </a:ext>
            </a:extLst>
          </p:cNvPr>
          <p:cNvSpPr txBox="1"/>
          <p:nvPr/>
        </p:nvSpPr>
        <p:spPr>
          <a:xfrm>
            <a:off x="10371500" y="3139833"/>
            <a:ext cx="15892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>
                <a:latin typeface="Times New Roman"/>
                <a:cs typeface="Times New Roman"/>
              </a:rPr>
              <a:t>OscA</a:t>
            </a:r>
            <a:r>
              <a:rPr lang="en-US" b="1" dirty="0">
                <a:latin typeface="Times New Roman"/>
                <a:cs typeface="Times New Roman"/>
              </a:rPr>
              <a:t> PCA/LT</a:t>
            </a:r>
          </a:p>
        </p:txBody>
      </p:sp>
    </p:spTree>
    <p:extLst>
      <p:ext uri="{BB962C8B-B14F-4D97-AF65-F5344CB8AC3E}">
        <p14:creationId xmlns:p14="http://schemas.microsoft.com/office/powerpoint/2010/main" val="251365428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xmlns="" id="{1E61A132-2BB5-6CF2-2B11-2F3E10D9D9A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8549" y="237118"/>
            <a:ext cx="3569996" cy="298600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xmlns="" id="{D6BFDCF9-D443-F206-D5F4-E380E593518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43455" y="183295"/>
            <a:ext cx="3569996" cy="293218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xmlns="" id="{9E65E466-4412-AFBE-4559-600DDB66E59D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34537" y="237118"/>
            <a:ext cx="3569996" cy="293218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xmlns="" id="{E5A8D821-DBAE-0558-80E7-1C09846B34E8}"/>
              </a:ext>
            </a:extLst>
          </p:cNvPr>
          <p:cNvSpPr txBox="1"/>
          <p:nvPr/>
        </p:nvSpPr>
        <p:spPr>
          <a:xfrm>
            <a:off x="2760552" y="254666"/>
            <a:ext cx="1197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>
                <a:latin typeface="Times New Roman"/>
                <a:cs typeface="Times New Roman"/>
              </a:rPr>
              <a:t>OscJ</a:t>
            </a:r>
            <a:r>
              <a:rPr lang="en-US" b="1" dirty="0">
                <a:latin typeface="Times New Roman"/>
                <a:cs typeface="Times New Roman"/>
              </a:rPr>
              <a:t> PC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xmlns="" id="{993151FF-F6C8-101F-FA2F-D867BCC18D25}"/>
              </a:ext>
            </a:extLst>
          </p:cNvPr>
          <p:cNvSpPr txBox="1"/>
          <p:nvPr/>
        </p:nvSpPr>
        <p:spPr>
          <a:xfrm>
            <a:off x="6994967" y="239352"/>
            <a:ext cx="10121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>
                <a:latin typeface="Times New Roman"/>
                <a:cs typeface="Times New Roman"/>
              </a:rPr>
              <a:t>OscJ</a:t>
            </a:r>
            <a:r>
              <a:rPr lang="en-US" b="1" dirty="0">
                <a:latin typeface="Times New Roman"/>
                <a:cs typeface="Times New Roman"/>
              </a:rPr>
              <a:t> LT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xmlns="" id="{2582937D-AD75-2A70-8E8B-68A38A040DA6}"/>
              </a:ext>
            </a:extLst>
          </p:cNvPr>
          <p:cNvSpPr txBox="1"/>
          <p:nvPr/>
        </p:nvSpPr>
        <p:spPr>
          <a:xfrm>
            <a:off x="10323027" y="187675"/>
            <a:ext cx="15507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>
                <a:latin typeface="Times New Roman"/>
                <a:cs typeface="Times New Roman"/>
              </a:rPr>
              <a:t>OscJ</a:t>
            </a:r>
            <a:r>
              <a:rPr lang="en-US" b="1" dirty="0">
                <a:latin typeface="Times New Roman"/>
                <a:cs typeface="Times New Roman"/>
              </a:rPr>
              <a:t> PCA/LT</a:t>
            </a:r>
          </a:p>
        </p:txBody>
      </p:sp>
      <p:graphicFrame>
        <p:nvGraphicFramePr>
          <p:cNvPr id="15" name="Table 14">
            <a:extLst>
              <a:ext uri="{FF2B5EF4-FFF2-40B4-BE49-F238E27FC236}">
                <a16:creationId xmlns:a16="http://schemas.microsoft.com/office/drawing/2014/main" xmlns="" id="{7A8BDD78-2C06-ACC7-17B9-80223966B5A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54236577"/>
              </p:ext>
            </p:extLst>
          </p:nvPr>
        </p:nvGraphicFramePr>
        <p:xfrm>
          <a:off x="1191491" y="3356702"/>
          <a:ext cx="9413660" cy="3978031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3153537">
                  <a:extLst>
                    <a:ext uri="{9D8B030D-6E8A-4147-A177-3AD203B41FA5}">
                      <a16:colId xmlns:a16="http://schemas.microsoft.com/office/drawing/2014/main" xmlns="" val="2092062374"/>
                    </a:ext>
                  </a:extLst>
                </a:gridCol>
                <a:gridCol w="6260123">
                  <a:extLst>
                    <a:ext uri="{9D8B030D-6E8A-4147-A177-3AD203B41FA5}">
                      <a16:colId xmlns:a16="http://schemas.microsoft.com/office/drawing/2014/main" xmlns="" val="3824839342"/>
                    </a:ext>
                  </a:extLst>
                </a:gridCol>
              </a:tblGrid>
              <a:tr h="237978">
                <a:tc>
                  <a:txBody>
                    <a:bodyPr/>
                    <a:lstStyle/>
                    <a:p>
                      <a:r>
                        <a:rPr lang="en-US" sz="12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alysis of OscJ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sults</a:t>
                      </a:r>
                      <a:endParaRPr lang="en-US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835661109"/>
                  </a:ext>
                </a:extLst>
              </a:tr>
              <a:tr h="218831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del confidence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A=60%, LT=95% confidently predicted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664505072"/>
                  </a:ext>
                </a:extLst>
              </a:tr>
              <a:tr h="246575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M-score results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MSD=24.3 Å, TM-score=0.65, MaxSub-score=0.58, GDT-TS-score=0.59, GDT-HA-score=0.53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64643894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imeraX Matchmaker RMSD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.06 Å (across all 372 pairs), 0.77 Å (across 246 pruned pairs), 33.87% of protein deviates &gt;2Å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658558605"/>
                  </a:ext>
                </a:extLst>
              </a:tr>
              <a:tr h="208280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% helix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A=25.2%, LT=38.2%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900628104"/>
                  </a:ext>
                </a:extLst>
              </a:tr>
              <a:tr h="189132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% sheet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A=12.9%, LT=22.9%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929318025"/>
                  </a:ext>
                </a:extLst>
              </a:tr>
              <a:tr h="216877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sidues structurally changed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9.1% (119 residues)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337092257"/>
                  </a:ext>
                </a:extLst>
              </a:tr>
              <a:tr h="268068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Nemar test for helices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Nemar’s X</a:t>
                      </a:r>
                      <a:r>
                        <a:rPr lang="en-US" sz="1200" baseline="300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=0.69, df = 1, p-value =0.4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51765313"/>
                  </a:ext>
                </a:extLst>
              </a:tr>
              <a:tr h="272366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Nemar test for strands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Nemar's X</a:t>
                      </a:r>
                      <a:r>
                        <a:rPr lang="en-US" sz="1200" baseline="300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=1, df = 1, p-value = 0.3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860041992"/>
                  </a:ext>
                </a:extLst>
              </a:tr>
              <a:tr h="253218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verage helix length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A=4.48 Å, LT=4.37 Å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009927532"/>
                  </a:ext>
                </a:extLst>
              </a:tr>
              <a:tr h="304409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ired t-test for differences in helix length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 = -0.11, df = 22, p-value =0.8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988636469"/>
                  </a:ext>
                </a:extLst>
              </a:tr>
              <a:tr h="285262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verage </a:t>
                      </a:r>
                      <a:r>
                        <a:rPr lang="el-GR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β</a:t>
                      </a: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strand length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A=1.2 Å, LT=1.48 Å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721450151"/>
                  </a:ext>
                </a:extLst>
              </a:tr>
              <a:tr h="266114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ired t-test for differences in strand length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 = -1.5, df = 43, p-value = 0.1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97398514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fferences in heme distances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ere are 16 </a:t>
                      </a:r>
                      <a:r>
                        <a:rPr lang="en-US" sz="12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emes</a:t>
                      </a:r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in LT and only 10 in PCA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297845352"/>
                  </a:ext>
                </a:extLst>
              </a:tr>
            </a:tbl>
          </a:graphicData>
        </a:graphic>
      </p:graphicFrame>
      <p:sp>
        <p:nvSpPr>
          <p:cNvPr id="16" name="TextBox 15">
            <a:extLst>
              <a:ext uri="{FF2B5EF4-FFF2-40B4-BE49-F238E27FC236}">
                <a16:creationId xmlns:a16="http://schemas.microsoft.com/office/drawing/2014/main" xmlns="" id="{4019C237-D111-60AC-0D6C-D4D91199E567}"/>
              </a:ext>
            </a:extLst>
          </p:cNvPr>
          <p:cNvSpPr txBox="1"/>
          <p:nvPr/>
        </p:nvSpPr>
        <p:spPr>
          <a:xfrm>
            <a:off x="635578" y="7575955"/>
            <a:ext cx="10920844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buNone/>
            </a:pPr>
            <a:r>
              <a:rPr lang="en-US" sz="1200" b="1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3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 (J) Tertiary structure predictions made for </a:t>
            </a:r>
            <a:r>
              <a:rPr lang="en-US" sz="12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OscJ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proteins using </a:t>
            </a:r>
            <a:r>
              <a:rPr lang="en-US" sz="12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alphafold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 The structures were visualized and </a:t>
            </a:r>
            <a:r>
              <a:rPr lang="en-US" sz="12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heme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positions were labeled in </a:t>
            </a:r>
            <a:r>
              <a:rPr lang="en-US" sz="12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ChimeraX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Heme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localizations in the individual proteins are highlighted in purple. For structural comparisons, the predicted structures were superimposed using Matchmaker and colored by the calculated per residue Cα-</a:t>
            </a:r>
            <a:r>
              <a:rPr lang="en-US" sz="1200" b="0" i="0" u="none" strike="noStrike" dirty="0" smtClean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RMSD measurement. 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Residues are colored on a continuous gradient: Blue indicates the highest similarity (RMSD </a:t>
            </a:r>
            <a:r>
              <a:rPr lang="en-US" sz="1200" b="0" i="0" u="sng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&lt; 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A), white indicates intermediate difference (RMSD ~ 1 A), and red indicates the largest structural difference (RSD </a:t>
            </a:r>
            <a:r>
              <a:rPr lang="en-US" sz="1200" b="0" i="0" u="sng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&gt;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2 A). Secondary structures predicted by </a:t>
            </a:r>
            <a:r>
              <a:rPr lang="en-US" sz="12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alphafold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were also analyzed in DSSP and statistics comparing DSSP results were done with the R-stats package. </a:t>
            </a:r>
          </a:p>
        </p:txBody>
      </p:sp>
    </p:spTree>
    <p:extLst>
      <p:ext uri="{BB962C8B-B14F-4D97-AF65-F5344CB8AC3E}">
        <p14:creationId xmlns:p14="http://schemas.microsoft.com/office/powerpoint/2010/main" val="3179911285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xmlns="" id="{33089F7E-7367-751B-7BEE-4F6D4D975D6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2529" y="459536"/>
            <a:ext cx="3379242" cy="296839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xmlns="" id="{15B0DBD2-95DC-0C2B-BA88-5E854C6A199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60229" y="406172"/>
            <a:ext cx="3304494" cy="296839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xmlns="" id="{62CA81C4-CB68-49B9-A7A2-481C35C1E1E0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43753" y="406172"/>
            <a:ext cx="3304494" cy="302176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xmlns="" id="{32C6937F-4F74-C8C6-0DE1-961F84F0F55C}"/>
              </a:ext>
            </a:extLst>
          </p:cNvPr>
          <p:cNvSpPr txBox="1"/>
          <p:nvPr/>
        </p:nvSpPr>
        <p:spPr>
          <a:xfrm>
            <a:off x="418572" y="3046352"/>
            <a:ext cx="12618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>
                <a:latin typeface="Times New Roman"/>
                <a:cs typeface="Times New Roman"/>
              </a:rPr>
              <a:t>OscK</a:t>
            </a:r>
            <a:r>
              <a:rPr lang="en-US" b="1" dirty="0">
                <a:latin typeface="Times New Roman"/>
                <a:cs typeface="Times New Roman"/>
              </a:rPr>
              <a:t> PC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xmlns="" id="{1074D1B0-D005-BC56-5814-CD268B6CCE46}"/>
              </a:ext>
            </a:extLst>
          </p:cNvPr>
          <p:cNvSpPr txBox="1"/>
          <p:nvPr/>
        </p:nvSpPr>
        <p:spPr>
          <a:xfrm>
            <a:off x="4459432" y="3040019"/>
            <a:ext cx="10763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>
                <a:latin typeface="Times New Roman"/>
                <a:cs typeface="Times New Roman"/>
              </a:rPr>
              <a:t>OscK</a:t>
            </a:r>
            <a:r>
              <a:rPr lang="en-US" b="1" dirty="0">
                <a:latin typeface="Times New Roman"/>
                <a:cs typeface="Times New Roman"/>
              </a:rPr>
              <a:t> LT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xmlns="" id="{B4AFBE28-1897-5B0F-9E04-314BE2C18ACE}"/>
              </a:ext>
            </a:extLst>
          </p:cNvPr>
          <p:cNvSpPr txBox="1"/>
          <p:nvPr/>
        </p:nvSpPr>
        <p:spPr>
          <a:xfrm>
            <a:off x="8360229" y="2989561"/>
            <a:ext cx="16148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>
                <a:latin typeface="Times New Roman"/>
                <a:cs typeface="Times New Roman"/>
              </a:rPr>
              <a:t>OscK</a:t>
            </a:r>
            <a:r>
              <a:rPr lang="en-US" b="1" dirty="0">
                <a:latin typeface="Times New Roman"/>
                <a:cs typeface="Times New Roman"/>
              </a:rPr>
              <a:t> PCA/LT</a:t>
            </a:r>
          </a:p>
        </p:txBody>
      </p:sp>
      <p:graphicFrame>
        <p:nvGraphicFramePr>
          <p:cNvPr id="13" name="Table 12">
            <a:extLst>
              <a:ext uri="{FF2B5EF4-FFF2-40B4-BE49-F238E27FC236}">
                <a16:creationId xmlns:a16="http://schemas.microsoft.com/office/drawing/2014/main" xmlns="" id="{C54FFDED-E46C-9BE8-4E02-6857983AAFC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96177005"/>
              </p:ext>
            </p:extLst>
          </p:nvPr>
        </p:nvGraphicFramePr>
        <p:xfrm>
          <a:off x="1273628" y="3652838"/>
          <a:ext cx="9249536" cy="3763107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3083198">
                  <a:extLst>
                    <a:ext uri="{9D8B030D-6E8A-4147-A177-3AD203B41FA5}">
                      <a16:colId xmlns:a16="http://schemas.microsoft.com/office/drawing/2014/main" xmlns="" val="1249526359"/>
                    </a:ext>
                  </a:extLst>
                </a:gridCol>
                <a:gridCol w="6166338">
                  <a:extLst>
                    <a:ext uri="{9D8B030D-6E8A-4147-A177-3AD203B41FA5}">
                      <a16:colId xmlns:a16="http://schemas.microsoft.com/office/drawing/2014/main" xmlns="" val="4151623715"/>
                    </a:ext>
                  </a:extLst>
                </a:gridCol>
              </a:tblGrid>
              <a:tr h="214532">
                <a:tc>
                  <a:txBody>
                    <a:bodyPr/>
                    <a:lstStyle/>
                    <a:p>
                      <a:r>
                        <a:rPr lang="en-US" sz="12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alysis of OscK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sults</a:t>
                      </a:r>
                      <a:endParaRPr lang="en-US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611683420"/>
                  </a:ext>
                </a:extLst>
              </a:tr>
              <a:tr h="289169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del confidence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A=99.6%, LT=99.6% confidently predicted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652401429"/>
                  </a:ext>
                </a:extLst>
              </a:tr>
              <a:tr h="270021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M-score results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MSD=0.26 Å, TM-score=0.99, MaxSub-score=0.99, GDT-TS-score=0.99, GDT-HA-score=0.99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60783566"/>
                  </a:ext>
                </a:extLst>
              </a:tr>
              <a:tr h="227428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imeraX Matchmaker RMSD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6 Å (across all 260 pairs), 0.26 Å (across 260 pruned pairs), 1.54% of protein deviates &gt;1Å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960398014"/>
                  </a:ext>
                </a:extLst>
              </a:tr>
              <a:tr h="325511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% helix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A=2.3%, LT=2.3%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15017517"/>
                  </a:ext>
                </a:extLst>
              </a:tr>
              <a:tr h="259471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% sheet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A=58.8%, LT=57.3%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668855736"/>
                  </a:ext>
                </a:extLst>
              </a:tr>
              <a:tr h="287215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sidues structurally changed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71% (6 residues)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20655481"/>
                  </a:ext>
                </a:extLst>
              </a:tr>
              <a:tr h="268068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Nemar test for helices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Nemar’s X</a:t>
                      </a:r>
                      <a:r>
                        <a:rPr lang="en-US" sz="1200" baseline="300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=1.8, df = 1, p-value =0.1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863399561"/>
                  </a:ext>
                </a:extLst>
              </a:tr>
              <a:tr h="295812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Nemar test for strands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Nemar's X</a:t>
                      </a:r>
                      <a:r>
                        <a:rPr lang="en-US" sz="1200" baseline="300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=2, df = 1, p-value = 0.1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791338622"/>
                  </a:ext>
                </a:extLst>
              </a:tr>
              <a:tr h="229772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verage helix length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A=3 Å, LT=3 Å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726892275"/>
                  </a:ext>
                </a:extLst>
              </a:tr>
              <a:tr h="257517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ired t-test for differences in helix length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 = 0, df = 1, p-value =1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9382470"/>
                  </a:ext>
                </a:extLst>
              </a:tr>
              <a:tr h="214923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verage </a:t>
                      </a:r>
                      <a:r>
                        <a:rPr lang="el-GR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β</a:t>
                      </a: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strand length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A=4.14 Å, LT=4.03 Å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37640779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ired t-test for differences in strand length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 = 2.09, </a:t>
                      </a:r>
                      <a:r>
                        <a:rPr lang="en-US" sz="12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f</a:t>
                      </a:r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= 36, p-value = 0.04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731288993"/>
                  </a:ext>
                </a:extLst>
              </a:tr>
            </a:tbl>
          </a:graphicData>
        </a:graphic>
      </p:graphicFrame>
      <p:sp>
        <p:nvSpPr>
          <p:cNvPr id="14" name="TextBox 13">
            <a:extLst>
              <a:ext uri="{FF2B5EF4-FFF2-40B4-BE49-F238E27FC236}">
                <a16:creationId xmlns:a16="http://schemas.microsoft.com/office/drawing/2014/main" xmlns="" id="{2760D75F-39A8-5222-D82B-F4098BD3C6C1}"/>
              </a:ext>
            </a:extLst>
          </p:cNvPr>
          <p:cNvSpPr txBox="1"/>
          <p:nvPr/>
        </p:nvSpPr>
        <p:spPr>
          <a:xfrm>
            <a:off x="635578" y="7575955"/>
            <a:ext cx="10920844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buNone/>
            </a:pPr>
            <a:r>
              <a:rPr lang="en-US" sz="1200" b="1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3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 (K) Tertiary structure predictions made for </a:t>
            </a:r>
            <a:r>
              <a:rPr lang="en-US" sz="12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Osc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proteins using </a:t>
            </a:r>
            <a:r>
              <a:rPr lang="en-US" sz="12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alphafold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 The structures were visualized and </a:t>
            </a:r>
            <a:r>
              <a:rPr lang="en-US" sz="12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heme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positions were labeled in </a:t>
            </a:r>
            <a:r>
              <a:rPr lang="en-US" sz="12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ChimeraX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b="0" i="0" u="none" strike="noStrike" dirty="0" smtClean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or 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tructural comparisons, the predicted structures were superimposed using Matchmaker and colored by the calculated per residue Cα-</a:t>
            </a:r>
            <a:r>
              <a:rPr lang="en-US" sz="1200" b="0" i="0" u="none" strike="noStrike" dirty="0" smtClean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RMSD measurement. 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Residues are colored on a continuous gradient: Blue indicates the highest similarity (RMSD </a:t>
            </a:r>
            <a:r>
              <a:rPr lang="en-US" sz="1200" b="0" i="0" u="sng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&lt; 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A), white indicates intermediate difference (RMSD ~ 1 A), and red indicates the largest structural difference (RSD </a:t>
            </a:r>
            <a:r>
              <a:rPr lang="en-US" sz="1200" b="0" i="0" u="sng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&gt;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2 A). Secondary structures predicted by </a:t>
            </a:r>
            <a:r>
              <a:rPr lang="en-US" sz="12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alphafold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were also analyzed in DSSP and statistics comparing DSSP results were done with the R-stats package. </a:t>
            </a:r>
          </a:p>
        </p:txBody>
      </p:sp>
    </p:spTree>
    <p:extLst>
      <p:ext uri="{BB962C8B-B14F-4D97-AF65-F5344CB8AC3E}">
        <p14:creationId xmlns:p14="http://schemas.microsoft.com/office/powerpoint/2010/main" val="363845126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xmlns="" id="{7C092497-0C45-7A43-B38B-9F8FCEDDBDF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8163" y="286160"/>
            <a:ext cx="3410708" cy="3180939"/>
          </a:xfrm>
          <a:prstGeom prst="rect">
            <a:avLst/>
          </a:prstGeom>
          <a:ln>
            <a:solidFill>
              <a:schemeClr val="tx1">
                <a:lumMod val="95000"/>
                <a:lumOff val="5000"/>
              </a:schemeClr>
            </a:solidFill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xmlns="" id="{5B7AF379-2D5A-72F3-B1F6-49E61EEBA4A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72449" y="240506"/>
            <a:ext cx="3410707" cy="3231474"/>
          </a:xfrm>
          <a:prstGeom prst="rect">
            <a:avLst/>
          </a:prstGeom>
          <a:ln>
            <a:solidFill>
              <a:schemeClr val="tx1">
                <a:lumMod val="95000"/>
                <a:lumOff val="5000"/>
              </a:schemeClr>
            </a:solidFill>
          </a:ln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xmlns="" id="{12381628-7DBF-EB7A-9E5E-3F6F6CFEB89D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81512" y="272694"/>
            <a:ext cx="3410708" cy="3195846"/>
          </a:xfrm>
          <a:prstGeom prst="rect">
            <a:avLst/>
          </a:prstGeom>
          <a:ln>
            <a:solidFill>
              <a:schemeClr val="tx1">
                <a:lumMod val="95000"/>
                <a:lumOff val="5000"/>
              </a:schemeClr>
            </a:solidFill>
          </a:ln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xmlns="" id="{3CA04546-3FF8-09BF-347A-DA907233014B}"/>
              </a:ext>
            </a:extLst>
          </p:cNvPr>
          <p:cNvSpPr txBox="1"/>
          <p:nvPr/>
        </p:nvSpPr>
        <p:spPr>
          <a:xfrm>
            <a:off x="552274" y="299994"/>
            <a:ext cx="12327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>
                <a:latin typeface="Times New Roman"/>
                <a:cs typeface="Times New Roman"/>
              </a:rPr>
              <a:t>OscB</a:t>
            </a:r>
            <a:r>
              <a:rPr lang="en-US" b="1" dirty="0">
                <a:latin typeface="Times New Roman"/>
                <a:cs typeface="Times New Roman"/>
              </a:rPr>
              <a:t> PC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xmlns="" id="{6E44E5F3-1A5B-CAF1-4A2D-E5BD69F5B1A5}"/>
              </a:ext>
            </a:extLst>
          </p:cNvPr>
          <p:cNvSpPr txBox="1"/>
          <p:nvPr/>
        </p:nvSpPr>
        <p:spPr>
          <a:xfrm>
            <a:off x="4501778" y="269019"/>
            <a:ext cx="10507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>
                <a:latin typeface="Times New Roman"/>
                <a:cs typeface="Times New Roman"/>
              </a:rPr>
              <a:t>OscB</a:t>
            </a:r>
            <a:r>
              <a:rPr lang="en-US" b="1" dirty="0">
                <a:latin typeface="Times New Roman"/>
                <a:cs typeface="Times New Roman"/>
              </a:rPr>
              <a:t> LT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xmlns="" id="{E6A56B67-658C-1014-352D-F5D8469DFD09}"/>
              </a:ext>
            </a:extLst>
          </p:cNvPr>
          <p:cNvSpPr txBox="1"/>
          <p:nvPr/>
        </p:nvSpPr>
        <p:spPr>
          <a:xfrm>
            <a:off x="8169636" y="269669"/>
            <a:ext cx="15892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>
                <a:latin typeface="Times New Roman"/>
                <a:cs typeface="Times New Roman"/>
              </a:rPr>
              <a:t>OscB</a:t>
            </a:r>
            <a:r>
              <a:rPr lang="en-US" b="1" dirty="0">
                <a:latin typeface="Times New Roman"/>
                <a:cs typeface="Times New Roman"/>
              </a:rPr>
              <a:t> PCA/LT</a:t>
            </a:r>
          </a:p>
        </p:txBody>
      </p:sp>
      <p:graphicFrame>
        <p:nvGraphicFramePr>
          <p:cNvPr id="13" name="Table 12">
            <a:extLst>
              <a:ext uri="{FF2B5EF4-FFF2-40B4-BE49-F238E27FC236}">
                <a16:creationId xmlns:a16="http://schemas.microsoft.com/office/drawing/2014/main" xmlns="" id="{E191306C-9EAB-0A52-FF20-6245E0E49E4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83681884"/>
              </p:ext>
            </p:extLst>
          </p:nvPr>
        </p:nvGraphicFramePr>
        <p:xfrm>
          <a:off x="1154518" y="3818438"/>
          <a:ext cx="9278098" cy="3709352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3064867">
                  <a:extLst>
                    <a:ext uri="{9D8B030D-6E8A-4147-A177-3AD203B41FA5}">
                      <a16:colId xmlns:a16="http://schemas.microsoft.com/office/drawing/2014/main" xmlns="" val="48685465"/>
                    </a:ext>
                  </a:extLst>
                </a:gridCol>
                <a:gridCol w="6213231">
                  <a:extLst>
                    <a:ext uri="{9D8B030D-6E8A-4147-A177-3AD203B41FA5}">
                      <a16:colId xmlns:a16="http://schemas.microsoft.com/office/drawing/2014/main" xmlns="" val="2303534596"/>
                    </a:ext>
                  </a:extLst>
                </a:gridCol>
              </a:tblGrid>
              <a:tr h="217304">
                <a:tc>
                  <a:txBody>
                    <a:bodyPr/>
                    <a:lstStyle/>
                    <a:p>
                      <a:r>
                        <a:rPr lang="en-US" sz="12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alysis of OscB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sults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300911427"/>
                  </a:ext>
                </a:extLst>
              </a:tr>
              <a:tr h="243522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del confidence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A=92.5%, LT=92.7% confidently predicted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790137510"/>
                  </a:ext>
                </a:extLst>
              </a:tr>
              <a:tr h="272732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M-score results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MSD=0.46 Å, TM-score=0.99, MaxSub-score=0.98, GDT-TS-score=0.99, GDT-HA-score=0.96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4225149769"/>
                  </a:ext>
                </a:extLst>
              </a:tr>
              <a:tr h="320992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imeraX Matchmaker RMSD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6 Å (across all 1017 pairs), 0.36 Å (across 1008 pruned pairs), 0.88% of protein deviates &gt;2Å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961268180"/>
                  </a:ext>
                </a:extLst>
              </a:tr>
              <a:tr h="274002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% helix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A=64.3%, LT=64.6%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213959695"/>
                  </a:ext>
                </a:extLst>
              </a:tr>
              <a:tr h="246062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% sheet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A=15.8%, LT=15.8%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595476525"/>
                  </a:ext>
                </a:extLst>
              </a:tr>
              <a:tr h="256222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sidues structurally changed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36% (24 residues)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517693107"/>
                  </a:ext>
                </a:extLst>
              </a:tr>
              <a:tr h="209232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Nemar test for helices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Nemar’s X</a:t>
                      </a:r>
                      <a:r>
                        <a:rPr lang="en-US" sz="1200" baseline="300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=1.8, df = 1, p-value =0.17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174306841"/>
                  </a:ext>
                </a:extLst>
              </a:tr>
              <a:tr h="257492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Nemar test for strands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Nemar's X</a:t>
                      </a:r>
                      <a:r>
                        <a:rPr lang="en-US" sz="1200" baseline="300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=2, df = 1, p-value = 0.15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982989159"/>
                  </a:ext>
                </a:extLst>
              </a:tr>
              <a:tr h="248602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verage helix length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A=17.2 Å, LT=17.8 Å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897665148"/>
                  </a:ext>
                </a:extLst>
              </a:tr>
              <a:tr h="201612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ired t-test for differences in helix length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 =-0.22, df = 36, p-value =0.8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885159953"/>
                  </a:ext>
                </a:extLst>
              </a:tr>
              <a:tr h="268922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verage </a:t>
                      </a:r>
                      <a:r>
                        <a:rPr lang="el-GR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β</a:t>
                      </a: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strand length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A=2.7 Å, LT=2.7 Å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41781922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ired t-test for differences in strand length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 = 0, df = 59, p-value = 1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590750249"/>
                  </a:ext>
                </a:extLst>
              </a:tr>
            </a:tbl>
          </a:graphicData>
        </a:graphic>
      </p:graphicFrame>
      <p:sp>
        <p:nvSpPr>
          <p:cNvPr id="14" name="TextBox 13">
            <a:extLst>
              <a:ext uri="{FF2B5EF4-FFF2-40B4-BE49-F238E27FC236}">
                <a16:creationId xmlns:a16="http://schemas.microsoft.com/office/drawing/2014/main" xmlns="" id="{D779FC0D-9C68-F217-70DD-0338C8038EFB}"/>
              </a:ext>
            </a:extLst>
          </p:cNvPr>
          <p:cNvSpPr txBox="1"/>
          <p:nvPr/>
        </p:nvSpPr>
        <p:spPr>
          <a:xfrm>
            <a:off x="388057" y="7822685"/>
            <a:ext cx="10920844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buNone/>
            </a:pPr>
            <a:r>
              <a:rPr lang="en-US" sz="1200" b="1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3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 (B) Tertiary structure predictions made for </a:t>
            </a:r>
            <a:r>
              <a:rPr lang="en-US" sz="12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OscB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proteins using </a:t>
            </a:r>
            <a:r>
              <a:rPr lang="en-US" sz="12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alphafold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 The structures were visualized and </a:t>
            </a:r>
            <a:r>
              <a:rPr lang="en-US" sz="12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heme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positions were labeled in </a:t>
            </a:r>
            <a:r>
              <a:rPr lang="en-US" sz="12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ChimeraX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b="0" i="0" u="none" strike="noStrike" dirty="0" smtClean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or 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tructural comparisons, the predicted structures were superimposed using Matchmaker and colored by the calculated per residue Cα-</a:t>
            </a:r>
            <a:r>
              <a:rPr lang="en-US" sz="1200" b="0" i="0" u="none" strike="noStrike" dirty="0" smtClean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RMSD measurement. 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Residues are colored on a continuous gradient: Blue indicates the highest similarity (RMSD </a:t>
            </a:r>
            <a:r>
              <a:rPr lang="en-US" sz="1200" b="0" i="0" u="sng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&lt; 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A), white indicates intermediate difference (RMSD ~ 1 A), and red indicates the largest structural difference (RSD </a:t>
            </a:r>
            <a:r>
              <a:rPr lang="en-US" sz="1200" b="0" i="0" u="sng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&gt;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2 A). Secondary structures predicted by </a:t>
            </a:r>
            <a:r>
              <a:rPr lang="en-US" sz="12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alphafold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were also analyzed in DSSP and statistics comparing DSSP results were done with the R-stats package. </a:t>
            </a:r>
          </a:p>
        </p:txBody>
      </p:sp>
    </p:spTree>
    <p:extLst>
      <p:ext uri="{BB962C8B-B14F-4D97-AF65-F5344CB8AC3E}">
        <p14:creationId xmlns:p14="http://schemas.microsoft.com/office/powerpoint/2010/main" val="206756468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xmlns="" id="{42011B00-E234-A6E2-2B1F-0DF924013DC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4768" y="209550"/>
            <a:ext cx="3695700" cy="2757488"/>
          </a:xfrm>
          <a:prstGeom prst="rect">
            <a:avLst/>
          </a:prstGeom>
          <a:ln>
            <a:solidFill>
              <a:schemeClr val="tx1">
                <a:lumMod val="95000"/>
                <a:lumOff val="5000"/>
              </a:schemeClr>
            </a:solidFill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xmlns="" id="{750D0169-FA32-63B1-8EF8-7DC85D912EB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2" y="209550"/>
            <a:ext cx="3695700" cy="2757488"/>
          </a:xfrm>
          <a:prstGeom prst="rect">
            <a:avLst/>
          </a:prstGeom>
          <a:ln>
            <a:solidFill>
              <a:schemeClr val="tx1">
                <a:lumMod val="95000"/>
                <a:lumOff val="5000"/>
              </a:schemeClr>
            </a:solidFill>
          </a:ln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xmlns="" id="{C04C3769-E8DA-A6E3-7C42-0C74F680AD7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91504" y="209551"/>
            <a:ext cx="3695700" cy="2757488"/>
          </a:xfrm>
          <a:prstGeom prst="rect">
            <a:avLst/>
          </a:prstGeom>
          <a:ln>
            <a:solidFill>
              <a:schemeClr val="tx1">
                <a:lumMod val="95000"/>
                <a:lumOff val="5000"/>
              </a:schemeClr>
            </a:solidFill>
          </a:ln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xmlns="" id="{36640EC8-E356-9C01-AB51-2A5981988FBF}"/>
              </a:ext>
            </a:extLst>
          </p:cNvPr>
          <p:cNvSpPr txBox="1"/>
          <p:nvPr/>
        </p:nvSpPr>
        <p:spPr>
          <a:xfrm>
            <a:off x="2803398" y="209550"/>
            <a:ext cx="12535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>
                <a:latin typeface="Times New Roman"/>
                <a:cs typeface="Times New Roman"/>
              </a:rPr>
              <a:t>OscC</a:t>
            </a:r>
            <a:r>
              <a:rPr lang="en-US" b="1" dirty="0">
                <a:latin typeface="Times New Roman"/>
                <a:cs typeface="Times New Roman"/>
              </a:rPr>
              <a:t> PC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xmlns="" id="{F381970B-7B5B-B3B7-9F65-821AD4D62B0A}"/>
              </a:ext>
            </a:extLst>
          </p:cNvPr>
          <p:cNvSpPr txBox="1"/>
          <p:nvPr/>
        </p:nvSpPr>
        <p:spPr>
          <a:xfrm>
            <a:off x="6875663" y="209550"/>
            <a:ext cx="10634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>
                <a:latin typeface="Times New Roman"/>
                <a:cs typeface="Times New Roman"/>
              </a:rPr>
              <a:t>OscC</a:t>
            </a:r>
            <a:r>
              <a:rPr lang="en-US" b="1" dirty="0">
                <a:latin typeface="Times New Roman"/>
                <a:cs typeface="Times New Roman"/>
              </a:rPr>
              <a:t> LT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xmlns="" id="{96EABEA8-9778-D622-DDE3-637CD627CB28}"/>
              </a:ext>
            </a:extLst>
          </p:cNvPr>
          <p:cNvSpPr txBox="1"/>
          <p:nvPr/>
        </p:nvSpPr>
        <p:spPr>
          <a:xfrm>
            <a:off x="10266486" y="209550"/>
            <a:ext cx="16020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>
                <a:latin typeface="Times New Roman"/>
                <a:cs typeface="Times New Roman"/>
              </a:rPr>
              <a:t>OscC</a:t>
            </a:r>
            <a:r>
              <a:rPr lang="en-US" b="1" dirty="0">
                <a:latin typeface="Times New Roman"/>
                <a:cs typeface="Times New Roman"/>
              </a:rPr>
              <a:t> PCA/LT</a:t>
            </a:r>
          </a:p>
        </p:txBody>
      </p:sp>
      <p:graphicFrame>
        <p:nvGraphicFramePr>
          <p:cNvPr id="13" name="Table 12">
            <a:extLst>
              <a:ext uri="{FF2B5EF4-FFF2-40B4-BE49-F238E27FC236}">
                <a16:creationId xmlns:a16="http://schemas.microsoft.com/office/drawing/2014/main" xmlns="" id="{C8B2E143-D1CF-6AC8-16B1-7B5189CAA5E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97006760"/>
              </p:ext>
            </p:extLst>
          </p:nvPr>
        </p:nvGraphicFramePr>
        <p:xfrm>
          <a:off x="367554" y="3424238"/>
          <a:ext cx="11405348" cy="3880051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3031742">
                  <a:extLst>
                    <a:ext uri="{9D8B030D-6E8A-4147-A177-3AD203B41FA5}">
                      <a16:colId xmlns:a16="http://schemas.microsoft.com/office/drawing/2014/main" xmlns="" val="2340427215"/>
                    </a:ext>
                  </a:extLst>
                </a:gridCol>
                <a:gridCol w="8373606">
                  <a:extLst>
                    <a:ext uri="{9D8B030D-6E8A-4147-A177-3AD203B41FA5}">
                      <a16:colId xmlns:a16="http://schemas.microsoft.com/office/drawing/2014/main" xmlns="" val="2408927111"/>
                    </a:ext>
                  </a:extLst>
                </a:gridCol>
              </a:tblGrid>
              <a:tr h="276615">
                <a:tc>
                  <a:txBody>
                    <a:bodyPr/>
                    <a:lstStyle/>
                    <a:p>
                      <a:r>
                        <a:rPr lang="en-US" sz="12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alysis of OscC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sults</a:t>
                      </a:r>
                      <a:endParaRPr lang="en-US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118530611"/>
                  </a:ext>
                </a:extLst>
              </a:tr>
              <a:tr h="274743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del confidence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A=96.1%, LT=95.4% confidently predicted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133835336"/>
                  </a:ext>
                </a:extLst>
              </a:tr>
              <a:tr h="222562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M-score results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MSD=1.3 Å, TM-score=0.98, MaxSub-score=0.95, GDT-TS-score=0.96, GDT-HA-score=0.93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198400853"/>
                  </a:ext>
                </a:extLst>
              </a:tr>
              <a:tr h="252775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imeraX Matchmaker RMSD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3 Å (across all 414 pairs), 0.39 Å (across 396 pruned pairs), 4.35% of protein deviates &gt;2Å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768405298"/>
                  </a:ext>
                </a:extLst>
              </a:tr>
              <a:tr h="266945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% helix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A=23.2%, LT=21.5%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412259890"/>
                  </a:ext>
                </a:extLst>
              </a:tr>
              <a:tr h="267257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% sheet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A=26.6%, LT=27.3%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60567859"/>
                  </a:ext>
                </a:extLst>
              </a:tr>
              <a:tr h="231385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sidues structurally changed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07% (21 residues)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505137205"/>
                  </a:ext>
                </a:extLst>
              </a:tr>
              <a:tr h="293682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Nemar test for helices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Nemar’s X</a:t>
                      </a:r>
                      <a:r>
                        <a:rPr lang="en-US" sz="1200" baseline="300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=6, df = 1, p-value =0.01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979906891"/>
                  </a:ext>
                </a:extLst>
              </a:tr>
              <a:tr h="291811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Nemar test for strands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Nemar's X</a:t>
                      </a:r>
                      <a:r>
                        <a:rPr lang="en-US" sz="1200" baseline="300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=0.6, df = 1, p-value = 0.44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576270424"/>
                  </a:ext>
                </a:extLst>
              </a:tr>
              <a:tr h="225771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verage helix length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A=4.17 Å, LT=4.24 Å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940714543"/>
                  </a:ext>
                </a:extLst>
              </a:tr>
              <a:tr h="239941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ired t-test for differences in helix length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 =-0.4, df = 74, p-value =0.7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629421096"/>
                  </a:ext>
                </a:extLst>
              </a:tr>
              <a:tr h="222027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verage </a:t>
                      </a:r>
                      <a:r>
                        <a:rPr lang="el-GR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β</a:t>
                      </a: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strand length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A=1.47 Å, LT=1.51 Å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2258536"/>
                  </a:ext>
                </a:extLst>
              </a:tr>
              <a:tr h="188072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ired t-test for differences in strand length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 = 0, df = 20, p-value = 1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42967492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fferences in heme distances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an difference = -0.53 </a:t>
                      </a:r>
                      <a:r>
                        <a:rPr lang="en-US" sz="12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Å</a:t>
                      </a:r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; t = -3.39, </a:t>
                      </a:r>
                      <a:r>
                        <a:rPr lang="en-US" sz="12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f</a:t>
                      </a:r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= 35, p-value = 0.002, 95% CI: -0.84 to 0.21; </a:t>
                      </a:r>
                      <a:r>
                        <a:rPr lang="en-US" sz="12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eme</a:t>
                      </a:r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6 is 1.55 </a:t>
                      </a:r>
                      <a:r>
                        <a:rPr lang="en-US" sz="12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Å</a:t>
                      </a:r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smaller in LT (p-value=0.02)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724527603"/>
                  </a:ext>
                </a:extLst>
              </a:tr>
            </a:tbl>
          </a:graphicData>
        </a:graphic>
      </p:graphicFrame>
      <p:sp>
        <p:nvSpPr>
          <p:cNvPr id="14" name="TextBox 13">
            <a:extLst>
              <a:ext uri="{FF2B5EF4-FFF2-40B4-BE49-F238E27FC236}">
                <a16:creationId xmlns:a16="http://schemas.microsoft.com/office/drawing/2014/main" xmlns="" id="{FA59FCF4-B0A6-7021-3A80-0EB1E7DBFB27}"/>
              </a:ext>
            </a:extLst>
          </p:cNvPr>
          <p:cNvSpPr txBox="1"/>
          <p:nvPr/>
        </p:nvSpPr>
        <p:spPr>
          <a:xfrm>
            <a:off x="364768" y="7494788"/>
            <a:ext cx="10920844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buNone/>
            </a:pPr>
            <a:r>
              <a:rPr lang="en-US" sz="1200" b="1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3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 (C) Tertiary structure predictions made for </a:t>
            </a:r>
            <a:r>
              <a:rPr lang="en-US" sz="12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Osc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proteins using </a:t>
            </a:r>
            <a:r>
              <a:rPr lang="en-US" sz="12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alphafold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 The structures were visualized and </a:t>
            </a:r>
            <a:r>
              <a:rPr lang="en-US" sz="12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heme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positions were labeled in </a:t>
            </a:r>
            <a:r>
              <a:rPr lang="en-US" sz="12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ChimeraX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Heme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localizations in the individual proteins are highlighted in purple. For structural comparisons, the predicted structures were superimposed using Matchmaker and colored by the calculated per residue Cα-</a:t>
            </a:r>
            <a:r>
              <a:rPr lang="en-US" sz="1200" b="0" i="0" u="none" strike="noStrike" dirty="0" smtClean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RMSD measurement. 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Residues are colored on a continuous gradient: Blue indicates the highest similarity (RMSD </a:t>
            </a:r>
            <a:r>
              <a:rPr lang="en-US" sz="1200" b="0" i="0" u="sng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&lt; 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A), white indicates intermediate difference (RMSD ~ 1 A), and red indicates the largest structural difference (RSD </a:t>
            </a:r>
            <a:r>
              <a:rPr lang="en-US" sz="1200" b="0" i="0" u="sng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&gt;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2 A). Secondary structures predicted by </a:t>
            </a:r>
            <a:r>
              <a:rPr lang="en-US" sz="12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alphafold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were also analyzed in DSSP and statistics comparing DSSP results were done with the R-stats package. </a:t>
            </a:r>
          </a:p>
        </p:txBody>
      </p:sp>
    </p:spTree>
    <p:extLst>
      <p:ext uri="{BB962C8B-B14F-4D97-AF65-F5344CB8AC3E}">
        <p14:creationId xmlns:p14="http://schemas.microsoft.com/office/powerpoint/2010/main" val="197333720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xmlns="" id="{A1AD71DB-37C9-A330-55AC-C81CF5FDFA6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900" y="117154"/>
            <a:ext cx="3566021" cy="2902678"/>
          </a:xfrm>
          <a:prstGeom prst="rect">
            <a:avLst/>
          </a:prstGeom>
          <a:ln>
            <a:solidFill>
              <a:schemeClr val="tx1">
                <a:lumMod val="95000"/>
                <a:lumOff val="5000"/>
              </a:schemeClr>
            </a:solidFill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xmlns="" id="{95A4D609-ACD3-6C0F-6E45-0FDE74ABC26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44927" y="117154"/>
            <a:ext cx="3566022" cy="2902678"/>
          </a:xfrm>
          <a:prstGeom prst="rect">
            <a:avLst/>
          </a:prstGeom>
          <a:ln>
            <a:solidFill>
              <a:schemeClr val="tx1">
                <a:lumMod val="95000"/>
                <a:lumOff val="5000"/>
              </a:schemeClr>
            </a:solidFill>
          </a:ln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xmlns="" id="{170E508A-AB0A-E1A0-0CB2-8BC62ECA9176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03978" y="117154"/>
            <a:ext cx="3566021" cy="2902678"/>
          </a:xfrm>
          <a:prstGeom prst="rect">
            <a:avLst/>
          </a:prstGeom>
          <a:ln>
            <a:solidFill>
              <a:schemeClr val="tx1">
                <a:lumMod val="95000"/>
                <a:lumOff val="5000"/>
              </a:schemeClr>
            </a:solidFill>
          </a:ln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xmlns="" id="{C0BEBE48-6147-8536-FFB7-57D86236863A}"/>
              </a:ext>
            </a:extLst>
          </p:cNvPr>
          <p:cNvSpPr txBox="1"/>
          <p:nvPr/>
        </p:nvSpPr>
        <p:spPr>
          <a:xfrm>
            <a:off x="2646057" y="2662821"/>
            <a:ext cx="12535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>
                <a:latin typeface="Times New Roman"/>
                <a:cs typeface="Times New Roman"/>
              </a:rPr>
              <a:t>OscD</a:t>
            </a:r>
            <a:r>
              <a:rPr lang="en-US" b="1" dirty="0">
                <a:latin typeface="Times New Roman"/>
                <a:cs typeface="Times New Roman"/>
              </a:rPr>
              <a:t> PC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xmlns="" id="{594D8548-412D-2896-83E7-160C348380F1}"/>
              </a:ext>
            </a:extLst>
          </p:cNvPr>
          <p:cNvSpPr txBox="1"/>
          <p:nvPr/>
        </p:nvSpPr>
        <p:spPr>
          <a:xfrm>
            <a:off x="6696871" y="2676932"/>
            <a:ext cx="10634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>
                <a:latin typeface="Times New Roman"/>
                <a:cs typeface="Times New Roman"/>
              </a:rPr>
              <a:t>OscD</a:t>
            </a:r>
            <a:r>
              <a:rPr lang="en-US" b="1" dirty="0">
                <a:latin typeface="Times New Roman"/>
                <a:cs typeface="Times New Roman"/>
              </a:rPr>
              <a:t> LT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xmlns="" id="{918C2F7D-B886-0A45-71EA-3B7A5B838325}"/>
              </a:ext>
            </a:extLst>
          </p:cNvPr>
          <p:cNvSpPr txBox="1"/>
          <p:nvPr/>
        </p:nvSpPr>
        <p:spPr>
          <a:xfrm>
            <a:off x="10104342" y="2676932"/>
            <a:ext cx="16020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>
                <a:latin typeface="Times New Roman"/>
                <a:cs typeface="Times New Roman"/>
              </a:rPr>
              <a:t>OscD</a:t>
            </a:r>
            <a:r>
              <a:rPr lang="en-US" b="1" dirty="0">
                <a:latin typeface="Times New Roman"/>
                <a:cs typeface="Times New Roman"/>
              </a:rPr>
              <a:t> PCA/LT</a:t>
            </a:r>
          </a:p>
        </p:txBody>
      </p:sp>
      <p:graphicFrame>
        <p:nvGraphicFramePr>
          <p:cNvPr id="13" name="Table 12">
            <a:extLst>
              <a:ext uri="{FF2B5EF4-FFF2-40B4-BE49-F238E27FC236}">
                <a16:creationId xmlns:a16="http://schemas.microsoft.com/office/drawing/2014/main" xmlns="" id="{78552BA4-154F-D9C0-6528-015043782F8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26357951"/>
              </p:ext>
            </p:extLst>
          </p:nvPr>
        </p:nvGraphicFramePr>
        <p:xfrm>
          <a:off x="1315327" y="3377536"/>
          <a:ext cx="9343321" cy="3681828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3059752">
                  <a:extLst>
                    <a:ext uri="{9D8B030D-6E8A-4147-A177-3AD203B41FA5}">
                      <a16:colId xmlns:a16="http://schemas.microsoft.com/office/drawing/2014/main" xmlns="" val="1471098284"/>
                    </a:ext>
                  </a:extLst>
                </a:gridCol>
                <a:gridCol w="6283569">
                  <a:extLst>
                    <a:ext uri="{9D8B030D-6E8A-4147-A177-3AD203B41FA5}">
                      <a16:colId xmlns:a16="http://schemas.microsoft.com/office/drawing/2014/main" xmlns="" val="941367702"/>
                    </a:ext>
                  </a:extLst>
                </a:gridCol>
              </a:tblGrid>
              <a:tr h="237978">
                <a:tc>
                  <a:txBody>
                    <a:bodyPr/>
                    <a:lstStyle/>
                    <a:p>
                      <a:r>
                        <a:rPr lang="en-US" sz="12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alysis of OscD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sults</a:t>
                      </a:r>
                      <a:endParaRPr lang="en-US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743862963"/>
                  </a:ext>
                </a:extLst>
              </a:tr>
              <a:tr h="265723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del confidence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A=0.5%, LT=0.5% confidently predicted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89207861"/>
                  </a:ext>
                </a:extLst>
              </a:tr>
              <a:tr h="293468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M-score results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MSD=52.1 Å, TM-score=0.11, MaxSub-score=0.04, GDT-TS-score=0.06, GDT-HA-score=0.04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987859889"/>
                  </a:ext>
                </a:extLst>
              </a:tr>
              <a:tr h="227428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imeraX Matchmaker RMSD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1.6 Å (across all 473 pairs), 1.03 Å (across 14 pruned pairs), 96.41% of protein deviates &gt;2Å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795515419"/>
                  </a:ext>
                </a:extLst>
              </a:tr>
              <a:tr h="208280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% helix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A=0%, LT=0%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43865664"/>
                  </a:ext>
                </a:extLst>
              </a:tr>
              <a:tr h="259471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% sheet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A=0%, LT=0%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358776939"/>
                  </a:ext>
                </a:extLst>
              </a:tr>
              <a:tr h="240323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sidues structurally changed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 (all coils)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018457047"/>
                  </a:ext>
                </a:extLst>
              </a:tr>
              <a:tr h="244622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Nemar test for helices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85636748"/>
                  </a:ext>
                </a:extLst>
              </a:tr>
              <a:tr h="272366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Nemar test for strands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985910685"/>
                  </a:ext>
                </a:extLst>
              </a:tr>
              <a:tr h="253218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verage helix length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4227799348"/>
                  </a:ext>
                </a:extLst>
              </a:tr>
              <a:tr h="257517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ired t-test for differences in helix length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123979151"/>
                  </a:ext>
                </a:extLst>
              </a:tr>
              <a:tr h="261815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verage </a:t>
                      </a:r>
                      <a:r>
                        <a:rPr lang="el-GR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β</a:t>
                      </a: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strand length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406593385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ired t-test for differences in strand length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150729384"/>
                  </a:ext>
                </a:extLst>
              </a:tr>
            </a:tbl>
          </a:graphicData>
        </a:graphic>
      </p:graphicFrame>
      <p:sp>
        <p:nvSpPr>
          <p:cNvPr id="14" name="TextBox 13">
            <a:extLst>
              <a:ext uri="{FF2B5EF4-FFF2-40B4-BE49-F238E27FC236}">
                <a16:creationId xmlns:a16="http://schemas.microsoft.com/office/drawing/2014/main" xmlns="" id="{3AA2706D-B761-9B11-4264-3381C576E8F0}"/>
              </a:ext>
            </a:extLst>
          </p:cNvPr>
          <p:cNvSpPr txBox="1"/>
          <p:nvPr/>
        </p:nvSpPr>
        <p:spPr>
          <a:xfrm>
            <a:off x="440673" y="7299080"/>
            <a:ext cx="10920844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buNone/>
            </a:pPr>
            <a:r>
              <a:rPr lang="en-US" sz="1200" b="1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3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 (D) Tertiary structure predictions made for </a:t>
            </a:r>
            <a:r>
              <a:rPr lang="en-US" sz="12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OscD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proteins using </a:t>
            </a:r>
            <a:r>
              <a:rPr lang="en-US" sz="12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alphafold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 The structures were visualized and </a:t>
            </a:r>
            <a:r>
              <a:rPr lang="en-US" sz="12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heme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positions were labeled in </a:t>
            </a:r>
            <a:r>
              <a:rPr lang="en-US" sz="12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ChimeraX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b="0" i="0" u="none" strike="noStrike" dirty="0" smtClean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or 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tructural comparisons, the predicted structures were superimposed using Matchmaker and colored by the calculated per residue Cα-</a:t>
            </a:r>
            <a:r>
              <a:rPr lang="en-US" sz="1200" b="0" i="0" u="none" strike="noStrike" dirty="0" smtClean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RMSD measurement. 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Residues are colored on a continuous gradient: Blue indicates the highest similarity (RMSD </a:t>
            </a:r>
            <a:r>
              <a:rPr lang="en-US" sz="1200" b="0" i="0" u="sng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&lt; 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A), white indicates intermediate difference (RMSD ~ 1 A), and red indicates the largest structural difference (RSD </a:t>
            </a:r>
            <a:r>
              <a:rPr lang="en-US" sz="1200" b="0" i="0" u="sng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&gt;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2 A). Secondary structures predicted by </a:t>
            </a:r>
            <a:r>
              <a:rPr lang="en-US" sz="12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alphafold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were also analyzed in DSSP and statistics comparing DSSP results were done with the R-stats package. </a:t>
            </a:r>
          </a:p>
        </p:txBody>
      </p:sp>
    </p:spTree>
    <p:extLst>
      <p:ext uri="{BB962C8B-B14F-4D97-AF65-F5344CB8AC3E}">
        <p14:creationId xmlns:p14="http://schemas.microsoft.com/office/powerpoint/2010/main" val="5267027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xmlns="" id="{9119F249-A5F2-715D-60E4-DEB8EFD93FF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6830" y="283918"/>
            <a:ext cx="3399692" cy="2868169"/>
          </a:xfrm>
          <a:prstGeom prst="rect">
            <a:avLst/>
          </a:prstGeom>
          <a:ln>
            <a:solidFill>
              <a:schemeClr val="tx1">
                <a:lumMod val="95000"/>
                <a:lumOff val="5000"/>
              </a:schemeClr>
            </a:solidFill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xmlns="" id="{DCC09847-7ED0-9D74-A7C3-ECAEE50C76E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60277" y="260472"/>
            <a:ext cx="3399691" cy="2868169"/>
          </a:xfrm>
          <a:prstGeom prst="rect">
            <a:avLst/>
          </a:prstGeom>
          <a:ln>
            <a:solidFill>
              <a:schemeClr val="tx1">
                <a:lumMod val="95000"/>
                <a:lumOff val="5000"/>
              </a:schemeClr>
            </a:solidFill>
          </a:ln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xmlns="" id="{91377A5A-C6BE-7699-9980-8DC13EEA965F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23383" y="260473"/>
            <a:ext cx="3399692" cy="2868169"/>
          </a:xfrm>
          <a:prstGeom prst="rect">
            <a:avLst/>
          </a:prstGeom>
          <a:ln>
            <a:solidFill>
              <a:schemeClr val="tx1">
                <a:lumMod val="95000"/>
                <a:lumOff val="5000"/>
              </a:schemeClr>
            </a:solidFill>
          </a:ln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xmlns="" id="{CD7EAB12-CDFD-78E7-3AAB-0709547861B5}"/>
              </a:ext>
            </a:extLst>
          </p:cNvPr>
          <p:cNvSpPr txBox="1"/>
          <p:nvPr/>
        </p:nvSpPr>
        <p:spPr>
          <a:xfrm>
            <a:off x="735321" y="2759309"/>
            <a:ext cx="1236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>
                <a:latin typeface="Times New Roman"/>
                <a:cs typeface="Times New Roman"/>
              </a:rPr>
              <a:t>OscE</a:t>
            </a:r>
            <a:r>
              <a:rPr lang="en-US" b="1" dirty="0">
                <a:latin typeface="Times New Roman"/>
                <a:cs typeface="Times New Roman"/>
              </a:rPr>
              <a:t> PC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xmlns="" id="{2DE77165-68F1-DFE1-07E7-C70A914666A0}"/>
              </a:ext>
            </a:extLst>
          </p:cNvPr>
          <p:cNvSpPr txBox="1"/>
          <p:nvPr/>
        </p:nvSpPr>
        <p:spPr>
          <a:xfrm>
            <a:off x="4572283" y="2751341"/>
            <a:ext cx="10507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>
                <a:latin typeface="Times New Roman"/>
                <a:cs typeface="Times New Roman"/>
              </a:rPr>
              <a:t>OscE</a:t>
            </a:r>
            <a:r>
              <a:rPr lang="en-US" b="1" dirty="0">
                <a:latin typeface="Times New Roman"/>
                <a:cs typeface="Times New Roman"/>
              </a:rPr>
              <a:t> LT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xmlns="" id="{5ACA912B-456C-A0C2-00FB-6C7D1D8E5E6F}"/>
              </a:ext>
            </a:extLst>
          </p:cNvPr>
          <p:cNvSpPr txBox="1"/>
          <p:nvPr/>
        </p:nvSpPr>
        <p:spPr>
          <a:xfrm>
            <a:off x="8332935" y="2765940"/>
            <a:ext cx="15892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>
                <a:latin typeface="Times New Roman"/>
                <a:cs typeface="Times New Roman"/>
              </a:rPr>
              <a:t>OscE</a:t>
            </a:r>
            <a:r>
              <a:rPr lang="en-US" b="1" dirty="0">
                <a:latin typeface="Times New Roman"/>
                <a:cs typeface="Times New Roman"/>
              </a:rPr>
              <a:t> PCA/LT</a:t>
            </a:r>
          </a:p>
        </p:txBody>
      </p:sp>
      <p:graphicFrame>
        <p:nvGraphicFramePr>
          <p:cNvPr id="13" name="Table 12">
            <a:extLst>
              <a:ext uri="{FF2B5EF4-FFF2-40B4-BE49-F238E27FC236}">
                <a16:creationId xmlns:a16="http://schemas.microsoft.com/office/drawing/2014/main" xmlns="" id="{ADAD441A-04DE-9A55-FDC4-2341C6F2987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48830102"/>
              </p:ext>
            </p:extLst>
          </p:nvPr>
        </p:nvGraphicFramePr>
        <p:xfrm>
          <a:off x="1469773" y="3348038"/>
          <a:ext cx="9252453" cy="3713871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3083198">
                  <a:extLst>
                    <a:ext uri="{9D8B030D-6E8A-4147-A177-3AD203B41FA5}">
                      <a16:colId xmlns:a16="http://schemas.microsoft.com/office/drawing/2014/main" xmlns="" val="4049757124"/>
                    </a:ext>
                  </a:extLst>
                </a:gridCol>
                <a:gridCol w="6169255">
                  <a:extLst>
                    <a:ext uri="{9D8B030D-6E8A-4147-A177-3AD203B41FA5}">
                      <a16:colId xmlns:a16="http://schemas.microsoft.com/office/drawing/2014/main" xmlns="" val="2211963246"/>
                    </a:ext>
                  </a:extLst>
                </a:gridCol>
              </a:tblGrid>
              <a:tr h="308317">
                <a:tc>
                  <a:txBody>
                    <a:bodyPr/>
                    <a:lstStyle/>
                    <a:p>
                      <a:r>
                        <a:rPr lang="en-US" sz="12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alysis of OscE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sults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159326413"/>
                  </a:ext>
                </a:extLst>
              </a:tr>
              <a:tr h="265723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del confidence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A=96.6%, LT=97.9% confidently predicted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13352026"/>
                  </a:ext>
                </a:extLst>
              </a:tr>
              <a:tr h="246575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M-score results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MSD=0.86 Å, TM-score=0.99, MaxSub-score=0.94, GDT-TS-score=0.95, GDT-HA-score=0.79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627593238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imeraX Matchmaker RMSD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6 Å (across all 701 pairs), 0.86 Å (across 701 pruned pairs), 20.11% of protein deviates &gt;1Å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50809871"/>
                  </a:ext>
                </a:extLst>
              </a:tr>
              <a:tr h="231726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% helix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A=75.7%, LT=75.7%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4258091665"/>
                  </a:ext>
                </a:extLst>
              </a:tr>
              <a:tr h="236025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% sheet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A=1%, LT=1%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292883949"/>
                  </a:ext>
                </a:extLst>
              </a:tr>
              <a:tr h="216877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sidues structurally changed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% (4 residues)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858666109"/>
                  </a:ext>
                </a:extLst>
              </a:tr>
              <a:tr h="291514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Nemar test for helices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Nemar’s X</a:t>
                      </a:r>
                      <a:r>
                        <a:rPr lang="en-US" sz="1200" baseline="300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=NaN, df = 1, p-value =NaN (no difference)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1219848"/>
                  </a:ext>
                </a:extLst>
              </a:tr>
              <a:tr h="225474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Nemar test for strands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Nemar's X</a:t>
                      </a:r>
                      <a:r>
                        <a:rPr lang="en-US" sz="1200" baseline="300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=0, df = 1, p-value = 1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982501443"/>
                  </a:ext>
                </a:extLst>
              </a:tr>
              <a:tr h="159434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verage helix length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A=3.5 Å, LT=3.5 Å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919585647"/>
                  </a:ext>
                </a:extLst>
              </a:tr>
              <a:tr h="234071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ired t-test for differences in helix length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 = NA, df = 1, p-value =NA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292458572"/>
                  </a:ext>
                </a:extLst>
              </a:tr>
              <a:tr h="261815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verage </a:t>
                      </a:r>
                      <a:r>
                        <a:rPr lang="el-GR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β</a:t>
                      </a: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strand length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A=10.62 Å, LT=10.21 Å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60342666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ired t-test for differences in strand length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 = 0.6, df = 49, p-value = 0.5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163638167"/>
                  </a:ext>
                </a:extLst>
              </a:tr>
            </a:tbl>
          </a:graphicData>
        </a:graphic>
      </p:graphicFrame>
      <p:sp>
        <p:nvSpPr>
          <p:cNvPr id="14" name="TextBox 13">
            <a:extLst>
              <a:ext uri="{FF2B5EF4-FFF2-40B4-BE49-F238E27FC236}">
                <a16:creationId xmlns:a16="http://schemas.microsoft.com/office/drawing/2014/main" xmlns="" id="{D70B46E7-6D14-C2FA-4519-CAEDAC8F47E9}"/>
              </a:ext>
            </a:extLst>
          </p:cNvPr>
          <p:cNvSpPr txBox="1"/>
          <p:nvPr/>
        </p:nvSpPr>
        <p:spPr>
          <a:xfrm>
            <a:off x="440673" y="7299080"/>
            <a:ext cx="10920844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buNone/>
            </a:pPr>
            <a:r>
              <a:rPr lang="en-US" sz="1200" b="1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3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 (E) Tertiary structure predictions made for </a:t>
            </a:r>
            <a:r>
              <a:rPr lang="en-US" sz="12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Osc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proteins using </a:t>
            </a:r>
            <a:r>
              <a:rPr lang="en-US" sz="12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alphafold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 The structures were visualized and </a:t>
            </a:r>
            <a:r>
              <a:rPr lang="en-US" sz="12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heme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positions were labeled in </a:t>
            </a:r>
            <a:r>
              <a:rPr lang="en-US" sz="12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ChimeraX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b="0" i="0" u="none" strike="noStrike" dirty="0" smtClean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or 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tructural comparisons, the predicted structures were superimposed using Matchmaker and colored by the calculated per residue Cα-</a:t>
            </a:r>
            <a:r>
              <a:rPr lang="en-US" sz="1200" b="0" i="0" u="none" strike="noStrike" dirty="0" smtClean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RMSD measurement. 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Residues are colored on a continuous gradient: Blue indicates the highest similarity (RMSD </a:t>
            </a:r>
            <a:r>
              <a:rPr lang="en-US" sz="1200" b="0" i="0" u="sng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&lt; 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A), white indicates intermediate difference (RMSD ~ 1 A), and red indicates the largest structural difference (RSD </a:t>
            </a:r>
            <a:r>
              <a:rPr lang="en-US" sz="1200" b="0" i="0" u="sng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&gt;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2 A). Secondary structures predicted by </a:t>
            </a:r>
            <a:r>
              <a:rPr lang="en-US" sz="12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alphafold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were also analyzed in DSSP and statistics comparing DSSP results were done with the R-stats package. </a:t>
            </a:r>
          </a:p>
        </p:txBody>
      </p:sp>
    </p:spTree>
    <p:extLst>
      <p:ext uri="{BB962C8B-B14F-4D97-AF65-F5344CB8AC3E}">
        <p14:creationId xmlns:p14="http://schemas.microsoft.com/office/powerpoint/2010/main" val="374058562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xmlns="" id="{72AFF809-ACC1-CE0B-0AA5-0F9BB84FFAD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7563" y="225371"/>
            <a:ext cx="3845174" cy="2799428"/>
          </a:xfrm>
          <a:prstGeom prst="rect">
            <a:avLst/>
          </a:prstGeom>
          <a:ln>
            <a:solidFill>
              <a:schemeClr val="tx1">
                <a:lumMod val="95000"/>
                <a:lumOff val="5000"/>
              </a:schemeClr>
            </a:solidFill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xmlns="" id="{0AD82611-0C17-D2F9-6E14-7144DFC66CE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84921" y="195875"/>
            <a:ext cx="3845175" cy="2828924"/>
          </a:xfrm>
          <a:prstGeom prst="rect">
            <a:avLst/>
          </a:prstGeom>
          <a:ln>
            <a:solidFill>
              <a:schemeClr val="tx1">
                <a:lumMod val="95000"/>
                <a:lumOff val="5000"/>
              </a:schemeClr>
            </a:solidFill>
          </a:ln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xmlns="" id="{690D259F-8C81-DD38-1C04-402FE56D8361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91164" y="195875"/>
            <a:ext cx="3836291" cy="2799429"/>
          </a:xfrm>
          <a:prstGeom prst="rect">
            <a:avLst/>
          </a:prstGeom>
          <a:ln>
            <a:solidFill>
              <a:schemeClr val="tx1">
                <a:lumMod val="95000"/>
                <a:lumOff val="5000"/>
              </a:schemeClr>
            </a:solidFill>
          </a:ln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xmlns="" id="{95712133-9EF3-D15E-8C12-E816D0A7A07E}"/>
              </a:ext>
            </a:extLst>
          </p:cNvPr>
          <p:cNvSpPr txBox="1"/>
          <p:nvPr/>
        </p:nvSpPr>
        <p:spPr>
          <a:xfrm>
            <a:off x="2695426" y="225371"/>
            <a:ext cx="12134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>
                <a:latin typeface="Times New Roman"/>
                <a:cs typeface="Times New Roman"/>
              </a:rPr>
              <a:t>OscF</a:t>
            </a:r>
            <a:r>
              <a:rPr lang="en-US" b="1" dirty="0">
                <a:latin typeface="Times New Roman"/>
                <a:cs typeface="Times New Roman"/>
              </a:rPr>
              <a:t> PC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xmlns="" id="{B3064E58-67F4-379B-2873-CCE5E42A27D6}"/>
              </a:ext>
            </a:extLst>
          </p:cNvPr>
          <p:cNvSpPr txBox="1"/>
          <p:nvPr/>
        </p:nvSpPr>
        <p:spPr>
          <a:xfrm>
            <a:off x="6868821" y="199778"/>
            <a:ext cx="10292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>
                <a:latin typeface="Times New Roman"/>
                <a:cs typeface="Times New Roman"/>
              </a:rPr>
              <a:t>OscF</a:t>
            </a:r>
            <a:r>
              <a:rPr lang="en-US" b="1" dirty="0">
                <a:latin typeface="Times New Roman"/>
                <a:cs typeface="Times New Roman"/>
              </a:rPr>
              <a:t> LT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xmlns="" id="{292FC76D-8F7A-7B5A-48D3-D3DD1049693A}"/>
              </a:ext>
            </a:extLst>
          </p:cNvPr>
          <p:cNvSpPr txBox="1"/>
          <p:nvPr/>
        </p:nvSpPr>
        <p:spPr>
          <a:xfrm>
            <a:off x="10332700" y="199778"/>
            <a:ext cx="15677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>
                <a:latin typeface="Times New Roman"/>
                <a:cs typeface="Times New Roman"/>
              </a:rPr>
              <a:t>OscF</a:t>
            </a:r>
            <a:r>
              <a:rPr lang="en-US" b="1" dirty="0">
                <a:latin typeface="Times New Roman"/>
                <a:cs typeface="Times New Roman"/>
              </a:rPr>
              <a:t> PCA/LT</a:t>
            </a:r>
          </a:p>
        </p:txBody>
      </p:sp>
      <p:graphicFrame>
        <p:nvGraphicFramePr>
          <p:cNvPr id="13" name="Table 12">
            <a:extLst>
              <a:ext uri="{FF2B5EF4-FFF2-40B4-BE49-F238E27FC236}">
                <a16:creationId xmlns:a16="http://schemas.microsoft.com/office/drawing/2014/main" xmlns="" id="{B5CF787D-0147-488E-2E8C-80ED1D0FE17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26908594"/>
              </p:ext>
            </p:extLst>
          </p:nvPr>
        </p:nvGraphicFramePr>
        <p:xfrm>
          <a:off x="1470140" y="3264911"/>
          <a:ext cx="9251720" cy="3724813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3036306">
                  <a:extLst>
                    <a:ext uri="{9D8B030D-6E8A-4147-A177-3AD203B41FA5}">
                      <a16:colId xmlns:a16="http://schemas.microsoft.com/office/drawing/2014/main" xmlns="" val="1557702554"/>
                    </a:ext>
                  </a:extLst>
                </a:gridCol>
                <a:gridCol w="6215414">
                  <a:extLst>
                    <a:ext uri="{9D8B030D-6E8A-4147-A177-3AD203B41FA5}">
                      <a16:colId xmlns:a16="http://schemas.microsoft.com/office/drawing/2014/main" xmlns="" val="2407619358"/>
                    </a:ext>
                  </a:extLst>
                </a:gridCol>
              </a:tblGrid>
              <a:tr h="214532">
                <a:tc>
                  <a:txBody>
                    <a:bodyPr/>
                    <a:lstStyle/>
                    <a:p>
                      <a:r>
                        <a:rPr lang="en-US" sz="12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alysis of OscF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sults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087569238"/>
                  </a:ext>
                </a:extLst>
              </a:tr>
              <a:tr h="242277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del confidence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A=91.7%, LT=93.5% confidently predicted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261741181"/>
                  </a:ext>
                </a:extLst>
              </a:tr>
              <a:tr h="223129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M-score results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MSD=0.18 Å, TM-score=0.99, MaxSub-score=0.99, GDT-TS-score=0.99, GDT-HA-score=0.99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4187465092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imeraX Matchmaker RMSD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8 Å (across all 169 pairs), 0.18 Å (across 169 pruned pairs), 1.78% of protein deviates &gt;0.5Å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461713725"/>
                  </a:ext>
                </a:extLst>
              </a:tr>
              <a:tr h="278619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% helix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A=37.3%, LT=37.3%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755744589"/>
                  </a:ext>
                </a:extLst>
              </a:tr>
              <a:tr h="189132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% sheet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A=37.9%, LT=37.9%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421624316"/>
                  </a:ext>
                </a:extLst>
              </a:tr>
              <a:tr h="216877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sidues structurally changed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78% (3 residues)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340017627"/>
                  </a:ext>
                </a:extLst>
              </a:tr>
              <a:tr h="244622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Nemar test for helices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Nemar’s X</a:t>
                      </a:r>
                      <a:r>
                        <a:rPr lang="en-US" sz="1200" baseline="300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=0, df = 1, p-value =1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731950181"/>
                  </a:ext>
                </a:extLst>
              </a:tr>
              <a:tr h="155136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Nemar test for strands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Nemar's X</a:t>
                      </a:r>
                      <a:r>
                        <a:rPr lang="en-US" sz="1200" baseline="300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=0, df = 1, p-value = 1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149177576"/>
                  </a:ext>
                </a:extLst>
              </a:tr>
              <a:tr h="206326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verage helix length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A=10.5 Å, LT=10.5 Å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215970581"/>
                  </a:ext>
                </a:extLst>
              </a:tr>
              <a:tr h="210625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ired t-test for differences in helix length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 = 0, df = 1, p-value =1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728116898"/>
                  </a:ext>
                </a:extLst>
              </a:tr>
              <a:tr h="332154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verage </a:t>
                      </a:r>
                      <a:r>
                        <a:rPr lang="el-GR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β</a:t>
                      </a: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strand length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A=3.37 Å, LT=3.56 Å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72065454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ired t-test for differences in strand length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 = -1, df = 17, p-value = 0.3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587596949"/>
                  </a:ext>
                </a:extLst>
              </a:tr>
            </a:tbl>
          </a:graphicData>
        </a:graphic>
      </p:graphicFrame>
      <p:sp>
        <p:nvSpPr>
          <p:cNvPr id="14" name="TextBox 13">
            <a:extLst>
              <a:ext uri="{FF2B5EF4-FFF2-40B4-BE49-F238E27FC236}">
                <a16:creationId xmlns:a16="http://schemas.microsoft.com/office/drawing/2014/main" xmlns="" id="{F927133D-2569-F4C3-B1B5-573974483286}"/>
              </a:ext>
            </a:extLst>
          </p:cNvPr>
          <p:cNvSpPr txBox="1"/>
          <p:nvPr/>
        </p:nvSpPr>
        <p:spPr>
          <a:xfrm>
            <a:off x="440673" y="7299080"/>
            <a:ext cx="10920844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buNone/>
            </a:pPr>
            <a:r>
              <a:rPr lang="en-US" sz="1200" b="1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3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 (F) Tertiary structure predictions made for </a:t>
            </a:r>
            <a:r>
              <a:rPr lang="en-US" sz="12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OscF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proteins using </a:t>
            </a:r>
            <a:r>
              <a:rPr lang="en-US" sz="12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alphafold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 The structures were visualized and </a:t>
            </a:r>
            <a:r>
              <a:rPr lang="en-US" sz="12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heme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positions were labeled in </a:t>
            </a:r>
            <a:r>
              <a:rPr lang="en-US" sz="12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ChimeraX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Heme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localizations in the individual proteins are highlighted in purple. For structural comparisons, the predicted structures were superimposed using Matchmaker and colored by the calculated per residue Cα-</a:t>
            </a:r>
            <a:r>
              <a:rPr lang="en-US" sz="1200" b="0" i="0" u="none" strike="noStrike" dirty="0" smtClean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RMSD measurement. 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Residues are colored on a continuous gradient: Blue indicates the highest similarity (RMSD </a:t>
            </a:r>
            <a:r>
              <a:rPr lang="en-US" sz="1200" b="0" i="0" u="sng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&lt; 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A), white indicates intermediate difference (RMSD ~ 1 A), and red indicates the largest structural difference (RSD </a:t>
            </a:r>
            <a:r>
              <a:rPr lang="en-US" sz="1200" b="0" i="0" u="sng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&gt;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2 A). Secondary structures predicted by </a:t>
            </a:r>
            <a:r>
              <a:rPr lang="en-US" sz="12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alphafold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were also analyzed in DSSP and statistics comparing DSSP results were done with the R-stats package. </a:t>
            </a:r>
          </a:p>
        </p:txBody>
      </p:sp>
    </p:spTree>
    <p:extLst>
      <p:ext uri="{BB962C8B-B14F-4D97-AF65-F5344CB8AC3E}">
        <p14:creationId xmlns:p14="http://schemas.microsoft.com/office/powerpoint/2010/main" val="245585703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xmlns="" id="{E4E6BC70-BCB5-9F20-51C3-9B8D1457FA8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3542" y="131796"/>
            <a:ext cx="3451858" cy="2814386"/>
          </a:xfrm>
          <a:prstGeom prst="rect">
            <a:avLst/>
          </a:prstGeom>
          <a:ln>
            <a:solidFill>
              <a:schemeClr val="tx1">
                <a:lumMod val="95000"/>
                <a:lumOff val="5000"/>
              </a:schemeClr>
            </a:solidFill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xmlns="" id="{28065578-4F6C-D7B2-8F3A-7DE368D04E4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534399" y="187643"/>
            <a:ext cx="3451861" cy="2814386"/>
          </a:xfrm>
          <a:prstGeom prst="rect">
            <a:avLst/>
          </a:prstGeom>
          <a:ln>
            <a:solidFill>
              <a:schemeClr val="tx1">
                <a:lumMod val="95000"/>
                <a:lumOff val="5000"/>
              </a:schemeClr>
            </a:solidFill>
          </a:ln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xmlns="" id="{3B62D786-AE78-37E6-117D-3334714EF74E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10098" y="187643"/>
            <a:ext cx="3451862" cy="2814386"/>
          </a:xfrm>
          <a:prstGeom prst="rect">
            <a:avLst/>
          </a:prstGeom>
          <a:ln>
            <a:solidFill>
              <a:schemeClr val="tx1">
                <a:lumMod val="95000"/>
                <a:lumOff val="5000"/>
              </a:schemeClr>
            </a:solidFill>
          </a:ln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xmlns="" id="{1AA51873-ADD6-B6A2-5A8E-7C9A2E9B5615}"/>
              </a:ext>
            </a:extLst>
          </p:cNvPr>
          <p:cNvSpPr txBox="1"/>
          <p:nvPr/>
        </p:nvSpPr>
        <p:spPr>
          <a:xfrm>
            <a:off x="2759593" y="150671"/>
            <a:ext cx="12551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>
                <a:latin typeface="Times New Roman"/>
                <a:cs typeface="Times New Roman"/>
              </a:rPr>
              <a:t>OscG</a:t>
            </a:r>
            <a:r>
              <a:rPr lang="en-US" b="1" dirty="0">
                <a:latin typeface="Times New Roman"/>
                <a:cs typeface="Times New Roman"/>
              </a:rPr>
              <a:t> PC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xmlns="" id="{D58D2251-F19C-84C6-C539-7644CEF03CA0}"/>
              </a:ext>
            </a:extLst>
          </p:cNvPr>
          <p:cNvSpPr txBox="1"/>
          <p:nvPr/>
        </p:nvSpPr>
        <p:spPr>
          <a:xfrm>
            <a:off x="6986574" y="178893"/>
            <a:ext cx="10763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>
                <a:latin typeface="Times New Roman"/>
                <a:cs typeface="Times New Roman"/>
              </a:rPr>
              <a:t>OscG</a:t>
            </a:r>
            <a:r>
              <a:rPr lang="en-US" b="1" dirty="0">
                <a:latin typeface="Times New Roman"/>
                <a:cs typeface="Times New Roman"/>
              </a:rPr>
              <a:t> LT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xmlns="" id="{865E1A26-3EAC-D24D-2BA2-AF110BEA549C}"/>
              </a:ext>
            </a:extLst>
          </p:cNvPr>
          <p:cNvSpPr txBox="1"/>
          <p:nvPr/>
        </p:nvSpPr>
        <p:spPr>
          <a:xfrm>
            <a:off x="10349172" y="189428"/>
            <a:ext cx="16148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>
                <a:latin typeface="Times New Roman"/>
                <a:cs typeface="Times New Roman"/>
              </a:rPr>
              <a:t>OscG</a:t>
            </a:r>
            <a:r>
              <a:rPr lang="en-US" b="1" dirty="0">
                <a:latin typeface="Times New Roman"/>
                <a:cs typeface="Times New Roman"/>
              </a:rPr>
              <a:t> PCA/LT</a:t>
            </a:r>
          </a:p>
        </p:txBody>
      </p:sp>
      <p:graphicFrame>
        <p:nvGraphicFramePr>
          <p:cNvPr id="13" name="Table 12">
            <a:extLst>
              <a:ext uri="{FF2B5EF4-FFF2-40B4-BE49-F238E27FC236}">
                <a16:creationId xmlns:a16="http://schemas.microsoft.com/office/drawing/2014/main" xmlns="" id="{867042AF-C894-C44F-6AA2-CF128946B20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41488591"/>
              </p:ext>
            </p:extLst>
          </p:nvPr>
        </p:nvGraphicFramePr>
        <p:xfrm>
          <a:off x="1504935" y="3319214"/>
          <a:ext cx="9182129" cy="366268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3086129">
                  <a:extLst>
                    <a:ext uri="{9D8B030D-6E8A-4147-A177-3AD203B41FA5}">
                      <a16:colId xmlns:a16="http://schemas.microsoft.com/office/drawing/2014/main" xmlns="" val="3245028548"/>
                    </a:ext>
                  </a:extLst>
                </a:gridCol>
                <a:gridCol w="6096000">
                  <a:extLst>
                    <a:ext uri="{9D8B030D-6E8A-4147-A177-3AD203B41FA5}">
                      <a16:colId xmlns:a16="http://schemas.microsoft.com/office/drawing/2014/main" xmlns="" val="799410072"/>
                    </a:ext>
                  </a:extLst>
                </a:gridCol>
              </a:tblGrid>
              <a:tr h="195482">
                <a:tc>
                  <a:txBody>
                    <a:bodyPr/>
                    <a:lstStyle/>
                    <a:p>
                      <a:r>
                        <a:rPr lang="en-US" sz="12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alysis of OscG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sults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28448022"/>
                  </a:ext>
                </a:extLst>
              </a:tr>
              <a:tr h="223227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del confidence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A=89.6%, LT=90.7% confidently predicted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961090895"/>
                  </a:ext>
                </a:extLst>
              </a:tr>
              <a:tr h="227525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M-score results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MSD=5.3 Å, TM-score=0.97, MaxSub-score=0.95, GDT-TS-score=0.96, GDT-HA-score=0.94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992588915"/>
                  </a:ext>
                </a:extLst>
              </a:tr>
              <a:tr h="255270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imeraX Matchmaker RMSD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6 Å (across all 367 pairs), 0.28 Å (across 328 pruned pairs), 3.81% of protein deviates &gt;2Å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248302172"/>
                  </a:ext>
                </a:extLst>
              </a:tr>
              <a:tr h="259568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% helix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A=34.9%, LT=34.9%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696510542"/>
                  </a:ext>
                </a:extLst>
              </a:tr>
              <a:tr h="240421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% sheet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A=30.5%, LT=29.7%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050095746"/>
                  </a:ext>
                </a:extLst>
              </a:tr>
              <a:tr h="197827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sidues structurally changed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91% (7 residues)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596510308"/>
                  </a:ext>
                </a:extLst>
              </a:tr>
              <a:tr h="272464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Nemar test for helices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Nemar’s X</a:t>
                      </a:r>
                      <a:r>
                        <a:rPr lang="en-US" sz="1200" baseline="300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=NaN, df = 1, p-value =NA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238134018"/>
                  </a:ext>
                </a:extLst>
              </a:tr>
              <a:tr h="253316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Nemar test for strands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Nemar's X</a:t>
                      </a:r>
                      <a:r>
                        <a:rPr lang="en-US" sz="1200" baseline="300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=1.3, df = 1, p-value = 0.2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108711854"/>
                  </a:ext>
                </a:extLst>
              </a:tr>
              <a:tr h="234168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verage helix length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A=10.7 Å, LT=10.7 Å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622877351"/>
                  </a:ext>
                </a:extLst>
              </a:tr>
              <a:tr h="215021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ired t-test for differences in helix length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 = NaN, df = 1, p-value =NA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680633277"/>
                  </a:ext>
                </a:extLst>
              </a:tr>
              <a:tr h="195873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verage </a:t>
                      </a:r>
                      <a:r>
                        <a:rPr lang="el-GR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β</a:t>
                      </a: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strand length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A=3.2 Å, LT=3.21 Å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30123941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ired t-test for differences in strand length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 = 0.1, df = 33, p-value = 0.9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90442842"/>
                  </a:ext>
                </a:extLst>
              </a:tr>
            </a:tbl>
          </a:graphicData>
        </a:graphic>
      </p:graphicFrame>
      <p:sp>
        <p:nvSpPr>
          <p:cNvPr id="14" name="TextBox 13">
            <a:extLst>
              <a:ext uri="{FF2B5EF4-FFF2-40B4-BE49-F238E27FC236}">
                <a16:creationId xmlns:a16="http://schemas.microsoft.com/office/drawing/2014/main" xmlns="" id="{884A6FE2-EB9A-874C-8FF4-5675A483DABE}"/>
              </a:ext>
            </a:extLst>
          </p:cNvPr>
          <p:cNvSpPr txBox="1"/>
          <p:nvPr/>
        </p:nvSpPr>
        <p:spPr>
          <a:xfrm>
            <a:off x="440673" y="7299080"/>
            <a:ext cx="10920844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buNone/>
            </a:pPr>
            <a:r>
              <a:rPr lang="en-US" sz="1200" b="1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3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 (G) Tertiary structure predictions made for </a:t>
            </a:r>
            <a:r>
              <a:rPr lang="en-US" sz="12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Osc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proteins using </a:t>
            </a:r>
            <a:r>
              <a:rPr lang="en-US" sz="12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alphafold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 The structures were visualized and </a:t>
            </a:r>
            <a:r>
              <a:rPr lang="en-US" sz="12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heme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positions were labeled in </a:t>
            </a:r>
            <a:r>
              <a:rPr lang="en-US" sz="12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ChimeraX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b="0" i="0" u="none" strike="noStrike" dirty="0" smtClean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or 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tructural comparisons, the predicted structures were superimposed using Matchmaker and colored by the calculated per residue Cα-</a:t>
            </a:r>
            <a:r>
              <a:rPr lang="en-US" sz="1200" b="0" i="0" u="none" strike="noStrike" dirty="0" smtClean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RMSD measurement. 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Residues are colored on a continuous gradient: Blue indicates the highest similarity (RMSD </a:t>
            </a:r>
            <a:r>
              <a:rPr lang="en-US" sz="1200" b="0" i="0" u="sng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&lt; 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A), white indicates intermediate difference (RMSD ~ 1 A), and red indicates the largest structural difference (RSD </a:t>
            </a:r>
            <a:r>
              <a:rPr lang="en-US" sz="1200" b="0" i="0" u="sng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&gt;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2 A). Secondary structures predicted by </a:t>
            </a:r>
            <a:r>
              <a:rPr lang="en-US" sz="12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alphafold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were also analyzed in DSSP and statistics comparing DSSP results were done with the R-stats package. </a:t>
            </a:r>
          </a:p>
        </p:txBody>
      </p:sp>
    </p:spTree>
    <p:extLst>
      <p:ext uri="{BB962C8B-B14F-4D97-AF65-F5344CB8AC3E}">
        <p14:creationId xmlns:p14="http://schemas.microsoft.com/office/powerpoint/2010/main" val="21172373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xmlns="" id="{7C6C843D-CB75-6C20-81A1-F9399512410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0587" y="222340"/>
            <a:ext cx="3082833" cy="3181506"/>
          </a:xfrm>
          <a:prstGeom prst="rect">
            <a:avLst/>
          </a:prstGeom>
          <a:ln>
            <a:solidFill>
              <a:schemeClr val="tx1">
                <a:lumMod val="95000"/>
                <a:lumOff val="5000"/>
              </a:schemeClr>
            </a:solidFill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xmlns="" id="{F3C6535C-5FEE-EF52-8CCC-715FB4AA66B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54583" y="222340"/>
            <a:ext cx="3082833" cy="3181506"/>
          </a:xfrm>
          <a:prstGeom prst="rect">
            <a:avLst/>
          </a:prstGeom>
          <a:ln>
            <a:solidFill>
              <a:schemeClr val="tx1">
                <a:lumMod val="95000"/>
                <a:lumOff val="5000"/>
              </a:schemeClr>
            </a:solidFill>
          </a:ln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xmlns="" id="{6729E6F3-EEE0-E72D-4F1E-F36A6F091FCE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18579" y="222340"/>
            <a:ext cx="3082833" cy="3181506"/>
          </a:xfrm>
          <a:prstGeom prst="rect">
            <a:avLst/>
          </a:prstGeom>
          <a:ln>
            <a:solidFill>
              <a:schemeClr val="tx1">
                <a:lumMod val="95000"/>
                <a:lumOff val="5000"/>
              </a:schemeClr>
            </a:solidFill>
          </a:ln>
        </p:spPr>
      </p:pic>
      <p:graphicFrame>
        <p:nvGraphicFramePr>
          <p:cNvPr id="10" name="Table 9">
            <a:extLst>
              <a:ext uri="{FF2B5EF4-FFF2-40B4-BE49-F238E27FC236}">
                <a16:creationId xmlns:a16="http://schemas.microsoft.com/office/drawing/2014/main" xmlns="" id="{FF111ED3-3B6C-3789-07C5-7806ED5D5B2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65998616"/>
              </p:ext>
            </p:extLst>
          </p:nvPr>
        </p:nvGraphicFramePr>
        <p:xfrm>
          <a:off x="1674223" y="3633028"/>
          <a:ext cx="9226090" cy="3763108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3059752">
                  <a:extLst>
                    <a:ext uri="{9D8B030D-6E8A-4147-A177-3AD203B41FA5}">
                      <a16:colId xmlns:a16="http://schemas.microsoft.com/office/drawing/2014/main" xmlns="" val="973186093"/>
                    </a:ext>
                  </a:extLst>
                </a:gridCol>
                <a:gridCol w="6166338">
                  <a:extLst>
                    <a:ext uri="{9D8B030D-6E8A-4147-A177-3AD203B41FA5}">
                      <a16:colId xmlns:a16="http://schemas.microsoft.com/office/drawing/2014/main" xmlns="" val="3632252578"/>
                    </a:ext>
                  </a:extLst>
                </a:gridCol>
              </a:tblGrid>
              <a:tr h="308317">
                <a:tc>
                  <a:txBody>
                    <a:bodyPr/>
                    <a:lstStyle/>
                    <a:p>
                      <a:r>
                        <a:rPr lang="en-US" sz="12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alysis of OscH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sults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638763404"/>
                  </a:ext>
                </a:extLst>
              </a:tr>
              <a:tr h="265723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del confidence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A=94.2%, LT=94% confidently predicted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548268049"/>
                  </a:ext>
                </a:extLst>
              </a:tr>
              <a:tr h="246575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M-score results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MSD=3.9 Å, TM-score=0.81, MaxSub-score=0.19, GDT-TS-score=0.47, GDT-HA-score=0.23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155545143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imeraX Matchmaker RMSD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4 Å (across all 548 pairs), 0.59 Å (across 524 pruned pairs), 4.38% of protein deviates &gt;2Å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905334906"/>
                  </a:ext>
                </a:extLst>
              </a:tr>
              <a:tr h="231726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% helix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A=53.6%, LT=53.6%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382934998"/>
                  </a:ext>
                </a:extLst>
              </a:tr>
              <a:tr h="236025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% sheet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A=21.9%, LT=21.5%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306078296"/>
                  </a:ext>
                </a:extLst>
              </a:tr>
              <a:tr h="263769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sidues structurally changed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.03% (110 residues)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146921896"/>
                  </a:ext>
                </a:extLst>
              </a:tr>
              <a:tr h="338406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Nemar test for helices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Nemar’s X</a:t>
                      </a:r>
                      <a:r>
                        <a:rPr lang="en-US" sz="1200" baseline="300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=0.08, df = 1, p-value =0.7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596015966"/>
                  </a:ext>
                </a:extLst>
              </a:tr>
              <a:tr h="24892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Nemar test for strands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Nemar's X</a:t>
                      </a:r>
                      <a:r>
                        <a:rPr lang="en-US" sz="1200" baseline="300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=0.7, df = 1, p-value = 0.4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029622207"/>
                  </a:ext>
                </a:extLst>
              </a:tr>
              <a:tr h="276665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verage helix length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A=11.8 Å, LT=11.8 Å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828237805"/>
                  </a:ext>
                </a:extLst>
              </a:tr>
              <a:tr h="210625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ired t-test for differences in helix length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 = 0, df = 24, p-value =1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11648796"/>
                  </a:ext>
                </a:extLst>
              </a:tr>
              <a:tr h="261815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verage </a:t>
                      </a:r>
                      <a:r>
                        <a:rPr lang="el-GR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β</a:t>
                      </a: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strand length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A=2.93 Å, LT=3.03 Å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50861644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ired t-test for differences in strand length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 = -0.1, df = 38, p-value = 0.9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446499406"/>
                  </a:ext>
                </a:extLst>
              </a:tr>
            </a:tbl>
          </a:graphicData>
        </a:graphic>
      </p:graphicFrame>
      <p:sp>
        <p:nvSpPr>
          <p:cNvPr id="11" name="TextBox 10">
            <a:extLst>
              <a:ext uri="{FF2B5EF4-FFF2-40B4-BE49-F238E27FC236}">
                <a16:creationId xmlns:a16="http://schemas.microsoft.com/office/drawing/2014/main" xmlns="" id="{8CDB5440-7695-FE3F-EA9A-58F1D0A40C3F}"/>
              </a:ext>
            </a:extLst>
          </p:cNvPr>
          <p:cNvSpPr txBox="1"/>
          <p:nvPr/>
        </p:nvSpPr>
        <p:spPr>
          <a:xfrm>
            <a:off x="380568" y="7625319"/>
            <a:ext cx="10920844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buNone/>
            </a:pPr>
            <a:r>
              <a:rPr lang="en-US" sz="1200" b="1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3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 (H) Tertiary structure predictions made for </a:t>
            </a:r>
            <a:r>
              <a:rPr lang="en-US" sz="12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OscH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proteins using </a:t>
            </a:r>
            <a:r>
              <a:rPr lang="en-US" sz="12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alphafold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 The structures were visualized and </a:t>
            </a:r>
            <a:r>
              <a:rPr lang="en-US" sz="12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heme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positions were labeled in </a:t>
            </a:r>
            <a:r>
              <a:rPr lang="en-US" sz="12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ChimeraX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b="0" i="0" u="none" strike="noStrike" dirty="0" smtClean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or 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tructural comparisons, the predicted structures were superimposed using Matchmaker and colored by the calculated per residue Cα-</a:t>
            </a:r>
            <a:r>
              <a:rPr lang="en-US" sz="1200" b="0" i="0" u="none" strike="noStrike" dirty="0" smtClean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RMSD measurement. 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Residues are colored on a continuous gradient: Blue indicates the highest similarity (RMSD </a:t>
            </a:r>
            <a:r>
              <a:rPr lang="en-US" sz="1200" b="0" i="0" u="sng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&lt; 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A), white indicates intermediate difference (RMSD ~ 1 A), and red indicates the largest structural difference (RSD </a:t>
            </a:r>
            <a:r>
              <a:rPr lang="en-US" sz="1200" b="0" i="0" u="sng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&gt;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2 A). Secondary structures predicted by </a:t>
            </a:r>
            <a:r>
              <a:rPr lang="en-US" sz="12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alphafold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were also analyzed in DSSP and statistics comparing DSSP results were done with the R-stats package. 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xmlns="" id="{F083A6A0-6BB1-BB96-54BC-4FBD58C22FA5}"/>
              </a:ext>
            </a:extLst>
          </p:cNvPr>
          <p:cNvSpPr txBox="1"/>
          <p:nvPr/>
        </p:nvSpPr>
        <p:spPr>
          <a:xfrm>
            <a:off x="2697078" y="240776"/>
            <a:ext cx="12583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>
                <a:latin typeface="Times New Roman"/>
                <a:cs typeface="Times New Roman"/>
              </a:rPr>
              <a:t>OscH</a:t>
            </a:r>
            <a:r>
              <a:rPr lang="en-US" b="1" dirty="0">
                <a:latin typeface="Times New Roman"/>
                <a:cs typeface="Times New Roman"/>
              </a:rPr>
              <a:t> PC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xmlns="" id="{4BFE22DA-7FA9-A526-704C-899909B4963C}"/>
              </a:ext>
            </a:extLst>
          </p:cNvPr>
          <p:cNvSpPr txBox="1"/>
          <p:nvPr/>
        </p:nvSpPr>
        <p:spPr>
          <a:xfrm>
            <a:off x="6541495" y="221226"/>
            <a:ext cx="10763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>
                <a:latin typeface="Times New Roman"/>
                <a:cs typeface="Times New Roman"/>
              </a:rPr>
              <a:t>OscH</a:t>
            </a:r>
            <a:r>
              <a:rPr lang="en-US" b="1" dirty="0">
                <a:latin typeface="Times New Roman"/>
                <a:cs typeface="Times New Roman"/>
              </a:rPr>
              <a:t> LT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xmlns="" id="{DD13474E-7B47-26E9-074C-C4C3FDE7EF50}"/>
              </a:ext>
            </a:extLst>
          </p:cNvPr>
          <p:cNvSpPr txBox="1"/>
          <p:nvPr/>
        </p:nvSpPr>
        <p:spPr>
          <a:xfrm>
            <a:off x="9650592" y="231761"/>
            <a:ext cx="16148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>
                <a:latin typeface="Times New Roman"/>
                <a:cs typeface="Times New Roman"/>
              </a:rPr>
              <a:t>OscH</a:t>
            </a:r>
            <a:r>
              <a:rPr lang="en-US" b="1" dirty="0">
                <a:latin typeface="Times New Roman"/>
                <a:cs typeface="Times New Roman"/>
              </a:rPr>
              <a:t> PCA/LT</a:t>
            </a:r>
          </a:p>
        </p:txBody>
      </p:sp>
    </p:spTree>
    <p:extLst>
      <p:ext uri="{BB962C8B-B14F-4D97-AF65-F5344CB8AC3E}">
        <p14:creationId xmlns:p14="http://schemas.microsoft.com/office/powerpoint/2010/main" val="140483580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xmlns="" id="{C27E5F16-0D9A-E3FD-0135-A3803756CFC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9404" y="172432"/>
            <a:ext cx="3624763" cy="3023068"/>
          </a:xfrm>
          <a:prstGeom prst="rect">
            <a:avLst/>
          </a:prstGeom>
          <a:ln>
            <a:solidFill>
              <a:schemeClr val="tx1">
                <a:lumMod val="95000"/>
                <a:lumOff val="5000"/>
              </a:schemeClr>
            </a:solidFill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xmlns="" id="{BFC317DC-D5B8-E073-E334-A27CF39FC20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63691" y="221860"/>
            <a:ext cx="3671888" cy="302306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xmlns="" id="{AC8F091E-D231-DC86-9B8F-99F5AB47FD20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89985" y="198777"/>
            <a:ext cx="3713174" cy="302306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xmlns="" id="{CC1C21EE-343C-6C6B-5A90-7B895958FD7E}"/>
              </a:ext>
            </a:extLst>
          </p:cNvPr>
          <p:cNvSpPr txBox="1"/>
          <p:nvPr/>
        </p:nvSpPr>
        <p:spPr>
          <a:xfrm>
            <a:off x="357626" y="2797946"/>
            <a:ext cx="11721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>
                <a:latin typeface="Times New Roman"/>
                <a:cs typeface="Times New Roman"/>
              </a:rPr>
              <a:t>OscI</a:t>
            </a:r>
            <a:r>
              <a:rPr lang="en-US" b="1" dirty="0">
                <a:latin typeface="Times New Roman"/>
                <a:cs typeface="Times New Roman"/>
              </a:rPr>
              <a:t> PC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xmlns="" id="{A4FC4E31-1770-28DA-EAA7-49529DC90E5C}"/>
              </a:ext>
            </a:extLst>
          </p:cNvPr>
          <p:cNvSpPr txBox="1"/>
          <p:nvPr/>
        </p:nvSpPr>
        <p:spPr>
          <a:xfrm>
            <a:off x="4218207" y="2826168"/>
            <a:ext cx="9866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>
                <a:latin typeface="Times New Roman"/>
                <a:cs typeface="Times New Roman"/>
              </a:rPr>
              <a:t>OscI</a:t>
            </a:r>
            <a:r>
              <a:rPr lang="en-US" b="1" dirty="0">
                <a:latin typeface="Times New Roman"/>
                <a:cs typeface="Times New Roman"/>
              </a:rPr>
              <a:t> LT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xmlns="" id="{7DC82AEE-59FE-D903-086C-0C5292E15E3D}"/>
              </a:ext>
            </a:extLst>
          </p:cNvPr>
          <p:cNvSpPr txBox="1"/>
          <p:nvPr/>
        </p:nvSpPr>
        <p:spPr>
          <a:xfrm>
            <a:off x="8181310" y="2838403"/>
            <a:ext cx="15251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>
                <a:latin typeface="Times New Roman"/>
                <a:cs typeface="Times New Roman"/>
              </a:rPr>
              <a:t>OscI</a:t>
            </a:r>
            <a:r>
              <a:rPr lang="en-US" b="1" dirty="0">
                <a:latin typeface="Times New Roman"/>
                <a:cs typeface="Times New Roman"/>
              </a:rPr>
              <a:t> PCA/LT</a:t>
            </a:r>
          </a:p>
        </p:txBody>
      </p:sp>
      <p:graphicFrame>
        <p:nvGraphicFramePr>
          <p:cNvPr id="13" name="Table 12">
            <a:extLst>
              <a:ext uri="{FF2B5EF4-FFF2-40B4-BE49-F238E27FC236}">
                <a16:creationId xmlns:a16="http://schemas.microsoft.com/office/drawing/2014/main" xmlns="" id="{0C4B3114-8C7F-8C3E-6C8D-1F8FD101348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54720270"/>
              </p:ext>
            </p:extLst>
          </p:nvPr>
        </p:nvGraphicFramePr>
        <p:xfrm>
          <a:off x="1109133" y="3534304"/>
          <a:ext cx="9437106" cy="4080803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3200429">
                  <a:extLst>
                    <a:ext uri="{9D8B030D-6E8A-4147-A177-3AD203B41FA5}">
                      <a16:colId xmlns:a16="http://schemas.microsoft.com/office/drawing/2014/main" xmlns="" val="3291212801"/>
                    </a:ext>
                  </a:extLst>
                </a:gridCol>
                <a:gridCol w="6236677">
                  <a:extLst>
                    <a:ext uri="{9D8B030D-6E8A-4147-A177-3AD203B41FA5}">
                      <a16:colId xmlns:a16="http://schemas.microsoft.com/office/drawing/2014/main" xmlns="" val="2889942318"/>
                    </a:ext>
                  </a:extLst>
                </a:gridCol>
              </a:tblGrid>
              <a:tr h="284871">
                <a:tc>
                  <a:txBody>
                    <a:bodyPr/>
                    <a:lstStyle/>
                    <a:p>
                      <a:r>
                        <a:rPr lang="en-US" sz="12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alysis of OscI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sults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260594004"/>
                  </a:ext>
                </a:extLst>
              </a:tr>
              <a:tr h="289169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del confidence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A=98.2%, LT=98.4% confidently predicted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63832908"/>
                  </a:ext>
                </a:extLst>
              </a:tr>
              <a:tr h="270022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M-score results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MSD=1.1 Å, TM-score=0.98, MaxSub-score=0.92, GDT-TS-score=0.93, GDT-HA-score=0.82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818620463"/>
                  </a:ext>
                </a:extLst>
              </a:tr>
              <a:tr h="250874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imeraX Matchmaker RMSD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2 Å (across all 627 pairs), 0.82 Å (across 595 pruned pairs), 5.10% of protein deviates &gt;2Å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483310171"/>
                  </a:ext>
                </a:extLst>
              </a:tr>
              <a:tr h="208280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% helix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A=41%, LT=41.1%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421405260"/>
                  </a:ext>
                </a:extLst>
              </a:tr>
              <a:tr h="189132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% sheet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A=21.4%, LT=21.1%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796079425"/>
                  </a:ext>
                </a:extLst>
              </a:tr>
              <a:tr h="287215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sidues structurally changed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03% (19 residues)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609382231"/>
                  </a:ext>
                </a:extLst>
              </a:tr>
              <a:tr h="244622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Nemar test for helices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Nemar’s X</a:t>
                      </a:r>
                      <a:r>
                        <a:rPr lang="en-US" sz="1200" baseline="300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=0.08, df = 1, p-value =0.7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491579124"/>
                  </a:ext>
                </a:extLst>
              </a:tr>
              <a:tr h="24892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Nemar test for strands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Nemar's X</a:t>
                      </a:r>
                      <a:r>
                        <a:rPr lang="en-US" sz="1200" baseline="300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=0.7, df = 1, p-value = 0.4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936120506"/>
                  </a:ext>
                </a:extLst>
              </a:tr>
              <a:tr h="276665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verage helix length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A=4.28 Å, LT=4.3 Å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922919025"/>
                  </a:ext>
                </a:extLst>
              </a:tr>
              <a:tr h="280963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ired t-test for differences in helix length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 = -0.16, df = 59, p-value =0.8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561780628"/>
                  </a:ext>
                </a:extLst>
              </a:tr>
              <a:tr h="308708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verage </a:t>
                      </a:r>
                      <a:r>
                        <a:rPr lang="el-GR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β</a:t>
                      </a: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strand length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A=1.41 Å, LT=1.39 Å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423398015"/>
                  </a:ext>
                </a:extLst>
              </a:tr>
              <a:tr h="336452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ired t-test for differences in strand length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 = 0.3, df = 94, p-value = 0.7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60748908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fferences in heme distances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an difference = 0.3 Å; t = 19.4, df = 675, p-value = 2.2x10</a:t>
                      </a:r>
                      <a:r>
                        <a:rPr lang="en-US" sz="1200" baseline="300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6</a:t>
                      </a: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 95% CI: 0.27 to 0.34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287176836"/>
                  </a:ext>
                </a:extLst>
              </a:tr>
            </a:tbl>
          </a:graphicData>
        </a:graphic>
      </p:graphicFrame>
      <p:sp>
        <p:nvSpPr>
          <p:cNvPr id="14" name="TextBox 13">
            <a:extLst>
              <a:ext uri="{FF2B5EF4-FFF2-40B4-BE49-F238E27FC236}">
                <a16:creationId xmlns:a16="http://schemas.microsoft.com/office/drawing/2014/main" xmlns="" id="{F5CFBD4C-57FD-3E03-9603-3A97E9319D67}"/>
              </a:ext>
            </a:extLst>
          </p:cNvPr>
          <p:cNvSpPr txBox="1"/>
          <p:nvPr/>
        </p:nvSpPr>
        <p:spPr>
          <a:xfrm>
            <a:off x="586150" y="7882656"/>
            <a:ext cx="10920844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buNone/>
            </a:pPr>
            <a:r>
              <a:rPr lang="en-US" sz="1200" b="1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3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 (I) Tertiary structure predictions made for </a:t>
            </a:r>
            <a:r>
              <a:rPr lang="en-US" sz="12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Osc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proteins using </a:t>
            </a:r>
            <a:r>
              <a:rPr lang="en-US" sz="12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alphafold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 The structures were visualized and </a:t>
            </a:r>
            <a:r>
              <a:rPr lang="en-US" sz="12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heme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positions were labeled in </a:t>
            </a:r>
            <a:r>
              <a:rPr lang="en-US" sz="12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ChimeraX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Heme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localizations in the individual proteins are highlighted in purple. For structural comparisons, the predicted structures were superimposed using Matchmaker and colored by the calculated per residue Cα-</a:t>
            </a:r>
            <a:r>
              <a:rPr lang="en-US" sz="1200" b="0" i="0" u="none" strike="noStrike" dirty="0" smtClean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RMSD measurement. 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Residues are colored on a continuous gradient: Blue indicates the highest similarity (RMSD </a:t>
            </a:r>
            <a:r>
              <a:rPr lang="en-US" sz="1200" b="0" i="0" u="sng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&lt; 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A), white indicates intermediate difference (RMSD ~ 1 A), and red indicates the largest structural difference (RSD </a:t>
            </a:r>
            <a:r>
              <a:rPr lang="en-US" sz="1200" b="0" i="0" u="sng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&gt;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2 A). Secondary structures predicted by </a:t>
            </a:r>
            <a:r>
              <a:rPr lang="en-US" sz="12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alphafold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were also analyzed in DSSP and statistics comparing DSSP results were done with the R-stats package. </a:t>
            </a:r>
          </a:p>
        </p:txBody>
      </p:sp>
    </p:spTree>
    <p:extLst>
      <p:ext uri="{BB962C8B-B14F-4D97-AF65-F5344CB8AC3E}">
        <p14:creationId xmlns:p14="http://schemas.microsoft.com/office/powerpoint/2010/main" val="17867710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xmlns="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94</TotalTime>
  <Words>3896</Words>
  <Application>Microsoft Macintosh PowerPoint</Application>
  <PresentationFormat>Custom</PresentationFormat>
  <Paragraphs>336</Paragraphs>
  <Slides>1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2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Western New England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wn Holmes</dc:creator>
  <cp:lastModifiedBy>Dawn Holmes</cp:lastModifiedBy>
  <cp:revision>8</cp:revision>
  <dcterms:created xsi:type="dcterms:W3CDTF">2026-04-09T20:48:46Z</dcterms:created>
  <dcterms:modified xsi:type="dcterms:W3CDTF">2026-04-11T16:14:5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cc4f9dd6-a4b8-4763-a61d-db8d0cf51108_Enabled">
    <vt:lpwstr>true</vt:lpwstr>
  </property>
  <property fmtid="{D5CDD505-2E9C-101B-9397-08002B2CF9AE}" pid="3" name="MSIP_Label_cc4f9dd6-a4b8-4763-a61d-db8d0cf51108_SetDate">
    <vt:lpwstr>2026-04-09T20:49:38Z</vt:lpwstr>
  </property>
  <property fmtid="{D5CDD505-2E9C-101B-9397-08002B2CF9AE}" pid="4" name="MSIP_Label_cc4f9dd6-a4b8-4763-a61d-db8d0cf51108_Method">
    <vt:lpwstr>Standard</vt:lpwstr>
  </property>
  <property fmtid="{D5CDD505-2E9C-101B-9397-08002B2CF9AE}" pid="5" name="MSIP_Label_cc4f9dd6-a4b8-4763-a61d-db8d0cf51108_Name">
    <vt:lpwstr>defa4170-0d19-0005-0004-bc88714345d2</vt:lpwstr>
  </property>
  <property fmtid="{D5CDD505-2E9C-101B-9397-08002B2CF9AE}" pid="6" name="MSIP_Label_cc4f9dd6-a4b8-4763-a61d-db8d0cf51108_SiteId">
    <vt:lpwstr>b5a5796f-19a9-493f-9cb2-7a88b4e9b123</vt:lpwstr>
  </property>
  <property fmtid="{D5CDD505-2E9C-101B-9397-08002B2CF9AE}" pid="7" name="MSIP_Label_cc4f9dd6-a4b8-4763-a61d-db8d0cf51108_ActionId">
    <vt:lpwstr>687c992c-4e52-4f56-9905-c847e53aa39a</vt:lpwstr>
  </property>
  <property fmtid="{D5CDD505-2E9C-101B-9397-08002B2CF9AE}" pid="8" name="MSIP_Label_cc4f9dd6-a4b8-4763-a61d-db8d0cf51108_ContentBits">
    <vt:lpwstr>0</vt:lpwstr>
  </property>
  <property fmtid="{D5CDD505-2E9C-101B-9397-08002B2CF9AE}" pid="9" name="MSIP_Label_cc4f9dd6-a4b8-4763-a61d-db8d0cf51108_Tag">
    <vt:lpwstr>10, 3, 0, 1</vt:lpwstr>
  </property>
</Properties>
</file>